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  <p:sldId id="261" r:id="rId3"/>
    <p:sldId id="276" r:id="rId4"/>
    <p:sldId id="267" r:id="rId5"/>
    <p:sldId id="269" r:id="rId6"/>
    <p:sldId id="262" r:id="rId7"/>
    <p:sldId id="266" r:id="rId8"/>
    <p:sldId id="273" r:id="rId9"/>
    <p:sldId id="272" r:id="rId10"/>
    <p:sldId id="265" r:id="rId11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ey Danilov MD PhD" initials="ADMP" lastIdx="1" clrIdx="0">
    <p:extLst>
      <p:ext uri="{19B8F6BF-5375-455C-9EA6-DF929625EA0E}">
        <p15:presenceInfo xmlns:p15="http://schemas.microsoft.com/office/powerpoint/2012/main" userId="S::adanilov@coh.org::4d58775f-0bf7-46eb-bed8-6557934649d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2F1D7B-2C31-491D-B7D2-2A71E36A1F1B}" v="33" dt="2023-03-01T20:51:07.91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5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wn Wang" userId="b55d1e73-8551-4a55-95aa-63326fdec5d5" providerId="ADAL" clId="{5D2F1D7B-2C31-491D-B7D2-2A71E36A1F1B}"/>
    <pc:docChg chg="undo custSel addSld delSld modSld">
      <pc:chgData name="Shawn Wang" userId="b55d1e73-8551-4a55-95aa-63326fdec5d5" providerId="ADAL" clId="{5D2F1D7B-2C31-491D-B7D2-2A71E36A1F1B}" dt="2023-03-01T20:51:39.727" v="607" actId="207"/>
      <pc:docMkLst>
        <pc:docMk/>
      </pc:docMkLst>
      <pc:sldChg chg="addSp delSp modSp mod">
        <pc:chgData name="Shawn Wang" userId="b55d1e73-8551-4a55-95aa-63326fdec5d5" providerId="ADAL" clId="{5D2F1D7B-2C31-491D-B7D2-2A71E36A1F1B}" dt="2023-03-01T20:45:24.183" v="485" actId="1076"/>
        <pc:sldMkLst>
          <pc:docMk/>
          <pc:sldMk cId="423450712" sldId="261"/>
        </pc:sldMkLst>
        <pc:spChg chg="mod">
          <ac:chgData name="Shawn Wang" userId="b55d1e73-8551-4a55-95aa-63326fdec5d5" providerId="ADAL" clId="{5D2F1D7B-2C31-491D-B7D2-2A71E36A1F1B}" dt="2023-03-01T19:54:23.467" v="5" actId="20577"/>
          <ac:spMkLst>
            <pc:docMk/>
            <pc:sldMk cId="423450712" sldId="261"/>
            <ac:spMk id="10" creationId="{B88F9F08-8311-477E-960A-030051FF147B}"/>
          </ac:spMkLst>
        </pc:spChg>
        <pc:spChg chg="mod">
          <ac:chgData name="Shawn Wang" userId="b55d1e73-8551-4a55-95aa-63326fdec5d5" providerId="ADAL" clId="{5D2F1D7B-2C31-491D-B7D2-2A71E36A1F1B}" dt="2023-03-01T20:40:56.583" v="434" actId="1036"/>
          <ac:spMkLst>
            <pc:docMk/>
            <pc:sldMk cId="423450712" sldId="261"/>
            <ac:spMk id="11" creationId="{F50FA955-06C3-4075-8145-6611DE3CFA49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12" creationId="{751C1DF2-34B3-D74D-EC43-7497BD1A8C15}"/>
          </ac:spMkLst>
        </pc:spChg>
        <pc:spChg chg="del">
          <ac:chgData name="Shawn Wang" userId="b55d1e73-8551-4a55-95aa-63326fdec5d5" providerId="ADAL" clId="{5D2F1D7B-2C31-491D-B7D2-2A71E36A1F1B}" dt="2023-03-01T19:57:40.186" v="8" actId="478"/>
          <ac:spMkLst>
            <pc:docMk/>
            <pc:sldMk cId="423450712" sldId="261"/>
            <ac:spMk id="12" creationId="{78B8139D-FD44-B6E9-9D7A-7B1B4B2894ED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13" creationId="{6C33F722-B2C5-C1BF-89A6-890E82F2417E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13" creationId="{E9FEF3C5-0544-1B16-163F-4F9F9ECD1DDE}"/>
          </ac:spMkLst>
        </pc:spChg>
        <pc:spChg chg="mod">
          <ac:chgData name="Shawn Wang" userId="b55d1e73-8551-4a55-95aa-63326fdec5d5" providerId="ADAL" clId="{5D2F1D7B-2C31-491D-B7D2-2A71E36A1F1B}" dt="2023-03-01T19:54:29.180" v="7" actId="20577"/>
          <ac:spMkLst>
            <pc:docMk/>
            <pc:sldMk cId="423450712" sldId="261"/>
            <ac:spMk id="14" creationId="{B221F5DC-AC97-468B-943B-A9B549D947BF}"/>
          </ac:spMkLst>
        </pc:spChg>
        <pc:spChg chg="mod">
          <ac:chgData name="Shawn Wang" userId="b55d1e73-8551-4a55-95aa-63326fdec5d5" providerId="ADAL" clId="{5D2F1D7B-2C31-491D-B7D2-2A71E36A1F1B}" dt="2023-03-01T20:03:15.435" v="158" actId="14100"/>
          <ac:spMkLst>
            <pc:docMk/>
            <pc:sldMk cId="423450712" sldId="261"/>
            <ac:spMk id="16" creationId="{96E5C148-BAFD-417D-8C2E-8FABBFBDDA01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17" creationId="{8C254652-7227-4244-DC83-E926E496D835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17" creationId="{99A0FD9F-D356-12B6-5C5C-2D114F99B3CB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18" creationId="{30AFB72F-7B7B-4F2B-0EBA-0DF09F81837F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18" creationId="{C1EDC836-0817-D333-2C49-F49816788D63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19" creationId="{724A0758-0EDF-393A-60AF-2F25D646EA41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19" creationId="{CE536657-296B-2BC2-B202-00F212A9CE1B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0" creationId="{B7AC99F2-3BAB-E5D8-2291-C14B34230748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0" creationId="{F3E5C3AB-FA1C-8ED6-2751-120D19B45C62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1" creationId="{60872753-3B9B-02CF-0521-B77CEAD8A641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1" creationId="{7572F901-917A-FE68-DB88-90C2D5535624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2" creationId="{3CB8EC64-1F56-C3F6-803A-C20B18386C15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2" creationId="{A9A65C8D-7044-5AAF-A835-2F13912B00CA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3" creationId="{A57F7AA4-4A1A-1D09-6F63-CA7335F50E7F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3" creationId="{FE3A0DA2-03F2-E1BB-E8D3-444D21272384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4" creationId="{90055FED-68B9-20F8-5BD6-0C2B5213A4E1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4" creationId="{E92EA484-C32A-E569-F9F3-1DFA5D6622FE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5" creationId="{1F43391F-B7E8-827F-EF5F-6171E0EA4B7B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5" creationId="{4A33C817-B139-2986-9400-A23BCB79AE10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6" creationId="{624DE9D6-FDED-0557-3DAD-2F25112C3533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6" creationId="{A53B2F3A-0122-573F-EABD-C07168F1FD79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7" creationId="{1872255E-2066-FB5B-9150-F7334CA7E040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7" creationId="{4F2588F7-1F8C-3512-3680-62C354A98E35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8" creationId="{4C652B78-B241-EB94-B40D-4C169FB75A7F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8" creationId="{E9F331BE-0B96-1D36-483E-DAE50D7095CC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29" creationId="{61B3B14D-3073-FA39-CA26-91611371E602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29" creationId="{E5F269CE-B865-3BA5-48A0-92981F4FDF4A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30" creationId="{A384BAD7-FA6D-90FD-FEF7-634ECC35196C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30" creationId="{F7A0BFBB-3B6B-69F5-7E4A-591E90BCAABB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31" creationId="{796BF7BE-0AD7-B74A-9A2D-4B532406A63C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32" creationId="{8F90C817-8407-563C-F60E-45D50F6AA6CE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33" creationId="{6E8382DE-E7CD-B642-206B-D99FEB6B6E56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34" creationId="{574DDBA6-1B0B-F77F-FD91-578CB849AC48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41" creationId="{3451E41C-F437-A410-CF10-26BBD590E45E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42" creationId="{7F166AEE-0A09-3300-5F9C-D3824EF7BFF0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43" creationId="{604F4946-F5C6-1633-E08D-652DA53BAAB3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44" creationId="{DF36FD7E-FCDF-CDAD-D56A-8DE2394914BE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44" creationId="{E4B85205-625A-72C4-6412-10DCADB15FF5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45" creationId="{3BD9B2A9-D338-4F16-D35D-7336CFD4F6EA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45" creationId="{C9899C91-905C-61D6-FFBB-E3364D40B2E7}"/>
          </ac:spMkLst>
        </pc:spChg>
        <pc:spChg chg="add del mod">
          <ac:chgData name="Shawn Wang" userId="b55d1e73-8551-4a55-95aa-63326fdec5d5" providerId="ADAL" clId="{5D2F1D7B-2C31-491D-B7D2-2A71E36A1F1B}" dt="2023-03-01T19:57:46.167" v="10"/>
          <ac:spMkLst>
            <pc:docMk/>
            <pc:sldMk cId="423450712" sldId="261"/>
            <ac:spMk id="47" creationId="{6A42E63D-A59B-AE90-A68F-5DAC0C5BCD0D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48" creationId="{8E98DC2D-0BB4-13F6-66D7-4ADBF3E95B92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49" creationId="{33D236EF-7071-E839-5F08-02752147F0D1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0" creationId="{EB50B7B3-326F-95D7-AC08-AA5117E6A19A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1" creationId="{A110D33D-679C-4DD9-573F-294B4A16645B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2" creationId="{B17DFDE1-A111-AE0F-11D1-13FFD12F83D9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3" creationId="{4666EAF6-D366-3CC6-C446-1E484D3DA160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4" creationId="{32D4DEC1-53B8-1F01-55F0-06519C083FFE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5" creationId="{1F711071-E2D7-081B-063E-ED1439A5A042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6" creationId="{D647542E-E927-89EF-B0E5-8FE453DCA1F8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7" creationId="{8FD681DD-EBCD-0638-B129-BF1E08F62CA4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8" creationId="{685DDAD8-8753-E6D2-F759-A3AF1B71EAE2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59" creationId="{42339DE0-E9A7-1DB3-4B9B-E4B9E503322D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60" creationId="{EF648694-C1BA-EA68-FF07-85CD3F875C6E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61" creationId="{72CC671B-6899-C006-B0CA-39FC67C447D8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62" creationId="{9401B37C-E2B6-02F6-268E-3ADF24A68957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73" creationId="{D8FA172A-D502-B0BD-3F7E-AAA0207C3C1D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74" creationId="{88A611BC-C737-394F-F93B-D1D8C547CFB6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76" creationId="{38E795F2-D159-C151-B9DA-33AC896A5F4D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77" creationId="{5D6223B9-9A70-B502-7128-2CCD0561F930}"/>
          </ac:spMkLst>
        </pc:spChg>
        <pc:spChg chg="add del mod">
          <ac:chgData name="Shawn Wang" userId="b55d1e73-8551-4a55-95aa-63326fdec5d5" providerId="ADAL" clId="{5D2F1D7B-2C31-491D-B7D2-2A71E36A1F1B}" dt="2023-03-01T20:35:10.160" v="237" actId="478"/>
          <ac:spMkLst>
            <pc:docMk/>
            <pc:sldMk cId="423450712" sldId="261"/>
            <ac:spMk id="79" creationId="{7424B8E9-3CC2-92EF-4DF0-20841C564F30}"/>
          </ac:spMkLst>
        </pc:spChg>
        <pc:spChg chg="add del mod">
          <ac:chgData name="Shawn Wang" userId="b55d1e73-8551-4a55-95aa-63326fdec5d5" providerId="ADAL" clId="{5D2F1D7B-2C31-491D-B7D2-2A71E36A1F1B}" dt="2023-03-01T20:35:11.585" v="238" actId="478"/>
          <ac:spMkLst>
            <pc:docMk/>
            <pc:sldMk cId="423450712" sldId="261"/>
            <ac:spMk id="82" creationId="{430D62AF-ACCD-0A6F-8E8C-316BA9672A05}"/>
          </ac:spMkLst>
        </pc:spChg>
        <pc:spChg chg="add del mod">
          <ac:chgData name="Shawn Wang" userId="b55d1e73-8551-4a55-95aa-63326fdec5d5" providerId="ADAL" clId="{5D2F1D7B-2C31-491D-B7D2-2A71E36A1F1B}" dt="2023-03-01T20:35:22.458" v="240"/>
          <ac:spMkLst>
            <pc:docMk/>
            <pc:sldMk cId="423450712" sldId="261"/>
            <ac:spMk id="84" creationId="{E1462A50-4B87-D7CA-3925-489AD3D339B4}"/>
          </ac:spMkLst>
        </pc:spChg>
        <pc:spChg chg="add mod">
          <ac:chgData name="Shawn Wang" userId="b55d1e73-8551-4a55-95aa-63326fdec5d5" providerId="ADAL" clId="{5D2F1D7B-2C31-491D-B7D2-2A71E36A1F1B}" dt="2023-03-01T20:43:47.505" v="461" actId="164"/>
          <ac:spMkLst>
            <pc:docMk/>
            <pc:sldMk cId="423450712" sldId="261"/>
            <ac:spMk id="85" creationId="{FBAC98FF-5780-5651-B3F0-B2FC9FB5BE94}"/>
          </ac:spMkLst>
        </pc:spChg>
        <pc:spChg chg="add mod">
          <ac:chgData name="Shawn Wang" userId="b55d1e73-8551-4a55-95aa-63326fdec5d5" providerId="ADAL" clId="{5D2F1D7B-2C31-491D-B7D2-2A71E36A1F1B}" dt="2023-03-01T20:43:47.505" v="461" actId="164"/>
          <ac:spMkLst>
            <pc:docMk/>
            <pc:sldMk cId="423450712" sldId="261"/>
            <ac:spMk id="86" creationId="{9F5D5840-CE85-106B-D31A-76761031147A}"/>
          </ac:spMkLst>
        </pc:spChg>
        <pc:spChg chg="add mod">
          <ac:chgData name="Shawn Wang" userId="b55d1e73-8551-4a55-95aa-63326fdec5d5" providerId="ADAL" clId="{5D2F1D7B-2C31-491D-B7D2-2A71E36A1F1B}" dt="2023-03-01T20:43:53.481" v="462" actId="164"/>
          <ac:spMkLst>
            <pc:docMk/>
            <pc:sldMk cId="423450712" sldId="261"/>
            <ac:spMk id="87" creationId="{69BC88F8-1561-E818-EA20-9D5EEA04D066}"/>
          </ac:spMkLst>
        </pc:spChg>
        <pc:spChg chg="add mod">
          <ac:chgData name="Shawn Wang" userId="b55d1e73-8551-4a55-95aa-63326fdec5d5" providerId="ADAL" clId="{5D2F1D7B-2C31-491D-B7D2-2A71E36A1F1B}" dt="2023-03-01T20:43:53.481" v="462" actId="164"/>
          <ac:spMkLst>
            <pc:docMk/>
            <pc:sldMk cId="423450712" sldId="261"/>
            <ac:spMk id="88" creationId="{05A0ED4E-5DC2-AE1E-8C4F-B29E2401E9D0}"/>
          </ac:spMkLst>
        </pc:spChg>
        <pc:spChg chg="add mod">
          <ac:chgData name="Shawn Wang" userId="b55d1e73-8551-4a55-95aa-63326fdec5d5" providerId="ADAL" clId="{5D2F1D7B-2C31-491D-B7D2-2A71E36A1F1B}" dt="2023-03-01T20:43:59.602" v="463" actId="164"/>
          <ac:spMkLst>
            <pc:docMk/>
            <pc:sldMk cId="423450712" sldId="261"/>
            <ac:spMk id="89" creationId="{0CBCC004-74AC-EFB5-8C34-4CDC2F040C4E}"/>
          </ac:spMkLst>
        </pc:spChg>
        <pc:spChg chg="add mod">
          <ac:chgData name="Shawn Wang" userId="b55d1e73-8551-4a55-95aa-63326fdec5d5" providerId="ADAL" clId="{5D2F1D7B-2C31-491D-B7D2-2A71E36A1F1B}" dt="2023-03-01T20:43:59.602" v="463" actId="164"/>
          <ac:spMkLst>
            <pc:docMk/>
            <pc:sldMk cId="423450712" sldId="261"/>
            <ac:spMk id="90" creationId="{2857EDCE-5E91-29DC-DA67-9B4C65384F8B}"/>
          </ac:spMkLst>
        </pc:spChg>
        <pc:spChg chg="add mod">
          <ac:chgData name="Shawn Wang" userId="b55d1e73-8551-4a55-95aa-63326fdec5d5" providerId="ADAL" clId="{5D2F1D7B-2C31-491D-B7D2-2A71E36A1F1B}" dt="2023-03-01T20:44:04.867" v="464" actId="164"/>
          <ac:spMkLst>
            <pc:docMk/>
            <pc:sldMk cId="423450712" sldId="261"/>
            <ac:spMk id="91" creationId="{E8FAEAC4-445C-1DAE-AC18-B3FF8C0888B8}"/>
          </ac:spMkLst>
        </pc:spChg>
        <pc:spChg chg="add mod">
          <ac:chgData name="Shawn Wang" userId="b55d1e73-8551-4a55-95aa-63326fdec5d5" providerId="ADAL" clId="{5D2F1D7B-2C31-491D-B7D2-2A71E36A1F1B}" dt="2023-03-01T20:44:04.867" v="464" actId="164"/>
          <ac:spMkLst>
            <pc:docMk/>
            <pc:sldMk cId="423450712" sldId="261"/>
            <ac:spMk id="92" creationId="{6E0F0C10-ED2C-3562-7DB5-CCB8B2AB9DDF}"/>
          </ac:spMkLst>
        </pc:spChg>
        <pc:spChg chg="add mod">
          <ac:chgData name="Shawn Wang" userId="b55d1e73-8551-4a55-95aa-63326fdec5d5" providerId="ADAL" clId="{5D2F1D7B-2C31-491D-B7D2-2A71E36A1F1B}" dt="2023-03-01T20:42:29.724" v="446" actId="164"/>
          <ac:spMkLst>
            <pc:docMk/>
            <pc:sldMk cId="423450712" sldId="261"/>
            <ac:spMk id="93" creationId="{2712B487-7F1A-7BD7-29EF-DD85FAF7D091}"/>
          </ac:spMkLst>
        </pc:spChg>
        <pc:spChg chg="add mod">
          <ac:chgData name="Shawn Wang" userId="b55d1e73-8551-4a55-95aa-63326fdec5d5" providerId="ADAL" clId="{5D2F1D7B-2C31-491D-B7D2-2A71E36A1F1B}" dt="2023-03-01T20:42:29.724" v="446" actId="164"/>
          <ac:spMkLst>
            <pc:docMk/>
            <pc:sldMk cId="423450712" sldId="261"/>
            <ac:spMk id="94" creationId="{38F30BE7-2CC0-2BF4-9D8C-7450D2FAC574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95" creationId="{15038905-34AB-6C9E-9672-9B29E149EE77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96" creationId="{C7BAD784-DB00-1DB1-694B-BC2DE3599DCF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97" creationId="{2406B136-35CA-62D3-B1F3-A8F9D3E5D224}"/>
          </ac:spMkLst>
        </pc:spChg>
        <pc:spChg chg="add mod">
          <ac:chgData name="Shawn Wang" userId="b55d1e73-8551-4a55-95aa-63326fdec5d5" providerId="ADAL" clId="{5D2F1D7B-2C31-491D-B7D2-2A71E36A1F1B}" dt="2023-03-01T20:43:07.429" v="450" actId="164"/>
          <ac:spMkLst>
            <pc:docMk/>
            <pc:sldMk cId="423450712" sldId="261"/>
            <ac:spMk id="98" creationId="{998CDB38-A8F2-1122-6100-C576977847D0}"/>
          </ac:spMkLst>
        </pc:spChg>
        <pc:spChg chg="add mod">
          <ac:chgData name="Shawn Wang" userId="b55d1e73-8551-4a55-95aa-63326fdec5d5" providerId="ADAL" clId="{5D2F1D7B-2C31-491D-B7D2-2A71E36A1F1B}" dt="2023-03-01T20:43:07.429" v="450" actId="164"/>
          <ac:spMkLst>
            <pc:docMk/>
            <pc:sldMk cId="423450712" sldId="261"/>
            <ac:spMk id="99" creationId="{C51A5EB8-3532-60A7-2999-781935340666}"/>
          </ac:spMkLst>
        </pc:spChg>
        <pc:spChg chg="add del mod">
          <ac:chgData name="Shawn Wang" userId="b55d1e73-8551-4a55-95aa-63326fdec5d5" providerId="ADAL" clId="{5D2F1D7B-2C31-491D-B7D2-2A71E36A1F1B}" dt="2023-03-01T20:38:21.541" v="327" actId="478"/>
          <ac:spMkLst>
            <pc:docMk/>
            <pc:sldMk cId="423450712" sldId="261"/>
            <ac:spMk id="100" creationId="{F9C165A7-E5CF-3D91-9F0D-6E50A19121CA}"/>
          </ac:spMkLst>
        </pc:spChg>
        <pc:spChg chg="add del mod">
          <ac:chgData name="Shawn Wang" userId="b55d1e73-8551-4a55-95aa-63326fdec5d5" providerId="ADAL" clId="{5D2F1D7B-2C31-491D-B7D2-2A71E36A1F1B}" dt="2023-03-01T20:38:21.541" v="327" actId="478"/>
          <ac:spMkLst>
            <pc:docMk/>
            <pc:sldMk cId="423450712" sldId="261"/>
            <ac:spMk id="101" creationId="{61CAF21A-D86B-6E2C-CD3A-19B0AB6CB95E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02" creationId="{5CFA830B-C968-E25F-1B0A-5547849E1598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03" creationId="{7ADB4DF4-39A1-3A07-A546-4A1EBB3244C7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04" creationId="{4FFE01A2-1879-4A44-23EE-039562A51A83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13" creationId="{9B24860C-4D56-EC8B-9D95-B920B5F28947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14" creationId="{C43DBF59-ADF3-7AA9-D556-BFF1879854CE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15" creationId="{DEBC98B4-81DC-F906-8C0C-93FC30635DAC}"/>
          </ac:spMkLst>
        </pc:spChg>
        <pc:spChg chg="add del mod">
          <ac:chgData name="Shawn Wang" userId="b55d1e73-8551-4a55-95aa-63326fdec5d5" providerId="ADAL" clId="{5D2F1D7B-2C31-491D-B7D2-2A71E36A1F1B}" dt="2023-03-01T20:38:19.587" v="326" actId="478"/>
          <ac:spMkLst>
            <pc:docMk/>
            <pc:sldMk cId="423450712" sldId="261"/>
            <ac:spMk id="120" creationId="{CBE1DF37-1D5A-2A24-A18C-17EB6460ABD3}"/>
          </ac:spMkLst>
        </pc:spChg>
        <pc:spChg chg="add mod">
          <ac:chgData name="Shawn Wang" userId="b55d1e73-8551-4a55-95aa-63326fdec5d5" providerId="ADAL" clId="{5D2F1D7B-2C31-491D-B7D2-2A71E36A1F1B}" dt="2023-03-01T20:35:50.442" v="247" actId="20577"/>
          <ac:spMkLst>
            <pc:docMk/>
            <pc:sldMk cId="423450712" sldId="261"/>
            <ac:spMk id="121" creationId="{50A79824-D9C0-E4C5-FC52-5605E539183B}"/>
          </ac:spMkLst>
        </pc:spChg>
        <pc:spChg chg="add mod">
          <ac:chgData name="Shawn Wang" userId="b55d1e73-8551-4a55-95aa-63326fdec5d5" providerId="ADAL" clId="{5D2F1D7B-2C31-491D-B7D2-2A71E36A1F1B}" dt="2023-03-01T20:36:32.404" v="258" actId="208"/>
          <ac:spMkLst>
            <pc:docMk/>
            <pc:sldMk cId="423450712" sldId="261"/>
            <ac:spMk id="122" creationId="{39DA1A9F-6883-34B8-6561-8486BF5B722B}"/>
          </ac:spMkLst>
        </pc:spChg>
        <pc:spChg chg="add mod">
          <ac:chgData name="Shawn Wang" userId="b55d1e73-8551-4a55-95aa-63326fdec5d5" providerId="ADAL" clId="{5D2F1D7B-2C31-491D-B7D2-2A71E36A1F1B}" dt="2023-03-01T20:37:02.048" v="279" actId="1038"/>
          <ac:spMkLst>
            <pc:docMk/>
            <pc:sldMk cId="423450712" sldId="261"/>
            <ac:spMk id="123" creationId="{494B10C5-829D-9D81-F85F-AB63CDA7C5C5}"/>
          </ac:spMkLst>
        </pc:spChg>
        <pc:spChg chg="add mod">
          <ac:chgData name="Shawn Wang" userId="b55d1e73-8551-4a55-95aa-63326fdec5d5" providerId="ADAL" clId="{5D2F1D7B-2C31-491D-B7D2-2A71E36A1F1B}" dt="2023-03-01T20:37:18.220" v="322" actId="1037"/>
          <ac:spMkLst>
            <pc:docMk/>
            <pc:sldMk cId="423450712" sldId="261"/>
            <ac:spMk id="124" creationId="{EFA1019C-5689-CF98-112E-2744879D20D9}"/>
          </ac:spMkLst>
        </pc:spChg>
        <pc:spChg chg="add del mod">
          <ac:chgData name="Shawn Wang" userId="b55d1e73-8551-4a55-95aa-63326fdec5d5" providerId="ADAL" clId="{5D2F1D7B-2C31-491D-B7D2-2A71E36A1F1B}" dt="2023-03-01T20:43:12.504" v="451" actId="478"/>
          <ac:spMkLst>
            <pc:docMk/>
            <pc:sldMk cId="423450712" sldId="261"/>
            <ac:spMk id="125" creationId="{24CBBE41-578D-8EC9-3ADA-A5E7D8F001E7}"/>
          </ac:spMkLst>
        </pc:spChg>
        <pc:spChg chg="add del mod">
          <ac:chgData name="Shawn Wang" userId="b55d1e73-8551-4a55-95aa-63326fdec5d5" providerId="ADAL" clId="{5D2F1D7B-2C31-491D-B7D2-2A71E36A1F1B}" dt="2023-03-01T20:39:11.576" v="336" actId="478"/>
          <ac:spMkLst>
            <pc:docMk/>
            <pc:sldMk cId="423450712" sldId="261"/>
            <ac:spMk id="126" creationId="{09F3C23A-2021-A317-7987-AC410BEAE3B6}"/>
          </ac:spMkLst>
        </pc:spChg>
        <pc:spChg chg="add mod">
          <ac:chgData name="Shawn Wang" userId="b55d1e73-8551-4a55-95aa-63326fdec5d5" providerId="ADAL" clId="{5D2F1D7B-2C31-491D-B7D2-2A71E36A1F1B}" dt="2023-03-01T20:43:00.516" v="449" actId="164"/>
          <ac:spMkLst>
            <pc:docMk/>
            <pc:sldMk cId="423450712" sldId="261"/>
            <ac:spMk id="127" creationId="{7F11FC15-2719-934C-93DC-52FCB2419AEA}"/>
          </ac:spMkLst>
        </pc:spChg>
        <pc:spChg chg="add mod">
          <ac:chgData name="Shawn Wang" userId="b55d1e73-8551-4a55-95aa-63326fdec5d5" providerId="ADAL" clId="{5D2F1D7B-2C31-491D-B7D2-2A71E36A1F1B}" dt="2023-03-01T20:43:00.516" v="449" actId="164"/>
          <ac:spMkLst>
            <pc:docMk/>
            <pc:sldMk cId="423450712" sldId="261"/>
            <ac:spMk id="129" creationId="{B24D2B13-E8B9-9DB9-F9FF-29036B2D18E7}"/>
          </ac:spMkLst>
        </pc:spChg>
        <pc:spChg chg="add mod">
          <ac:chgData name="Shawn Wang" userId="b55d1e73-8551-4a55-95aa-63326fdec5d5" providerId="ADAL" clId="{5D2F1D7B-2C31-491D-B7D2-2A71E36A1F1B}" dt="2023-03-01T20:42:37.247" v="447" actId="164"/>
          <ac:spMkLst>
            <pc:docMk/>
            <pc:sldMk cId="423450712" sldId="261"/>
            <ac:spMk id="130" creationId="{7AD28D8B-E580-270F-A65F-977DDAAAA8CD}"/>
          </ac:spMkLst>
        </pc:spChg>
        <pc:spChg chg="add mod">
          <ac:chgData name="Shawn Wang" userId="b55d1e73-8551-4a55-95aa-63326fdec5d5" providerId="ADAL" clId="{5D2F1D7B-2C31-491D-B7D2-2A71E36A1F1B}" dt="2023-03-01T20:42:24.205" v="445" actId="164"/>
          <ac:spMkLst>
            <pc:docMk/>
            <pc:sldMk cId="423450712" sldId="261"/>
            <ac:spMk id="131" creationId="{021CB16A-80D9-6FC8-FB8C-092F06673ACB}"/>
          </ac:spMkLst>
        </pc:spChg>
        <pc:spChg chg="add mod">
          <ac:chgData name="Shawn Wang" userId="b55d1e73-8551-4a55-95aa-63326fdec5d5" providerId="ADAL" clId="{5D2F1D7B-2C31-491D-B7D2-2A71E36A1F1B}" dt="2023-03-01T20:42:16.694" v="444" actId="164"/>
          <ac:spMkLst>
            <pc:docMk/>
            <pc:sldMk cId="423450712" sldId="261"/>
            <ac:spMk id="132" creationId="{BB658EA6-5412-53E7-8014-BAC88E4D8E4F}"/>
          </ac:spMkLst>
        </pc:spChg>
        <pc:spChg chg="add mod">
          <ac:chgData name="Shawn Wang" userId="b55d1e73-8551-4a55-95aa-63326fdec5d5" providerId="ADAL" clId="{5D2F1D7B-2C31-491D-B7D2-2A71E36A1F1B}" dt="2023-03-01T20:42:37.247" v="447" actId="164"/>
          <ac:spMkLst>
            <pc:docMk/>
            <pc:sldMk cId="423450712" sldId="261"/>
            <ac:spMk id="136" creationId="{A1C467C9-EB8C-1419-71F2-71C380269336}"/>
          </ac:spMkLst>
        </pc:spChg>
        <pc:spChg chg="add mod">
          <ac:chgData name="Shawn Wang" userId="b55d1e73-8551-4a55-95aa-63326fdec5d5" providerId="ADAL" clId="{5D2F1D7B-2C31-491D-B7D2-2A71E36A1F1B}" dt="2023-03-01T20:42:24.205" v="445" actId="164"/>
          <ac:spMkLst>
            <pc:docMk/>
            <pc:sldMk cId="423450712" sldId="261"/>
            <ac:spMk id="137" creationId="{AD1F5C2B-130E-CAD4-5144-18D159615D47}"/>
          </ac:spMkLst>
        </pc:spChg>
        <pc:spChg chg="add mod">
          <ac:chgData name="Shawn Wang" userId="b55d1e73-8551-4a55-95aa-63326fdec5d5" providerId="ADAL" clId="{5D2F1D7B-2C31-491D-B7D2-2A71E36A1F1B}" dt="2023-03-01T20:42:16.694" v="444" actId="164"/>
          <ac:spMkLst>
            <pc:docMk/>
            <pc:sldMk cId="423450712" sldId="261"/>
            <ac:spMk id="138" creationId="{0F871DD2-D2D2-1F55-4310-273885E750D6}"/>
          </ac:spMkLst>
        </pc:spChg>
        <pc:spChg chg="add mod">
          <ac:chgData name="Shawn Wang" userId="b55d1e73-8551-4a55-95aa-63326fdec5d5" providerId="ADAL" clId="{5D2F1D7B-2C31-491D-B7D2-2A71E36A1F1B}" dt="2023-03-01T20:42:11.169" v="443" actId="164"/>
          <ac:spMkLst>
            <pc:docMk/>
            <pc:sldMk cId="423450712" sldId="261"/>
            <ac:spMk id="139" creationId="{621CBCD4-2E05-DC2E-A12F-2DA9AF5CFB5D}"/>
          </ac:spMkLst>
        </pc:spChg>
        <pc:spChg chg="add mod">
          <ac:chgData name="Shawn Wang" userId="b55d1e73-8551-4a55-95aa-63326fdec5d5" providerId="ADAL" clId="{5D2F1D7B-2C31-491D-B7D2-2A71E36A1F1B}" dt="2023-03-01T20:42:11.169" v="443" actId="164"/>
          <ac:spMkLst>
            <pc:docMk/>
            <pc:sldMk cId="423450712" sldId="261"/>
            <ac:spMk id="140" creationId="{07AE3DED-811B-0704-92B9-AC361323159C}"/>
          </ac:spMkLst>
        </pc:spChg>
        <pc:spChg chg="add mod">
          <ac:chgData name="Shawn Wang" userId="b55d1e73-8551-4a55-95aa-63326fdec5d5" providerId="ADAL" clId="{5D2F1D7B-2C31-491D-B7D2-2A71E36A1F1B}" dt="2023-03-01T20:42:05.900" v="442" actId="164"/>
          <ac:spMkLst>
            <pc:docMk/>
            <pc:sldMk cId="423450712" sldId="261"/>
            <ac:spMk id="141" creationId="{DAD88F86-5BAA-046F-329F-656AE3C9B082}"/>
          </ac:spMkLst>
        </pc:spChg>
        <pc:spChg chg="add mod">
          <ac:chgData name="Shawn Wang" userId="b55d1e73-8551-4a55-95aa-63326fdec5d5" providerId="ADAL" clId="{5D2F1D7B-2C31-491D-B7D2-2A71E36A1F1B}" dt="2023-03-01T20:42:05.900" v="442" actId="164"/>
          <ac:spMkLst>
            <pc:docMk/>
            <pc:sldMk cId="423450712" sldId="261"/>
            <ac:spMk id="142" creationId="{1CD12FDB-1467-9D0E-6FB5-CF67B26BD279}"/>
          </ac:spMkLst>
        </pc:spChg>
        <pc:spChg chg="add mod">
          <ac:chgData name="Shawn Wang" userId="b55d1e73-8551-4a55-95aa-63326fdec5d5" providerId="ADAL" clId="{5D2F1D7B-2C31-491D-B7D2-2A71E36A1F1B}" dt="2023-03-01T20:43:26.736" v="460" actId="1038"/>
          <ac:spMkLst>
            <pc:docMk/>
            <pc:sldMk cId="423450712" sldId="261"/>
            <ac:spMk id="153" creationId="{35EBBDE3-79B2-95C4-95C1-62850F94C649}"/>
          </ac:spMkLst>
        </pc:spChg>
        <pc:spChg chg="add mod">
          <ac:chgData name="Shawn Wang" userId="b55d1e73-8551-4a55-95aa-63326fdec5d5" providerId="ADAL" clId="{5D2F1D7B-2C31-491D-B7D2-2A71E36A1F1B}" dt="2023-03-01T20:45:24.183" v="485" actId="1076"/>
          <ac:spMkLst>
            <pc:docMk/>
            <pc:sldMk cId="423450712" sldId="261"/>
            <ac:spMk id="158" creationId="{596DDD98-CB1F-451E-7DF3-FF307EC29009}"/>
          </ac:spMkLst>
        </pc:s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45" creationId="{3BA905B9-99D6-C85C-FDD7-0F83B21E032A}"/>
          </ac:grpSpMkLst>
        </pc:gr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46" creationId="{718DE309-E015-3B0A-DEFF-0615AB1C411C}"/>
          </ac:grpSpMkLst>
        </pc:gr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47" creationId="{C2CABF7F-4A52-9163-8B2C-48B2DA1490F9}"/>
          </ac:grpSpMkLst>
        </pc:gr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48" creationId="{D73C21B8-CCB4-9DB2-2FCE-8835F60132C1}"/>
          </ac:grpSpMkLst>
        </pc:gr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49" creationId="{56C85AE7-ADDB-6796-D92B-8B0E747BC78C}"/>
          </ac:grpSpMkLst>
        </pc:grpChg>
        <pc:grpChg chg="add mod">
          <ac:chgData name="Shawn Wang" userId="b55d1e73-8551-4a55-95aa-63326fdec5d5" providerId="ADAL" clId="{5D2F1D7B-2C31-491D-B7D2-2A71E36A1F1B}" dt="2023-03-01T20:42:53.207" v="448" actId="555"/>
          <ac:grpSpMkLst>
            <pc:docMk/>
            <pc:sldMk cId="423450712" sldId="261"/>
            <ac:grpSpMk id="150" creationId="{F3FCB5B6-0034-329C-308F-F4F15A02AB01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1" creationId="{67683A5A-E2A8-DB9F-F0DD-E88F64B86B97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2" creationId="{22AE140B-1EBF-2A42-4FF8-7F78BF145107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4" creationId="{41DC0345-0A32-0D1E-7768-988DE71D5096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5" creationId="{547ECF27-1846-8B59-CA92-368C2F082287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6" creationId="{61804E37-5D43-B6DB-718D-432145AADCAD}"/>
          </ac:grpSpMkLst>
        </pc:grpChg>
        <pc:grpChg chg="add mod">
          <ac:chgData name="Shawn Wang" userId="b55d1e73-8551-4a55-95aa-63326fdec5d5" providerId="ADAL" clId="{5D2F1D7B-2C31-491D-B7D2-2A71E36A1F1B}" dt="2023-03-01T20:44:18.214" v="465" actId="554"/>
          <ac:grpSpMkLst>
            <pc:docMk/>
            <pc:sldMk cId="423450712" sldId="261"/>
            <ac:grpSpMk id="157" creationId="{B81EC95A-61B2-F07F-FBD2-8F3AEC04105C}"/>
          </ac:grpSpMkLst>
        </pc:grpChg>
        <pc:graphicFrameChg chg="mod">
          <ac:chgData name="Shawn Wang" userId="b55d1e73-8551-4a55-95aa-63326fdec5d5" providerId="ADAL" clId="{5D2F1D7B-2C31-491D-B7D2-2A71E36A1F1B}" dt="2023-03-01T20:44:57.249" v="476" actId="1036"/>
          <ac:graphicFrameMkLst>
            <pc:docMk/>
            <pc:sldMk cId="423450712" sldId="261"/>
            <ac:graphicFrameMk id="6" creationId="{D31A2ED2-FC50-4FC4-958F-19BF61EECDFC}"/>
          </ac:graphicFrameMkLst>
        </pc:graphicFrameChg>
        <pc:graphicFrameChg chg="mod">
          <ac:chgData name="Shawn Wang" userId="b55d1e73-8551-4a55-95aa-63326fdec5d5" providerId="ADAL" clId="{5D2F1D7B-2C31-491D-B7D2-2A71E36A1F1B}" dt="2023-03-01T20:44:58.818" v="482" actId="1036"/>
          <ac:graphicFrameMkLst>
            <pc:docMk/>
            <pc:sldMk cId="423450712" sldId="261"/>
            <ac:graphicFrameMk id="7" creationId="{5BCCC327-1EAC-4A8A-ADC6-338C4790B40B}"/>
          </ac:graphicFrameMkLst>
        </pc:graphicFrame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1" creationId="{9935B8FE-4EC5-B19A-D02A-144ADEB34C6A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2" creationId="{1CD0983F-FBF3-3410-4CAD-80DB05BE69BE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3" creationId="{ED336FD7-AA28-8396-8734-7AC974566DE5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4" creationId="{B83C85B7-2DB4-8CD1-8133-6E3C33A6392C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35" creationId="{3EDD9AE8-8E33-E12D-C3E2-27ED1A2B1EB0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5" creationId="{DF5E13CE-2671-6DA4-5251-3F8B5DAA48A6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6" creationId="{6700BAAC-2C3F-EFAD-F7C4-352032CC6581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36" creationId="{EB4F0EA0-3B2A-679F-023A-2FA1CE0B2803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7" creationId="{37C92400-1ECE-6191-0581-49E6E4F60411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37" creationId="{F7EB7CD4-877D-932D-85E3-EA8463224F8C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38" creationId="{C6623AA2-5626-C6DA-B446-FDADB42C304C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8" creationId="{D068B916-1D4C-5698-6B5C-64CF010CB194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39" creationId="{9A09E154-5F63-CBBD-2845-B3C5E101D532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39" creationId="{F22B9454-88B7-2C0C-2726-B7D201F15730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40" creationId="{6B30BA8D-F36F-7665-9DA6-AF8823D4F9B3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40" creationId="{D829A51E-B618-6C20-201A-4B765F1B6833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41" creationId="{8FC71BD7-F5E6-C07C-6BE5-EBC894F52D64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42" creationId="{7767B495-C972-01EB-9385-1607B38F9C5A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43" creationId="{86597F69-54A6-275A-8C12-771551750CC0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46" creationId="{1D1E6E62-A1B4-4082-5910-CCF8BC8FCE53}"/>
          </ac:picMkLst>
        </pc:picChg>
        <pc:picChg chg="add del mod">
          <ac:chgData name="Shawn Wang" userId="b55d1e73-8551-4a55-95aa-63326fdec5d5" providerId="ADAL" clId="{5D2F1D7B-2C31-491D-B7D2-2A71E36A1F1B}" dt="2023-03-01T19:57:46.167" v="10"/>
          <ac:picMkLst>
            <pc:docMk/>
            <pc:sldMk cId="423450712" sldId="261"/>
            <ac:picMk id="46" creationId="{E90B063D-DE2B-D9C1-18A7-3953358067E1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47" creationId="{DC476CFD-156B-4442-C312-3B251B5B6CB7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3" creationId="{4E7616DE-7488-017F-C121-9A7F563F4952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4" creationId="{09428D6E-2C55-1A61-CD2C-62CB68C76E79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5" creationId="{4F65202F-350C-6C50-5F33-A387F7D875D9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6" creationId="{91FC7247-06E4-FC44-AF8B-C977E4CD62D8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7" creationId="{22243D3E-12A7-C721-F704-B9011947EAEC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8" creationId="{BA459136-396C-5002-5924-05A775B8756B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69" creationId="{AE72A762-6674-9122-5768-CDDC57909524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70" creationId="{A2AC3CC6-0194-BD36-6164-012ED0B8D694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71" creationId="{34CF5852-A04B-A739-CB96-22AB5851575F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72" creationId="{5228E9EC-3CD6-24C2-89FE-9597D482289E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75" creationId="{CAA2A5FE-FFBB-592C-14D4-763377FBE621}"/>
          </ac:picMkLst>
        </pc:picChg>
        <pc:picChg chg="add del mod">
          <ac:chgData name="Shawn Wang" userId="b55d1e73-8551-4a55-95aa-63326fdec5d5" providerId="ADAL" clId="{5D2F1D7B-2C31-491D-B7D2-2A71E36A1F1B}" dt="2023-03-01T20:35:10.160" v="237" actId="478"/>
          <ac:picMkLst>
            <pc:docMk/>
            <pc:sldMk cId="423450712" sldId="261"/>
            <ac:picMk id="78" creationId="{BD49F248-0AA5-1848-FFDD-9692B6745F7C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80" creationId="{9B0A10C7-F59C-A452-89E1-1A833A2B4B53}"/>
          </ac:picMkLst>
        </pc:picChg>
        <pc:picChg chg="add del mod">
          <ac:chgData name="Shawn Wang" userId="b55d1e73-8551-4a55-95aa-63326fdec5d5" providerId="ADAL" clId="{5D2F1D7B-2C31-491D-B7D2-2A71E36A1F1B}" dt="2023-03-01T20:35:22.458" v="240"/>
          <ac:picMkLst>
            <pc:docMk/>
            <pc:sldMk cId="423450712" sldId="261"/>
            <ac:picMk id="83" creationId="{CCCE5495-2169-838E-8E3C-836A960EC7AB}"/>
          </ac:picMkLst>
        </pc:picChg>
        <pc:picChg chg="add mod">
          <ac:chgData name="Shawn Wang" userId="b55d1e73-8551-4a55-95aa-63326fdec5d5" providerId="ADAL" clId="{5D2F1D7B-2C31-491D-B7D2-2A71E36A1F1B}" dt="2023-03-01T20:43:47.505" v="461" actId="164"/>
          <ac:picMkLst>
            <pc:docMk/>
            <pc:sldMk cId="423450712" sldId="261"/>
            <ac:picMk id="105" creationId="{F5B226F1-E588-CFE9-35B6-352C268639C8}"/>
          </ac:picMkLst>
        </pc:picChg>
        <pc:picChg chg="add mod">
          <ac:chgData name="Shawn Wang" userId="b55d1e73-8551-4a55-95aa-63326fdec5d5" providerId="ADAL" clId="{5D2F1D7B-2C31-491D-B7D2-2A71E36A1F1B}" dt="2023-03-01T20:43:53.481" v="462" actId="164"/>
          <ac:picMkLst>
            <pc:docMk/>
            <pc:sldMk cId="423450712" sldId="261"/>
            <ac:picMk id="106" creationId="{34BAB8B7-AA94-9A1D-838C-27700D14B2FF}"/>
          </ac:picMkLst>
        </pc:picChg>
        <pc:picChg chg="add mod">
          <ac:chgData name="Shawn Wang" userId="b55d1e73-8551-4a55-95aa-63326fdec5d5" providerId="ADAL" clId="{5D2F1D7B-2C31-491D-B7D2-2A71E36A1F1B}" dt="2023-03-01T20:43:59.602" v="463" actId="164"/>
          <ac:picMkLst>
            <pc:docMk/>
            <pc:sldMk cId="423450712" sldId="261"/>
            <ac:picMk id="107" creationId="{634802FB-9B76-731C-3BA3-86F50A9E5209}"/>
          </ac:picMkLst>
        </pc:picChg>
        <pc:picChg chg="add mod">
          <ac:chgData name="Shawn Wang" userId="b55d1e73-8551-4a55-95aa-63326fdec5d5" providerId="ADAL" clId="{5D2F1D7B-2C31-491D-B7D2-2A71E36A1F1B}" dt="2023-03-01T20:44:04.867" v="464" actId="164"/>
          <ac:picMkLst>
            <pc:docMk/>
            <pc:sldMk cId="423450712" sldId="261"/>
            <ac:picMk id="108" creationId="{AB7F95C4-6148-689C-794A-067A80708883}"/>
          </ac:picMkLst>
        </pc:picChg>
        <pc:picChg chg="add mod">
          <ac:chgData name="Shawn Wang" userId="b55d1e73-8551-4a55-95aa-63326fdec5d5" providerId="ADAL" clId="{5D2F1D7B-2C31-491D-B7D2-2A71E36A1F1B}" dt="2023-03-01T20:42:29.724" v="446" actId="164"/>
          <ac:picMkLst>
            <pc:docMk/>
            <pc:sldMk cId="423450712" sldId="261"/>
            <ac:picMk id="109" creationId="{4B11F524-6011-5050-81F7-67EEE0BBCA6D}"/>
          </ac:picMkLst>
        </pc:picChg>
        <pc:picChg chg="add del mod">
          <ac:chgData name="Shawn Wang" userId="b55d1e73-8551-4a55-95aa-63326fdec5d5" providerId="ADAL" clId="{5D2F1D7B-2C31-491D-B7D2-2A71E36A1F1B}" dt="2023-03-01T20:38:19.587" v="326" actId="478"/>
          <ac:picMkLst>
            <pc:docMk/>
            <pc:sldMk cId="423450712" sldId="261"/>
            <ac:picMk id="110" creationId="{98CDD539-71AD-2B30-3DD1-14A69EF69D17}"/>
          </ac:picMkLst>
        </pc:picChg>
        <pc:picChg chg="add del mod">
          <ac:chgData name="Shawn Wang" userId="b55d1e73-8551-4a55-95aa-63326fdec5d5" providerId="ADAL" clId="{5D2F1D7B-2C31-491D-B7D2-2A71E36A1F1B}" dt="2023-03-01T20:38:19.587" v="326" actId="478"/>
          <ac:picMkLst>
            <pc:docMk/>
            <pc:sldMk cId="423450712" sldId="261"/>
            <ac:picMk id="111" creationId="{196FBB4F-6AFC-218A-5BD6-20C5D17BAEA3}"/>
          </ac:picMkLst>
        </pc:picChg>
        <pc:picChg chg="add del mod">
          <ac:chgData name="Shawn Wang" userId="b55d1e73-8551-4a55-95aa-63326fdec5d5" providerId="ADAL" clId="{5D2F1D7B-2C31-491D-B7D2-2A71E36A1F1B}" dt="2023-03-01T20:38:19.587" v="326" actId="478"/>
          <ac:picMkLst>
            <pc:docMk/>
            <pc:sldMk cId="423450712" sldId="261"/>
            <ac:picMk id="112" creationId="{EA5C5E5F-8651-33C9-5AF7-29B066B10CFD}"/>
          </ac:picMkLst>
        </pc:picChg>
        <pc:picChg chg="add del mod">
          <ac:chgData name="Shawn Wang" userId="b55d1e73-8551-4a55-95aa-63326fdec5d5" providerId="ADAL" clId="{5D2F1D7B-2C31-491D-B7D2-2A71E36A1F1B}" dt="2023-03-01T20:38:21.541" v="327" actId="478"/>
          <ac:picMkLst>
            <pc:docMk/>
            <pc:sldMk cId="423450712" sldId="261"/>
            <ac:picMk id="116" creationId="{D47F7099-5FE9-E631-BB81-12BB8E4B323D}"/>
          </ac:picMkLst>
        </pc:picChg>
        <pc:picChg chg="add del mod">
          <ac:chgData name="Shawn Wang" userId="b55d1e73-8551-4a55-95aa-63326fdec5d5" providerId="ADAL" clId="{5D2F1D7B-2C31-491D-B7D2-2A71E36A1F1B}" dt="2023-03-01T20:38:19.587" v="326" actId="478"/>
          <ac:picMkLst>
            <pc:docMk/>
            <pc:sldMk cId="423450712" sldId="261"/>
            <ac:picMk id="117" creationId="{A5E83673-A91F-39D0-BE53-3AACC3FF098C}"/>
          </ac:picMkLst>
        </pc:picChg>
        <pc:picChg chg="add mod">
          <ac:chgData name="Shawn Wang" userId="b55d1e73-8551-4a55-95aa-63326fdec5d5" providerId="ADAL" clId="{5D2F1D7B-2C31-491D-B7D2-2A71E36A1F1B}" dt="2023-03-01T20:43:07.429" v="450" actId="164"/>
          <ac:picMkLst>
            <pc:docMk/>
            <pc:sldMk cId="423450712" sldId="261"/>
            <ac:picMk id="118" creationId="{05CB3042-0898-30AB-0CB5-FC35AEFCF783}"/>
          </ac:picMkLst>
        </pc:picChg>
        <pc:picChg chg="add del mod">
          <ac:chgData name="Shawn Wang" userId="b55d1e73-8551-4a55-95aa-63326fdec5d5" providerId="ADAL" clId="{5D2F1D7B-2C31-491D-B7D2-2A71E36A1F1B}" dt="2023-03-01T20:38:19.587" v="326" actId="478"/>
          <ac:picMkLst>
            <pc:docMk/>
            <pc:sldMk cId="423450712" sldId="261"/>
            <ac:picMk id="119" creationId="{CEF871E4-9040-C429-78C8-E5F903F33E0A}"/>
          </ac:picMkLst>
        </pc:picChg>
        <pc:picChg chg="add mod">
          <ac:chgData name="Shawn Wang" userId="b55d1e73-8551-4a55-95aa-63326fdec5d5" providerId="ADAL" clId="{5D2F1D7B-2C31-491D-B7D2-2A71E36A1F1B}" dt="2023-03-01T20:43:00.516" v="449" actId="164"/>
          <ac:picMkLst>
            <pc:docMk/>
            <pc:sldMk cId="423450712" sldId="261"/>
            <ac:picMk id="128" creationId="{274A94FA-6856-1DE5-462E-9512FE7F547D}"/>
          </ac:picMkLst>
        </pc:picChg>
        <pc:picChg chg="add mod">
          <ac:chgData name="Shawn Wang" userId="b55d1e73-8551-4a55-95aa-63326fdec5d5" providerId="ADAL" clId="{5D2F1D7B-2C31-491D-B7D2-2A71E36A1F1B}" dt="2023-03-01T20:42:24.205" v="445" actId="164"/>
          <ac:picMkLst>
            <pc:docMk/>
            <pc:sldMk cId="423450712" sldId="261"/>
            <ac:picMk id="133" creationId="{B86817FB-C8C6-FEB7-85DD-19C2D1637889}"/>
          </ac:picMkLst>
        </pc:picChg>
        <pc:picChg chg="add mod">
          <ac:chgData name="Shawn Wang" userId="b55d1e73-8551-4a55-95aa-63326fdec5d5" providerId="ADAL" clId="{5D2F1D7B-2C31-491D-B7D2-2A71E36A1F1B}" dt="2023-03-01T20:42:37.247" v="447" actId="164"/>
          <ac:picMkLst>
            <pc:docMk/>
            <pc:sldMk cId="423450712" sldId="261"/>
            <ac:picMk id="134" creationId="{F9E7548C-423F-313C-9545-6ECA8CD2BB35}"/>
          </ac:picMkLst>
        </pc:picChg>
        <pc:picChg chg="add mod">
          <ac:chgData name="Shawn Wang" userId="b55d1e73-8551-4a55-95aa-63326fdec5d5" providerId="ADAL" clId="{5D2F1D7B-2C31-491D-B7D2-2A71E36A1F1B}" dt="2023-03-01T20:42:16.694" v="444" actId="164"/>
          <ac:picMkLst>
            <pc:docMk/>
            <pc:sldMk cId="423450712" sldId="261"/>
            <ac:picMk id="135" creationId="{6FCDDE0D-B210-BF4B-0465-31DDF98F8BA8}"/>
          </ac:picMkLst>
        </pc:picChg>
        <pc:picChg chg="add mod">
          <ac:chgData name="Shawn Wang" userId="b55d1e73-8551-4a55-95aa-63326fdec5d5" providerId="ADAL" clId="{5D2F1D7B-2C31-491D-B7D2-2A71E36A1F1B}" dt="2023-03-01T20:42:11.169" v="443" actId="164"/>
          <ac:picMkLst>
            <pc:docMk/>
            <pc:sldMk cId="423450712" sldId="261"/>
            <ac:picMk id="143" creationId="{3B76411E-06E2-80DB-F0EE-50057879394E}"/>
          </ac:picMkLst>
        </pc:picChg>
        <pc:picChg chg="add mod">
          <ac:chgData name="Shawn Wang" userId="b55d1e73-8551-4a55-95aa-63326fdec5d5" providerId="ADAL" clId="{5D2F1D7B-2C31-491D-B7D2-2A71E36A1F1B}" dt="2023-03-01T20:42:05.900" v="442" actId="164"/>
          <ac:picMkLst>
            <pc:docMk/>
            <pc:sldMk cId="423450712" sldId="261"/>
            <ac:picMk id="144" creationId="{8D52AAE2-F035-572D-8CBD-DDADBCF6F827}"/>
          </ac:picMkLst>
        </pc:picChg>
        <pc:cxnChg chg="add del">
          <ac:chgData name="Shawn Wang" userId="b55d1e73-8551-4a55-95aa-63326fdec5d5" providerId="ADAL" clId="{5D2F1D7B-2C31-491D-B7D2-2A71E36A1F1B}" dt="2023-03-01T20:35:11.585" v="238" actId="478"/>
          <ac:cxnSpMkLst>
            <pc:docMk/>
            <pc:sldMk cId="423450712" sldId="261"/>
            <ac:cxnSpMk id="81" creationId="{CBEECB17-BE3C-EDF7-E5E9-2A3EE1310EC1}"/>
          </ac:cxnSpMkLst>
        </pc:cxnChg>
        <pc:cxnChg chg="add mod">
          <ac:chgData name="Shawn Wang" userId="b55d1e73-8551-4a55-95aa-63326fdec5d5" providerId="ADAL" clId="{5D2F1D7B-2C31-491D-B7D2-2A71E36A1F1B}" dt="2023-03-01T20:45:11.839" v="484" actId="208"/>
          <ac:cxnSpMkLst>
            <pc:docMk/>
            <pc:sldMk cId="423450712" sldId="261"/>
            <ac:cxnSpMk id="160" creationId="{F12224AA-5ABA-5125-AFB3-1AD1AEB3899D}"/>
          </ac:cxnSpMkLst>
        </pc:cxnChg>
      </pc:sldChg>
      <pc:sldChg chg="addSp modSp mod">
        <pc:chgData name="Shawn Wang" userId="b55d1e73-8551-4a55-95aa-63326fdec5d5" providerId="ADAL" clId="{5D2F1D7B-2C31-491D-B7D2-2A71E36A1F1B}" dt="2023-03-01T20:51:39.727" v="607" actId="207"/>
        <pc:sldMkLst>
          <pc:docMk/>
          <pc:sldMk cId="1843066077" sldId="266"/>
        </pc:sldMkLst>
        <pc:spChg chg="mod">
          <ac:chgData name="Shawn Wang" userId="b55d1e73-8551-4a55-95aa-63326fdec5d5" providerId="ADAL" clId="{5D2F1D7B-2C31-491D-B7D2-2A71E36A1F1B}" dt="2023-03-01T20:51:39.727" v="607" actId="207"/>
          <ac:spMkLst>
            <pc:docMk/>
            <pc:sldMk cId="1843066077" sldId="266"/>
            <ac:spMk id="2" creationId="{337B18FE-FFC8-4E6C-41F6-9E799B949476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0" creationId="{C31205FA-66CF-415F-A3E6-E49B34A35EC4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1" creationId="{7129F08D-CD5C-4EF9-81DD-919FE726308A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2" creationId="{3BB91F0B-5C28-40A2-AB91-07A89FC01959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3" creationId="{08EEA770-1089-4746-B3D8-83FC7C6026C0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4" creationId="{A7EE60AB-29C5-4AD6-B9E2-F067A7373D3C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25" creationId="{AD11BC07-FEB3-4B37-BD6A-CEE8C92664E1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32" creationId="{65961C56-546E-4664-9D71-7C9D84D14971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33" creationId="{34FD4964-90E1-4634-AD6D-F74E82196AD1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37" creationId="{0D2A9F4E-1ECB-4913-AD20-0EC7AEF776F4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38" creationId="{C347003C-1C72-4382-B03B-CA5709D6D4FD}"/>
          </ac:spMkLst>
        </pc:spChg>
        <pc:spChg chg="mod">
          <ac:chgData name="Shawn Wang" userId="b55d1e73-8551-4a55-95aa-63326fdec5d5" providerId="ADAL" clId="{5D2F1D7B-2C31-491D-B7D2-2A71E36A1F1B}" dt="2023-03-01T20:50:27.446" v="570" actId="1037"/>
          <ac:spMkLst>
            <pc:docMk/>
            <pc:sldMk cId="1843066077" sldId="266"/>
            <ac:spMk id="39" creationId="{B94F0304-E728-4CC7-A85A-7CA7CBB81F2D}"/>
          </ac:spMkLst>
        </pc:spChg>
        <pc:spChg chg="mod">
          <ac:chgData name="Shawn Wang" userId="b55d1e73-8551-4a55-95aa-63326fdec5d5" providerId="ADAL" clId="{5D2F1D7B-2C31-491D-B7D2-2A71E36A1F1B}" dt="2023-03-01T20:50:54.176" v="600" actId="1036"/>
          <ac:spMkLst>
            <pc:docMk/>
            <pc:sldMk cId="1843066077" sldId="266"/>
            <ac:spMk id="40" creationId="{5CE0FC9D-6C9D-473B-AF62-B83A94479923}"/>
          </ac:spMkLst>
        </pc:spChg>
        <pc:spChg chg="add mod">
          <ac:chgData name="Shawn Wang" userId="b55d1e73-8551-4a55-95aa-63326fdec5d5" providerId="ADAL" clId="{5D2F1D7B-2C31-491D-B7D2-2A71E36A1F1B}" dt="2023-03-01T20:51:12.532" v="602" actId="1076"/>
          <ac:spMkLst>
            <pc:docMk/>
            <pc:sldMk cId="1843066077" sldId="266"/>
            <ac:spMk id="42" creationId="{C75F9005-0349-0D21-6B8F-DD0F27B97273}"/>
          </ac:spMkLst>
        </pc:spChg>
        <pc:spChg chg="add mod">
          <ac:chgData name="Shawn Wang" userId="b55d1e73-8551-4a55-95aa-63326fdec5d5" providerId="ADAL" clId="{5D2F1D7B-2C31-491D-B7D2-2A71E36A1F1B}" dt="2023-03-01T20:51:12.532" v="602" actId="1076"/>
          <ac:spMkLst>
            <pc:docMk/>
            <pc:sldMk cId="1843066077" sldId="266"/>
            <ac:spMk id="43" creationId="{E36FF904-783A-44FE-7C8D-2E701E780674}"/>
          </ac:spMkLst>
        </pc:spChg>
        <pc:spChg chg="add mod">
          <ac:chgData name="Shawn Wang" userId="b55d1e73-8551-4a55-95aa-63326fdec5d5" providerId="ADAL" clId="{5D2F1D7B-2C31-491D-B7D2-2A71E36A1F1B}" dt="2023-03-01T20:51:12.532" v="602" actId="1076"/>
          <ac:spMkLst>
            <pc:docMk/>
            <pc:sldMk cId="1843066077" sldId="266"/>
            <ac:spMk id="45" creationId="{8927862D-2108-5B5E-44AB-A4474CA5E939}"/>
          </ac:spMkLst>
        </pc:spChg>
        <pc:spChg chg="add mod">
          <ac:chgData name="Shawn Wang" userId="b55d1e73-8551-4a55-95aa-63326fdec5d5" providerId="ADAL" clId="{5D2F1D7B-2C31-491D-B7D2-2A71E36A1F1B}" dt="2023-03-01T20:51:12.532" v="602" actId="1076"/>
          <ac:spMkLst>
            <pc:docMk/>
            <pc:sldMk cId="1843066077" sldId="266"/>
            <ac:spMk id="46" creationId="{6A45F67F-FB74-5BBF-4280-77A189C294C4}"/>
          </ac:spMkLst>
        </pc:spChg>
        <pc:graphicFrameChg chg="mod">
          <ac:chgData name="Shawn Wang" userId="b55d1e73-8551-4a55-95aa-63326fdec5d5" providerId="ADAL" clId="{5D2F1D7B-2C31-491D-B7D2-2A71E36A1F1B}" dt="2023-03-01T20:51:24.650" v="606" actId="1037"/>
          <ac:graphicFrameMkLst>
            <pc:docMk/>
            <pc:sldMk cId="1843066077" sldId="266"/>
            <ac:graphicFrameMk id="28" creationId="{2DA57F4C-0B4F-40A1-AC83-BAEDFB20D612}"/>
          </ac:graphicFrameMkLst>
        </pc:graphicFrameChg>
        <pc:graphicFrameChg chg="mod">
          <ac:chgData name="Shawn Wang" userId="b55d1e73-8551-4a55-95aa-63326fdec5d5" providerId="ADAL" clId="{5D2F1D7B-2C31-491D-B7D2-2A71E36A1F1B}" dt="2023-03-01T20:50:27.446" v="570" actId="1037"/>
          <ac:graphicFrameMkLst>
            <pc:docMk/>
            <pc:sldMk cId="1843066077" sldId="266"/>
            <ac:graphicFrameMk id="34" creationId="{08A01486-19F3-4F66-9899-A99FC8A391B7}"/>
          </ac:graphicFrameMkLst>
        </pc:graphicFrameChg>
        <pc:graphicFrameChg chg="mod">
          <ac:chgData name="Shawn Wang" userId="b55d1e73-8551-4a55-95aa-63326fdec5d5" providerId="ADAL" clId="{5D2F1D7B-2C31-491D-B7D2-2A71E36A1F1B}" dt="2023-03-01T20:50:27.446" v="570" actId="1037"/>
          <ac:graphicFrameMkLst>
            <pc:docMk/>
            <pc:sldMk cId="1843066077" sldId="266"/>
            <ac:graphicFrameMk id="35" creationId="{E274A859-4C1E-4A86-9281-B9DFE5C611E2}"/>
          </ac:graphicFrameMkLst>
        </pc:graphicFrameChg>
        <pc:graphicFrameChg chg="mod">
          <ac:chgData name="Shawn Wang" userId="b55d1e73-8551-4a55-95aa-63326fdec5d5" providerId="ADAL" clId="{5D2F1D7B-2C31-491D-B7D2-2A71E36A1F1B}" dt="2023-03-01T20:50:27.446" v="570" actId="1037"/>
          <ac:graphicFrameMkLst>
            <pc:docMk/>
            <pc:sldMk cId="1843066077" sldId="266"/>
            <ac:graphicFrameMk id="36" creationId="{AA474382-CA3E-47CC-AF22-E5C03D54D5E9}"/>
          </ac:graphicFrameMkLst>
        </pc:graphicFrameChg>
        <pc:picChg chg="add mod">
          <ac:chgData name="Shawn Wang" userId="b55d1e73-8551-4a55-95aa-63326fdec5d5" providerId="ADAL" clId="{5D2F1D7B-2C31-491D-B7D2-2A71E36A1F1B}" dt="2023-03-01T20:51:12.532" v="602" actId="1076"/>
          <ac:picMkLst>
            <pc:docMk/>
            <pc:sldMk cId="1843066077" sldId="266"/>
            <ac:picMk id="16" creationId="{A1FCA271-1917-E94D-03F5-91BED9E14116}"/>
          </ac:picMkLst>
        </pc:picChg>
        <pc:picChg chg="add mod">
          <ac:chgData name="Shawn Wang" userId="b55d1e73-8551-4a55-95aa-63326fdec5d5" providerId="ADAL" clId="{5D2F1D7B-2C31-491D-B7D2-2A71E36A1F1B}" dt="2023-03-01T20:51:12.532" v="602" actId="1076"/>
          <ac:picMkLst>
            <pc:docMk/>
            <pc:sldMk cId="1843066077" sldId="266"/>
            <ac:picMk id="41" creationId="{58D2F8DE-B38A-1F4C-5921-5200D093C729}"/>
          </ac:picMkLst>
        </pc:picChg>
        <pc:cxnChg chg="mod">
          <ac:chgData name="Shawn Wang" userId="b55d1e73-8551-4a55-95aa-63326fdec5d5" providerId="ADAL" clId="{5D2F1D7B-2C31-491D-B7D2-2A71E36A1F1B}" dt="2023-03-01T20:50:27.446" v="570" actId="1037"/>
          <ac:cxnSpMkLst>
            <pc:docMk/>
            <pc:sldMk cId="1843066077" sldId="266"/>
            <ac:cxnSpMk id="26" creationId="{BFA8963E-162C-40DD-8535-F83A6D7FF374}"/>
          </ac:cxnSpMkLst>
        </pc:cxnChg>
        <pc:cxnChg chg="mod">
          <ac:chgData name="Shawn Wang" userId="b55d1e73-8551-4a55-95aa-63326fdec5d5" providerId="ADAL" clId="{5D2F1D7B-2C31-491D-B7D2-2A71E36A1F1B}" dt="2023-03-01T20:50:27.446" v="570" actId="1037"/>
          <ac:cxnSpMkLst>
            <pc:docMk/>
            <pc:sldMk cId="1843066077" sldId="266"/>
            <ac:cxnSpMk id="31" creationId="{0647702C-BDDC-427D-96AD-AACD93C7BCE7}"/>
          </ac:cxnSpMkLst>
        </pc:cxnChg>
        <pc:cxnChg chg="add mod">
          <ac:chgData name="Shawn Wang" userId="b55d1e73-8551-4a55-95aa-63326fdec5d5" providerId="ADAL" clId="{5D2F1D7B-2C31-491D-B7D2-2A71E36A1F1B}" dt="2023-03-01T20:51:12.532" v="602" actId="1076"/>
          <ac:cxnSpMkLst>
            <pc:docMk/>
            <pc:sldMk cId="1843066077" sldId="266"/>
            <ac:cxnSpMk id="44" creationId="{50E5DC4A-70CD-3935-8B28-F1D9703729B0}"/>
          </ac:cxnSpMkLst>
        </pc:cxnChg>
      </pc:sldChg>
      <pc:sldChg chg="del">
        <pc:chgData name="Shawn Wang" userId="b55d1e73-8551-4a55-95aa-63326fdec5d5" providerId="ADAL" clId="{5D2F1D7B-2C31-491D-B7D2-2A71E36A1F1B}" dt="2023-03-01T19:50:32.049" v="1" actId="47"/>
        <pc:sldMkLst>
          <pc:docMk/>
          <pc:sldMk cId="2306725162" sldId="274"/>
        </pc:sldMkLst>
      </pc:sldChg>
      <pc:sldChg chg="add">
        <pc:chgData name="Shawn Wang" userId="b55d1e73-8551-4a55-95aa-63326fdec5d5" providerId="ADAL" clId="{5D2F1D7B-2C31-491D-B7D2-2A71E36A1F1B}" dt="2023-03-01T19:50:29.812" v="0"/>
        <pc:sldMkLst>
          <pc:docMk/>
          <pc:sldMk cId="3422695395" sldId="27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216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1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724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619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50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1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705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495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629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301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502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DC9FD-E962-43E4-A9D1-130A90D610AA}" type="datetimeFigureOut">
              <a:rPr lang="en-US" smtClean="0"/>
              <a:t>3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9AE74-4B04-4E40-8A57-BBBFDFFAC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944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miltenyibiotec.com/US-en/products/macs-antibodies.html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50.emf"/><Relationship Id="rId3" Type="http://schemas.openxmlformats.org/officeDocument/2006/relationships/image" Target="../media/image45.emf"/><Relationship Id="rId7" Type="http://schemas.openxmlformats.org/officeDocument/2006/relationships/image" Target="../media/image47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5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49.emf"/><Relationship Id="rId5" Type="http://schemas.openxmlformats.org/officeDocument/2006/relationships/image" Target="../media/image46.emf"/><Relationship Id="rId15" Type="http://schemas.openxmlformats.org/officeDocument/2006/relationships/image" Target="../media/image51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8.emf"/><Relationship Id="rId14" Type="http://schemas.openxmlformats.org/officeDocument/2006/relationships/oleObject" Target="../embeddings/oleObject7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58.emf"/><Relationship Id="rId18" Type="http://schemas.openxmlformats.org/officeDocument/2006/relationships/oleObject" Target="../embeddings/oleObject17.bin"/><Relationship Id="rId3" Type="http://schemas.openxmlformats.org/officeDocument/2006/relationships/image" Target="../media/image53.emf"/><Relationship Id="rId21" Type="http://schemas.openxmlformats.org/officeDocument/2006/relationships/image" Target="../media/image62.emf"/><Relationship Id="rId7" Type="http://schemas.openxmlformats.org/officeDocument/2006/relationships/image" Target="../media/image55.emf"/><Relationship Id="rId12" Type="http://schemas.openxmlformats.org/officeDocument/2006/relationships/oleObject" Target="../embeddings/oleObject14.bin"/><Relationship Id="rId17" Type="http://schemas.openxmlformats.org/officeDocument/2006/relationships/image" Target="../media/image60.emf"/><Relationship Id="rId25" Type="http://schemas.openxmlformats.org/officeDocument/2006/relationships/image" Target="../media/image64.emf"/><Relationship Id="rId2" Type="http://schemas.openxmlformats.org/officeDocument/2006/relationships/oleObject" Target="../embeddings/oleObject9.bin"/><Relationship Id="rId16" Type="http://schemas.openxmlformats.org/officeDocument/2006/relationships/oleObject" Target="../embeddings/oleObject16.bin"/><Relationship Id="rId20" Type="http://schemas.openxmlformats.org/officeDocument/2006/relationships/oleObject" Target="../embeddings/oleObject1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57.emf"/><Relationship Id="rId24" Type="http://schemas.openxmlformats.org/officeDocument/2006/relationships/oleObject" Target="../embeddings/oleObject20.bin"/><Relationship Id="rId5" Type="http://schemas.openxmlformats.org/officeDocument/2006/relationships/image" Target="../media/image54.emf"/><Relationship Id="rId15" Type="http://schemas.openxmlformats.org/officeDocument/2006/relationships/image" Target="../media/image59.emf"/><Relationship Id="rId23" Type="http://schemas.openxmlformats.org/officeDocument/2006/relationships/image" Target="../media/image63.emf"/><Relationship Id="rId10" Type="http://schemas.openxmlformats.org/officeDocument/2006/relationships/oleObject" Target="../embeddings/oleObject13.bin"/><Relationship Id="rId19" Type="http://schemas.openxmlformats.org/officeDocument/2006/relationships/image" Target="../media/image61.emf"/><Relationship Id="rId4" Type="http://schemas.openxmlformats.org/officeDocument/2006/relationships/oleObject" Target="../embeddings/oleObject10.bin"/><Relationship Id="rId9" Type="http://schemas.openxmlformats.org/officeDocument/2006/relationships/image" Target="../media/image56.emf"/><Relationship Id="rId14" Type="http://schemas.openxmlformats.org/officeDocument/2006/relationships/oleObject" Target="../embeddings/oleObject15.bin"/><Relationship Id="rId22" Type="http://schemas.openxmlformats.org/officeDocument/2006/relationships/oleObject" Target="../embeddings/oleObject19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13" Type="http://schemas.openxmlformats.org/officeDocument/2006/relationships/image" Target="../media/image70.emf"/><Relationship Id="rId18" Type="http://schemas.openxmlformats.org/officeDocument/2006/relationships/oleObject" Target="../embeddings/oleObject29.bin"/><Relationship Id="rId3" Type="http://schemas.openxmlformats.org/officeDocument/2006/relationships/image" Target="../media/image65.emf"/><Relationship Id="rId21" Type="http://schemas.openxmlformats.org/officeDocument/2006/relationships/image" Target="../media/image74.emf"/><Relationship Id="rId7" Type="http://schemas.openxmlformats.org/officeDocument/2006/relationships/image" Target="../media/image67.emf"/><Relationship Id="rId12" Type="http://schemas.openxmlformats.org/officeDocument/2006/relationships/oleObject" Target="../embeddings/oleObject26.bin"/><Relationship Id="rId17" Type="http://schemas.openxmlformats.org/officeDocument/2006/relationships/image" Target="../media/image72.emf"/><Relationship Id="rId2" Type="http://schemas.openxmlformats.org/officeDocument/2006/relationships/oleObject" Target="../embeddings/oleObject21.bin"/><Relationship Id="rId16" Type="http://schemas.openxmlformats.org/officeDocument/2006/relationships/oleObject" Target="../embeddings/oleObject28.bin"/><Relationship Id="rId20" Type="http://schemas.openxmlformats.org/officeDocument/2006/relationships/oleObject" Target="../embeddings/oleObject30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69.emf"/><Relationship Id="rId5" Type="http://schemas.openxmlformats.org/officeDocument/2006/relationships/image" Target="../media/image66.emf"/><Relationship Id="rId15" Type="http://schemas.openxmlformats.org/officeDocument/2006/relationships/image" Target="../media/image71.emf"/><Relationship Id="rId10" Type="http://schemas.openxmlformats.org/officeDocument/2006/relationships/oleObject" Target="../embeddings/oleObject25.bin"/><Relationship Id="rId19" Type="http://schemas.openxmlformats.org/officeDocument/2006/relationships/image" Target="../media/image73.emf"/><Relationship Id="rId4" Type="http://schemas.openxmlformats.org/officeDocument/2006/relationships/oleObject" Target="../embeddings/oleObject22.bin"/><Relationship Id="rId9" Type="http://schemas.openxmlformats.org/officeDocument/2006/relationships/image" Target="../media/image68.emf"/><Relationship Id="rId14" Type="http://schemas.openxmlformats.org/officeDocument/2006/relationships/oleObject" Target="../embeddings/oleObject27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13" Type="http://schemas.openxmlformats.org/officeDocument/2006/relationships/image" Target="../media/image86.png"/><Relationship Id="rId18" Type="http://schemas.openxmlformats.org/officeDocument/2006/relationships/image" Target="../media/image91.png"/><Relationship Id="rId26" Type="http://schemas.openxmlformats.org/officeDocument/2006/relationships/image" Target="../media/image99.png"/><Relationship Id="rId3" Type="http://schemas.openxmlformats.org/officeDocument/2006/relationships/image" Target="../media/image76.png"/><Relationship Id="rId21" Type="http://schemas.openxmlformats.org/officeDocument/2006/relationships/image" Target="../media/image94.png"/><Relationship Id="rId7" Type="http://schemas.openxmlformats.org/officeDocument/2006/relationships/image" Target="../media/image80.png"/><Relationship Id="rId12" Type="http://schemas.openxmlformats.org/officeDocument/2006/relationships/image" Target="../media/image85.png"/><Relationship Id="rId17" Type="http://schemas.openxmlformats.org/officeDocument/2006/relationships/image" Target="../media/image90.png"/><Relationship Id="rId25" Type="http://schemas.openxmlformats.org/officeDocument/2006/relationships/image" Target="../media/image98.png"/><Relationship Id="rId33" Type="http://schemas.openxmlformats.org/officeDocument/2006/relationships/image" Target="../media/image106.png"/><Relationship Id="rId2" Type="http://schemas.openxmlformats.org/officeDocument/2006/relationships/image" Target="../media/image75.png"/><Relationship Id="rId16" Type="http://schemas.openxmlformats.org/officeDocument/2006/relationships/image" Target="../media/image89.png"/><Relationship Id="rId20" Type="http://schemas.openxmlformats.org/officeDocument/2006/relationships/image" Target="../media/image93.png"/><Relationship Id="rId29" Type="http://schemas.openxmlformats.org/officeDocument/2006/relationships/image" Target="../media/image10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png"/><Relationship Id="rId11" Type="http://schemas.openxmlformats.org/officeDocument/2006/relationships/image" Target="../media/image84.png"/><Relationship Id="rId24" Type="http://schemas.openxmlformats.org/officeDocument/2006/relationships/image" Target="../media/image97.png"/><Relationship Id="rId32" Type="http://schemas.openxmlformats.org/officeDocument/2006/relationships/image" Target="../media/image105.png"/><Relationship Id="rId5" Type="http://schemas.openxmlformats.org/officeDocument/2006/relationships/image" Target="../media/image78.png"/><Relationship Id="rId15" Type="http://schemas.openxmlformats.org/officeDocument/2006/relationships/image" Target="../media/image88.png"/><Relationship Id="rId23" Type="http://schemas.openxmlformats.org/officeDocument/2006/relationships/image" Target="../media/image96.png"/><Relationship Id="rId28" Type="http://schemas.openxmlformats.org/officeDocument/2006/relationships/image" Target="../media/image101.png"/><Relationship Id="rId10" Type="http://schemas.openxmlformats.org/officeDocument/2006/relationships/image" Target="../media/image83.png"/><Relationship Id="rId19" Type="http://schemas.openxmlformats.org/officeDocument/2006/relationships/image" Target="../media/image92.png"/><Relationship Id="rId31" Type="http://schemas.openxmlformats.org/officeDocument/2006/relationships/image" Target="../media/image104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Relationship Id="rId14" Type="http://schemas.openxmlformats.org/officeDocument/2006/relationships/image" Target="../media/image87.png"/><Relationship Id="rId22" Type="http://schemas.openxmlformats.org/officeDocument/2006/relationships/image" Target="../media/image95.png"/><Relationship Id="rId27" Type="http://schemas.openxmlformats.org/officeDocument/2006/relationships/image" Target="../media/image100.png"/><Relationship Id="rId30" Type="http://schemas.openxmlformats.org/officeDocument/2006/relationships/image" Target="../media/image10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4.bin"/><Relationship Id="rId13" Type="http://schemas.openxmlformats.org/officeDocument/2006/relationships/image" Target="../media/image112.emf"/><Relationship Id="rId18" Type="http://schemas.openxmlformats.org/officeDocument/2006/relationships/oleObject" Target="../embeddings/oleObject39.bin"/><Relationship Id="rId26" Type="http://schemas.openxmlformats.org/officeDocument/2006/relationships/oleObject" Target="../embeddings/oleObject43.bin"/><Relationship Id="rId3" Type="http://schemas.openxmlformats.org/officeDocument/2006/relationships/image" Target="../media/image107.emf"/><Relationship Id="rId21" Type="http://schemas.openxmlformats.org/officeDocument/2006/relationships/image" Target="../media/image116.emf"/><Relationship Id="rId34" Type="http://schemas.openxmlformats.org/officeDocument/2006/relationships/oleObject" Target="../embeddings/oleObject47.bin"/><Relationship Id="rId7" Type="http://schemas.openxmlformats.org/officeDocument/2006/relationships/image" Target="../media/image109.emf"/><Relationship Id="rId12" Type="http://schemas.openxmlformats.org/officeDocument/2006/relationships/oleObject" Target="../embeddings/oleObject36.bin"/><Relationship Id="rId17" Type="http://schemas.openxmlformats.org/officeDocument/2006/relationships/image" Target="../media/image114.emf"/><Relationship Id="rId25" Type="http://schemas.openxmlformats.org/officeDocument/2006/relationships/image" Target="../media/image118.emf"/><Relationship Id="rId33" Type="http://schemas.openxmlformats.org/officeDocument/2006/relationships/image" Target="../media/image122.wmf"/><Relationship Id="rId2" Type="http://schemas.openxmlformats.org/officeDocument/2006/relationships/oleObject" Target="../embeddings/oleObject31.bin"/><Relationship Id="rId16" Type="http://schemas.openxmlformats.org/officeDocument/2006/relationships/oleObject" Target="../embeddings/oleObject38.bin"/><Relationship Id="rId20" Type="http://schemas.openxmlformats.org/officeDocument/2006/relationships/oleObject" Target="../embeddings/oleObject40.bin"/><Relationship Id="rId29" Type="http://schemas.openxmlformats.org/officeDocument/2006/relationships/image" Target="../media/image120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3.bin"/><Relationship Id="rId11" Type="http://schemas.openxmlformats.org/officeDocument/2006/relationships/image" Target="../media/image111.emf"/><Relationship Id="rId24" Type="http://schemas.openxmlformats.org/officeDocument/2006/relationships/oleObject" Target="../embeddings/oleObject42.bin"/><Relationship Id="rId32" Type="http://schemas.openxmlformats.org/officeDocument/2006/relationships/oleObject" Target="../embeddings/oleObject46.bin"/><Relationship Id="rId37" Type="http://schemas.openxmlformats.org/officeDocument/2006/relationships/image" Target="../media/image125.png"/><Relationship Id="rId5" Type="http://schemas.openxmlformats.org/officeDocument/2006/relationships/image" Target="../media/image108.emf"/><Relationship Id="rId15" Type="http://schemas.openxmlformats.org/officeDocument/2006/relationships/image" Target="../media/image113.emf"/><Relationship Id="rId23" Type="http://schemas.openxmlformats.org/officeDocument/2006/relationships/image" Target="../media/image117.emf"/><Relationship Id="rId28" Type="http://schemas.openxmlformats.org/officeDocument/2006/relationships/oleObject" Target="../embeddings/oleObject44.bin"/><Relationship Id="rId36" Type="http://schemas.openxmlformats.org/officeDocument/2006/relationships/image" Target="../media/image124.png"/><Relationship Id="rId10" Type="http://schemas.openxmlformats.org/officeDocument/2006/relationships/oleObject" Target="../embeddings/oleObject35.bin"/><Relationship Id="rId19" Type="http://schemas.openxmlformats.org/officeDocument/2006/relationships/image" Target="../media/image115.emf"/><Relationship Id="rId31" Type="http://schemas.openxmlformats.org/officeDocument/2006/relationships/image" Target="../media/image121.wmf"/><Relationship Id="rId4" Type="http://schemas.openxmlformats.org/officeDocument/2006/relationships/oleObject" Target="../embeddings/oleObject32.bin"/><Relationship Id="rId9" Type="http://schemas.openxmlformats.org/officeDocument/2006/relationships/image" Target="../media/image110.emf"/><Relationship Id="rId14" Type="http://schemas.openxmlformats.org/officeDocument/2006/relationships/oleObject" Target="../embeddings/oleObject37.bin"/><Relationship Id="rId22" Type="http://schemas.openxmlformats.org/officeDocument/2006/relationships/oleObject" Target="../embeddings/oleObject41.bin"/><Relationship Id="rId27" Type="http://schemas.openxmlformats.org/officeDocument/2006/relationships/image" Target="../media/image119.emf"/><Relationship Id="rId30" Type="http://schemas.openxmlformats.org/officeDocument/2006/relationships/oleObject" Target="../embeddings/oleObject45.bin"/><Relationship Id="rId35" Type="http://schemas.openxmlformats.org/officeDocument/2006/relationships/image" Target="../media/image123.w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8.bin"/><Relationship Id="rId2" Type="http://schemas.openxmlformats.org/officeDocument/2006/relationships/image" Target="../media/image12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7.w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AA308C46-2089-4D92-AB3B-3D018D58DE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4852" y="4097777"/>
            <a:ext cx="1052311" cy="10363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3ABB527-928D-4D25-8B5D-11F2E0E7A5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4852" y="2976376"/>
            <a:ext cx="1052311" cy="103632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8EEC481-BC2E-4488-878D-EB98D6FBA1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7993" y="516141"/>
            <a:ext cx="1052311" cy="103632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71CFEF56-8A54-4F33-984D-3FA984F2DD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57993" y="1698563"/>
            <a:ext cx="1052311" cy="103632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E86E8EB-159C-4A6D-965A-1262DA39AB0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3461" y="2976376"/>
            <a:ext cx="1052311" cy="10363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DB22CEC-768B-4327-AE43-2A208C9A84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21652" y="2976376"/>
            <a:ext cx="1052311" cy="103632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A0ABC33-5180-400E-A37B-D3921F62FC8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53461" y="4097777"/>
            <a:ext cx="1052311" cy="103632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60B6011-F216-426E-98F4-06AEE601655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21652" y="4097777"/>
            <a:ext cx="1052311" cy="103632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67A17D01-E4E5-428D-9C61-AC431F37474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16601" y="516141"/>
            <a:ext cx="1052311" cy="103632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5139CC3-11BE-46A5-9FB0-AEB98F53816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84793" y="516141"/>
            <a:ext cx="1052311" cy="103632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B0565E62-D18B-4068-BEE5-BC7C21F470F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16601" y="1710376"/>
            <a:ext cx="1052311" cy="103632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0270095A-A70B-4972-B671-AD952BAFAE6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84793" y="1710376"/>
            <a:ext cx="1052311" cy="103632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3D46115-5AE4-4FE9-B91C-6779349EDB98}"/>
              </a:ext>
            </a:extLst>
          </p:cNvPr>
          <p:cNvSpPr txBox="1"/>
          <p:nvPr/>
        </p:nvSpPr>
        <p:spPr>
          <a:xfrm>
            <a:off x="4359427" y="283910"/>
            <a:ext cx="272832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FE1B70-E537-43F5-B6DB-1F039A409B54}"/>
              </a:ext>
            </a:extLst>
          </p:cNvPr>
          <p:cNvSpPr txBox="1"/>
          <p:nvPr/>
        </p:nvSpPr>
        <p:spPr>
          <a:xfrm>
            <a:off x="5164258" y="289431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05 µ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3F2008-4A1D-4272-BD53-5A420B0AABC1}"/>
              </a:ext>
            </a:extLst>
          </p:cNvPr>
          <p:cNvSpPr txBox="1"/>
          <p:nvPr/>
        </p:nvSpPr>
        <p:spPr>
          <a:xfrm>
            <a:off x="6145938" y="278634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25 µM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605B2EC5-E76C-4400-84EA-1B586E97A769}"/>
              </a:ext>
            </a:extLst>
          </p:cNvPr>
          <p:cNvCxnSpPr>
            <a:cxnSpLocks/>
          </p:cNvCxnSpPr>
          <p:nvPr/>
        </p:nvCxnSpPr>
        <p:spPr>
          <a:xfrm flipV="1">
            <a:off x="3893069" y="1380610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B866889-B6E3-4E70-AC5B-9B605D38F758}"/>
              </a:ext>
            </a:extLst>
          </p:cNvPr>
          <p:cNvSpPr txBox="1"/>
          <p:nvPr/>
        </p:nvSpPr>
        <p:spPr>
          <a:xfrm rot="16200000">
            <a:off x="3670980" y="985447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4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8D891EFF-9E60-4B50-9E48-156EB172A007}"/>
              </a:ext>
            </a:extLst>
          </p:cNvPr>
          <p:cNvCxnSpPr>
            <a:cxnSpLocks/>
          </p:cNvCxnSpPr>
          <p:nvPr/>
        </p:nvCxnSpPr>
        <p:spPr>
          <a:xfrm flipV="1">
            <a:off x="3960820" y="3706962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AF3D1821-F610-4AA1-BE39-B8D37B117CCE}"/>
              </a:ext>
            </a:extLst>
          </p:cNvPr>
          <p:cNvSpPr txBox="1"/>
          <p:nvPr/>
        </p:nvSpPr>
        <p:spPr>
          <a:xfrm rot="16200000">
            <a:off x="3724217" y="3387999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4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F5C144F-064E-49FA-8559-1A699C02173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933" y="2976376"/>
            <a:ext cx="1052311" cy="10363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35E96B4-8925-40E9-AEFD-E2CFF5F16E1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099872" y="2976376"/>
            <a:ext cx="1052311" cy="103632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FD3EEE4-EF77-4A86-B5E7-F0035934013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933" y="4097777"/>
            <a:ext cx="1052311" cy="103632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161FEF5-9DF2-48DA-B821-FE52A008204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99872" y="4097777"/>
            <a:ext cx="1052311" cy="103632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77A1FE6-C442-4364-9C2F-511899017CB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98515" y="2976376"/>
            <a:ext cx="1052311" cy="103632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01F37FCF-6978-41CA-B305-F5B8289F903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98515" y="4097777"/>
            <a:ext cx="1052311" cy="103632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F7C48F8-2DA3-46DD-B44C-571D368566D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-6927" y="567174"/>
            <a:ext cx="1052311" cy="103632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49C12AE-BE43-43EE-B223-10C492B93326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063013" y="552804"/>
            <a:ext cx="1052311" cy="103632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26BCED87-3E44-4B4E-9116-F990B8705F1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-6927" y="1703151"/>
            <a:ext cx="1052311" cy="103632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02A11764-2DCE-4F98-AE97-38A733C0621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063013" y="1687170"/>
            <a:ext cx="1052311" cy="103632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D4B97EA-C4E1-4681-9F7E-ABDCF8C61F0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061656" y="552804"/>
            <a:ext cx="1052311" cy="103632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7A1D1B10-53DB-45D5-85FA-000F9E942986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061656" y="1687170"/>
            <a:ext cx="1052311" cy="103632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1CA63C8-9271-46A4-93A0-D2A2477DE88D}"/>
              </a:ext>
            </a:extLst>
          </p:cNvPr>
          <p:cNvSpPr txBox="1"/>
          <p:nvPr/>
        </p:nvSpPr>
        <p:spPr>
          <a:xfrm>
            <a:off x="502458" y="290770"/>
            <a:ext cx="272832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912714-80BB-4460-A44C-30847E0C2112}"/>
              </a:ext>
            </a:extLst>
          </p:cNvPr>
          <p:cNvSpPr txBox="1"/>
          <p:nvPr/>
        </p:nvSpPr>
        <p:spPr>
          <a:xfrm>
            <a:off x="1406442" y="296291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05 µ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2ABEE2-9294-4B40-9057-ADBF1478AC7A}"/>
              </a:ext>
            </a:extLst>
          </p:cNvPr>
          <p:cNvSpPr txBox="1"/>
          <p:nvPr/>
        </p:nvSpPr>
        <p:spPr>
          <a:xfrm>
            <a:off x="2313723" y="285494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25 µM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B757AA34-B768-41CD-B7CB-000D720DF1B7}"/>
              </a:ext>
            </a:extLst>
          </p:cNvPr>
          <p:cNvCxnSpPr>
            <a:cxnSpLocks/>
          </p:cNvCxnSpPr>
          <p:nvPr/>
        </p:nvCxnSpPr>
        <p:spPr>
          <a:xfrm flipV="1">
            <a:off x="98906" y="1377091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3BFEBD00-4E2E-4192-855C-F929D0DBB293}"/>
              </a:ext>
            </a:extLst>
          </p:cNvPr>
          <p:cNvSpPr txBox="1"/>
          <p:nvPr/>
        </p:nvSpPr>
        <p:spPr>
          <a:xfrm rot="16200000">
            <a:off x="-123702" y="975604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8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DF889CEF-F5EB-42E1-A005-FE7568C23A9D}"/>
              </a:ext>
            </a:extLst>
          </p:cNvPr>
          <p:cNvCxnSpPr>
            <a:cxnSpLocks/>
          </p:cNvCxnSpPr>
          <p:nvPr/>
        </p:nvCxnSpPr>
        <p:spPr>
          <a:xfrm flipV="1">
            <a:off x="133606" y="3802593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CBE9F9A8-9EFD-4179-AA6C-93F3C625E27C}"/>
              </a:ext>
            </a:extLst>
          </p:cNvPr>
          <p:cNvSpPr txBox="1"/>
          <p:nvPr/>
        </p:nvSpPr>
        <p:spPr>
          <a:xfrm rot="16200000">
            <a:off x="-89002" y="3477306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8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39EE29F3-25A2-43BF-843C-FF8B2BCABD76}"/>
              </a:ext>
            </a:extLst>
          </p:cNvPr>
          <p:cNvGrpSpPr/>
          <p:nvPr/>
        </p:nvGrpSpPr>
        <p:grpSpPr>
          <a:xfrm>
            <a:off x="907857" y="3818394"/>
            <a:ext cx="1743612" cy="301621"/>
            <a:chOff x="869263" y="3635047"/>
            <a:chExt cx="1538482" cy="266136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8006BE4-4358-4C29-8DD3-6EAC87DE4F7A}"/>
                </a:ext>
              </a:extLst>
            </p:cNvPr>
            <p:cNvSpPr txBox="1"/>
            <p:nvPr/>
          </p:nvSpPr>
          <p:spPr>
            <a:xfrm>
              <a:off x="1808429" y="3635047"/>
              <a:ext cx="599316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CTLA-4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3FCB9EA2-98B6-405E-AF73-51B2C8F7FEF4}"/>
                </a:ext>
              </a:extLst>
            </p:cNvPr>
            <p:cNvCxnSpPr/>
            <p:nvPr/>
          </p:nvCxnSpPr>
          <p:spPr>
            <a:xfrm>
              <a:off x="869263" y="3742517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E950C64C-BD8E-42AD-AEB1-8D1759ADBAB5}"/>
              </a:ext>
            </a:extLst>
          </p:cNvPr>
          <p:cNvGrpSpPr/>
          <p:nvPr/>
        </p:nvGrpSpPr>
        <p:grpSpPr>
          <a:xfrm>
            <a:off x="880414" y="1372915"/>
            <a:ext cx="1599405" cy="301621"/>
            <a:chOff x="845048" y="1241951"/>
            <a:chExt cx="1411240" cy="266136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C5DD7DE-7599-4273-8E1B-023B0C598FFA}"/>
                </a:ext>
              </a:extLst>
            </p:cNvPr>
            <p:cNvSpPr txBox="1"/>
            <p:nvPr/>
          </p:nvSpPr>
          <p:spPr>
            <a:xfrm>
              <a:off x="1769446" y="1241951"/>
              <a:ext cx="486842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IFN-</a:t>
              </a:r>
              <a:r>
                <a:rPr lang="el-GR" sz="1360" dirty="0"/>
                <a:t>γ</a:t>
              </a:r>
              <a:endParaRPr lang="en-US" sz="1360" dirty="0"/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AC47CA95-6144-41F8-993E-4344C591725F}"/>
                </a:ext>
              </a:extLst>
            </p:cNvPr>
            <p:cNvCxnSpPr/>
            <p:nvPr/>
          </p:nvCxnSpPr>
          <p:spPr>
            <a:xfrm>
              <a:off x="845048" y="1380448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5CBE7A46-AD27-43E0-8A2A-AF115EE3F8FA}"/>
              </a:ext>
            </a:extLst>
          </p:cNvPr>
          <p:cNvGrpSpPr/>
          <p:nvPr/>
        </p:nvGrpSpPr>
        <p:grpSpPr>
          <a:xfrm>
            <a:off x="930227" y="2536658"/>
            <a:ext cx="1661922" cy="301621"/>
            <a:chOff x="855384" y="2363359"/>
            <a:chExt cx="1466402" cy="26613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4E359A5-9E18-47E2-951D-359C8B3B9181}"/>
                </a:ext>
              </a:extLst>
            </p:cNvPr>
            <p:cNvSpPr txBox="1"/>
            <p:nvPr/>
          </p:nvSpPr>
          <p:spPr>
            <a:xfrm>
              <a:off x="1779782" y="2363359"/>
              <a:ext cx="542004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TNF-</a:t>
              </a:r>
              <a:r>
                <a:rPr lang="el-GR" sz="1360" dirty="0"/>
                <a:t>α</a:t>
              </a:r>
              <a:endParaRPr lang="en-US" sz="1360" dirty="0"/>
            </a:p>
          </p:txBody>
        </p: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C6076FD5-3DF6-4C20-9059-E896C332C3A9}"/>
                </a:ext>
              </a:extLst>
            </p:cNvPr>
            <p:cNvCxnSpPr/>
            <p:nvPr/>
          </p:nvCxnSpPr>
          <p:spPr>
            <a:xfrm>
              <a:off x="855384" y="2501856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ECC359B4-CACE-4622-AC81-60C0CAEF3CA0}"/>
              </a:ext>
            </a:extLst>
          </p:cNvPr>
          <p:cNvGrpSpPr/>
          <p:nvPr/>
        </p:nvGrpSpPr>
        <p:grpSpPr>
          <a:xfrm>
            <a:off x="907857" y="4929696"/>
            <a:ext cx="1601999" cy="301621"/>
            <a:chOff x="1012710" y="4705252"/>
            <a:chExt cx="1413529" cy="266136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9363D8B-91CC-48F9-894E-B58077D4B7A8}"/>
                </a:ext>
              </a:extLst>
            </p:cNvPr>
            <p:cNvSpPr txBox="1"/>
            <p:nvPr/>
          </p:nvSpPr>
          <p:spPr>
            <a:xfrm>
              <a:off x="1964856" y="4705252"/>
              <a:ext cx="461383" cy="266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60" dirty="0"/>
                <a:t>PD-1</a:t>
              </a: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FD9A27BF-D1EF-4B70-BA8A-AACEDECF20BB}"/>
                </a:ext>
              </a:extLst>
            </p:cNvPr>
            <p:cNvCxnSpPr/>
            <p:nvPr/>
          </p:nvCxnSpPr>
          <p:spPr>
            <a:xfrm>
              <a:off x="1012710" y="4832406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F86C562F-0EF6-4237-B9E8-1BE84BF1AA18}"/>
              </a:ext>
            </a:extLst>
          </p:cNvPr>
          <p:cNvSpPr txBox="1"/>
          <p:nvPr/>
        </p:nvSpPr>
        <p:spPr>
          <a:xfrm>
            <a:off x="-84492" y="-64992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F858CBA-B3A3-4CEE-B4AD-75D98B7C3330}"/>
              </a:ext>
            </a:extLst>
          </p:cNvPr>
          <p:cNvSpPr txBox="1"/>
          <p:nvPr/>
        </p:nvSpPr>
        <p:spPr>
          <a:xfrm>
            <a:off x="4383251" y="2721301"/>
            <a:ext cx="272832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368A7AB-E0C8-4CD4-A300-C64CD45890E2}"/>
              </a:ext>
            </a:extLst>
          </p:cNvPr>
          <p:cNvSpPr txBox="1"/>
          <p:nvPr/>
        </p:nvSpPr>
        <p:spPr>
          <a:xfrm>
            <a:off x="5188082" y="2726822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05 µM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13DDDD0-528A-4BD2-9431-32F4DAE67F4E}"/>
              </a:ext>
            </a:extLst>
          </p:cNvPr>
          <p:cNvSpPr txBox="1"/>
          <p:nvPr/>
        </p:nvSpPr>
        <p:spPr>
          <a:xfrm>
            <a:off x="6169762" y="2716025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25 µM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7C78D98-9585-4E26-B849-5AB3704B7BA4}"/>
              </a:ext>
            </a:extLst>
          </p:cNvPr>
          <p:cNvSpPr txBox="1"/>
          <p:nvPr/>
        </p:nvSpPr>
        <p:spPr>
          <a:xfrm>
            <a:off x="526282" y="2728161"/>
            <a:ext cx="272832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511B630-0683-4D0B-B461-2FBCAC6CAD90}"/>
              </a:ext>
            </a:extLst>
          </p:cNvPr>
          <p:cNvSpPr txBox="1"/>
          <p:nvPr/>
        </p:nvSpPr>
        <p:spPr>
          <a:xfrm>
            <a:off x="1430266" y="2733682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05 µM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226DF97-9A0B-4403-B01C-C7BE31373E02}"/>
              </a:ext>
            </a:extLst>
          </p:cNvPr>
          <p:cNvSpPr txBox="1"/>
          <p:nvPr/>
        </p:nvSpPr>
        <p:spPr>
          <a:xfrm>
            <a:off x="2337547" y="2722885"/>
            <a:ext cx="777777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0.25 µM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9BBEFD9-B7D1-43D6-B952-04D82F9188EF}"/>
              </a:ext>
            </a:extLst>
          </p:cNvPr>
          <p:cNvSpPr txBox="1"/>
          <p:nvPr/>
        </p:nvSpPr>
        <p:spPr>
          <a:xfrm>
            <a:off x="147601" y="8145913"/>
            <a:ext cx="7376017" cy="1523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AEi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dulates CD8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 response and affects cytotoxicity. Magnetically enriched CD3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derived from patients with CLL (n=3 individual patients) were activated with 0.5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g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mL αCD3/28 for 24 hours. Thereafter, stimulation continued in the presence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of the indicated doses of </a:t>
            </a:r>
            <a:r>
              <a:rPr lang="en-US" sz="1300" dirty="0" err="1">
                <a:latin typeface="Arial" panose="020B060402020202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or vehicle control for an additional 72 hours.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Expression of IFN-</a:t>
            </a:r>
            <a:r>
              <a:rPr lang="el-GR" sz="13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, TNF-</a:t>
            </a:r>
            <a:r>
              <a:rPr lang="el-GR" sz="13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, CTLA-4 and PD-1 was quantified in CD4+ or CD8+ T cells by flow cytometry. 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ell death was quantified using 7-AAD expression by flow cytometry Representative flow histograms are shown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DA6632A-DDB4-F407-817E-6050BA19F877}"/>
              </a:ext>
            </a:extLst>
          </p:cNvPr>
          <p:cNvSpPr txBox="1"/>
          <p:nvPr/>
        </p:nvSpPr>
        <p:spPr>
          <a:xfrm>
            <a:off x="65998" y="2295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1FAFCA-74AB-0905-2A70-0CBCC82EB63F}"/>
              </a:ext>
            </a:extLst>
          </p:cNvPr>
          <p:cNvSpPr txBox="1"/>
          <p:nvPr/>
        </p:nvSpPr>
        <p:spPr>
          <a:xfrm>
            <a:off x="253177" y="521679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030B33CD-15C8-4B04-B048-6961A12466C2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999443" y="5565453"/>
            <a:ext cx="1051560" cy="1035579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9F3292EC-80C3-4E0A-8B25-A1919F8B1454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240415" y="5565452"/>
            <a:ext cx="1051560" cy="1035579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C8238D59-621E-4888-ADE9-8A05CED9ABE6}"/>
              </a:ext>
            </a:extLst>
          </p:cNvPr>
          <p:cNvSpPr txBox="1"/>
          <p:nvPr/>
        </p:nvSpPr>
        <p:spPr>
          <a:xfrm>
            <a:off x="1116620" y="5165342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JeKo-1 + T cell</a:t>
            </a:r>
          </a:p>
          <a:p>
            <a:pPr algn="ctr"/>
            <a:r>
              <a:rPr lang="en-US" sz="1000" dirty="0"/>
              <a:t>DMSO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F4124FD-E7DA-4897-9F30-D8DEFA0D89C9}"/>
              </a:ext>
            </a:extLst>
          </p:cNvPr>
          <p:cNvSpPr txBox="1"/>
          <p:nvPr/>
        </p:nvSpPr>
        <p:spPr>
          <a:xfrm>
            <a:off x="2402536" y="5165342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JeKo-1 + T cell</a:t>
            </a:r>
          </a:p>
          <a:p>
            <a:pPr algn="ctr"/>
            <a:r>
              <a:rPr lang="en-US" sz="1000" dirty="0" err="1"/>
              <a:t>Pevo</a:t>
            </a:r>
            <a:endParaRPr lang="en-US" sz="1000" dirty="0"/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id="{73774D3B-AB35-4752-BD0B-45AFB5171C49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688452" y="5565451"/>
            <a:ext cx="1051560" cy="1035579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E42D89DE-E983-4FC4-80A7-C742466574EC}"/>
              </a:ext>
            </a:extLst>
          </p:cNvPr>
          <p:cNvSpPr txBox="1"/>
          <p:nvPr/>
        </p:nvSpPr>
        <p:spPr>
          <a:xfrm>
            <a:off x="3805630" y="5165341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aver-1 + T cell</a:t>
            </a:r>
          </a:p>
          <a:p>
            <a:pPr algn="ctr"/>
            <a:r>
              <a:rPr lang="en-US" sz="1000" dirty="0"/>
              <a:t>DMSO</a:t>
            </a: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B38B2B11-A94C-4646-8027-840C67BE6104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974368" y="5565451"/>
            <a:ext cx="1051560" cy="1035579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5EF7A167-331C-4324-BB02-D0408FE2278B}"/>
              </a:ext>
            </a:extLst>
          </p:cNvPr>
          <p:cNvSpPr txBox="1"/>
          <p:nvPr/>
        </p:nvSpPr>
        <p:spPr>
          <a:xfrm>
            <a:off x="5091546" y="5165341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aver-1 + T cell</a:t>
            </a:r>
          </a:p>
          <a:p>
            <a:pPr algn="ctr"/>
            <a:r>
              <a:rPr lang="en-US" sz="1000" dirty="0" err="1"/>
              <a:t>Pevo</a:t>
            </a:r>
            <a:endParaRPr lang="en-US" sz="1000" dirty="0"/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id="{855B2504-9B99-4530-AAFE-EE6B9F840247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999443" y="6892909"/>
            <a:ext cx="1051560" cy="1035579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315245FF-19A3-47C6-A698-C5387914FFC1}"/>
              </a:ext>
            </a:extLst>
          </p:cNvPr>
          <p:cNvSpPr txBox="1"/>
          <p:nvPr/>
        </p:nvSpPr>
        <p:spPr>
          <a:xfrm>
            <a:off x="1116620" y="6546916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ino + T cell</a:t>
            </a:r>
          </a:p>
          <a:p>
            <a:pPr algn="ctr"/>
            <a:r>
              <a:rPr lang="en-US" sz="1000" dirty="0"/>
              <a:t>DMSO</a:t>
            </a:r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FCACD7DC-6C12-4014-B4E5-E7D094EC2D36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240415" y="6892909"/>
            <a:ext cx="1051560" cy="1035579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87EAF848-F2BB-4367-A9A2-DB71E40C16A1}"/>
              </a:ext>
            </a:extLst>
          </p:cNvPr>
          <p:cNvSpPr txBox="1"/>
          <p:nvPr/>
        </p:nvSpPr>
        <p:spPr>
          <a:xfrm>
            <a:off x="2357593" y="6546915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ino + T cell</a:t>
            </a:r>
          </a:p>
          <a:p>
            <a:pPr algn="ctr"/>
            <a:r>
              <a:rPr lang="en-US" sz="1000" dirty="0" err="1"/>
              <a:t>Pevo</a:t>
            </a:r>
            <a:endParaRPr lang="en-US" sz="1000" dirty="0"/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A5EC4A0B-F058-4150-AC3B-A697689B6DC7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3688452" y="6892908"/>
            <a:ext cx="1051560" cy="1035579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6EAF9749-651C-4767-8188-5C578745F99E}"/>
              </a:ext>
            </a:extLst>
          </p:cNvPr>
          <p:cNvSpPr txBox="1"/>
          <p:nvPr/>
        </p:nvSpPr>
        <p:spPr>
          <a:xfrm>
            <a:off x="3805629" y="6546915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VAL + T cell</a:t>
            </a:r>
          </a:p>
          <a:p>
            <a:pPr algn="ctr"/>
            <a:r>
              <a:rPr lang="en-US" sz="1000" dirty="0"/>
              <a:t>DMSO</a:t>
            </a:r>
          </a:p>
        </p:txBody>
      </p:sp>
      <p:pic>
        <p:nvPicPr>
          <p:cNvPr id="94" name="Picture 93">
            <a:extLst>
              <a:ext uri="{FF2B5EF4-FFF2-40B4-BE49-F238E27FC236}">
                <a16:creationId xmlns:a16="http://schemas.microsoft.com/office/drawing/2014/main" id="{2B4762DC-F64D-49D8-94F8-450E8FD6279F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4974368" y="6892907"/>
            <a:ext cx="1051560" cy="1035579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E82BA538-FF7F-4402-AC16-1390669B4A19}"/>
              </a:ext>
            </a:extLst>
          </p:cNvPr>
          <p:cNvSpPr txBox="1"/>
          <p:nvPr/>
        </p:nvSpPr>
        <p:spPr>
          <a:xfrm>
            <a:off x="5096284" y="6554370"/>
            <a:ext cx="10066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VAL + T cell</a:t>
            </a:r>
          </a:p>
          <a:p>
            <a:pPr algn="ctr"/>
            <a:r>
              <a:rPr lang="en-US" sz="1000" dirty="0" err="1"/>
              <a:t>Pevo</a:t>
            </a:r>
            <a:endParaRPr lang="en-US" sz="1000" dirty="0"/>
          </a:p>
        </p:txBody>
      </p: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98F46AE5-F5D8-430B-829E-CB73628578ED}"/>
              </a:ext>
            </a:extLst>
          </p:cNvPr>
          <p:cNvCxnSpPr>
            <a:cxnSpLocks/>
            <a:endCxn id="98" idx="2"/>
          </p:cNvCxnSpPr>
          <p:nvPr/>
        </p:nvCxnSpPr>
        <p:spPr>
          <a:xfrm flipV="1">
            <a:off x="906628" y="6389589"/>
            <a:ext cx="0" cy="13377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75EFF304-9D30-40C2-AE58-5229EA7F1E86}"/>
              </a:ext>
            </a:extLst>
          </p:cNvPr>
          <p:cNvCxnSpPr>
            <a:cxnSpLocks/>
            <a:endCxn id="99" idx="1"/>
          </p:cNvCxnSpPr>
          <p:nvPr/>
        </p:nvCxnSpPr>
        <p:spPr>
          <a:xfrm>
            <a:off x="1208631" y="7928486"/>
            <a:ext cx="37657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FD341C1C-3098-46B2-BD4F-94B3DF8EBC27}"/>
              </a:ext>
            </a:extLst>
          </p:cNvPr>
          <p:cNvSpPr txBox="1"/>
          <p:nvPr/>
        </p:nvSpPr>
        <p:spPr>
          <a:xfrm>
            <a:off x="675795" y="5524144"/>
            <a:ext cx="461665" cy="86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dirty="0"/>
              <a:t>7-AAD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C61DDC4-04E1-49B6-B964-4CC3A1F35F4B}"/>
              </a:ext>
            </a:extLst>
          </p:cNvPr>
          <p:cNvSpPr txBox="1"/>
          <p:nvPr/>
        </p:nvSpPr>
        <p:spPr>
          <a:xfrm>
            <a:off x="4974368" y="7743820"/>
            <a:ext cx="1264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nnexin</a:t>
            </a:r>
          </a:p>
        </p:txBody>
      </p:sp>
    </p:spTree>
    <p:extLst>
      <p:ext uri="{BB962C8B-B14F-4D97-AF65-F5344CB8AC3E}">
        <p14:creationId xmlns:p14="http://schemas.microsoft.com/office/powerpoint/2010/main" val="34226953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2B3652D6-5090-4B84-96C0-D1E0A7F103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9657185"/>
              </p:ext>
            </p:extLst>
          </p:nvPr>
        </p:nvGraphicFramePr>
        <p:xfrm>
          <a:off x="73227" y="620384"/>
          <a:ext cx="7699173" cy="865878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4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143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05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584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32398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u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n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algn="ctr"/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β-actin 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57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6A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algn="ctr"/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spase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3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66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ly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UBC1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4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13D7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HIF-1 alpha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6169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1S7W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8216025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GATA3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85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13C9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6475039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anti-Nedd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374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-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anta Cruz Biotechnology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0264843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anti-c-</a:t>
                      </a:r>
                      <a:r>
                        <a:rPr lang="en-US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yc</a:t>
                      </a:r>
                      <a:endParaRPr lang="en-US" altLang="zh-CN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40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ly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GB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echnology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139933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 anti-H-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550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b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200" b="0" i="0" u="sng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1/42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altLang="zh-CN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4192245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 anti-PDL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4307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sng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F.9G2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altLang="zh-CN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5908037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/cy7 anti-CD3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59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A2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7293850"/>
                  </a:ext>
                </a:extLst>
              </a:tr>
              <a:tr h="3896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V605 anti-CD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547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4-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altLang="zh-CN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432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V421 anti-CD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3898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-6.7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4543105"/>
                  </a:ext>
                </a:extLst>
              </a:tr>
              <a:tr h="2814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y5.5 anti-CD2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1112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6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8861892"/>
                  </a:ext>
                </a:extLst>
              </a:tr>
              <a:tr h="2814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exa </a:t>
                      </a: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uor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8 anti-Foxp3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40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-1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4547941"/>
                  </a:ext>
                </a:extLst>
              </a:tr>
              <a:tr h="2814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 anti-IL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04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B1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302437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 anti-IL2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4429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ES6-5H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3982811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y5.5 anti-IL17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666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11-18H10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1862719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TC anti-IFN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-117-780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638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2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iltenyi Biotec</a:t>
                      </a:r>
                      <a:endParaRPr kumimoji="0" lang="en-US" sz="12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  <a:hlinkClick r:id="rId2">
                          <a:extLst>
                            <a:ext uri="{A12FA001-AC4F-418D-AE19-62706E023703}">
                              <ahyp:hlinkClr xmlns:ahyp="http://schemas.microsoft.com/office/drawing/2018/hyperlinkcolor" val="tx"/>
                            </a:ext>
                          </a:extLst>
                        </a:hlinkClick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4550049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/cy7 anti-CD3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785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4050423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 anti-CD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2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iltenyi Biotec</a:t>
                      </a:r>
                      <a:endParaRPr kumimoji="0" lang="en-US" sz="12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  <a:hlinkClick r:id="rId2">
                          <a:extLst>
                            <a:ext uri="{A12FA001-AC4F-418D-AE19-62706E023703}">
                              <ahyp:hlinkClr xmlns:ahyp="http://schemas.microsoft.com/office/drawing/2018/hyperlinkcolor" val="tx"/>
                            </a:ext>
                          </a:extLst>
                        </a:hlinkClick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 anti-CD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741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KT4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altLang="zh-CN" sz="1200" b="0" i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605 anti-CD8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74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iolegend</a:t>
                      </a: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 anti-CD8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70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1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iolegend</a:t>
                      </a: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421 anti-CD279 (PD1)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5935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93836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y5.5 anti-CD152 (CTLA4)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9607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NI3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y5.5 anti-TNF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679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29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650 anti-IFN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3416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S.B3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10795" marR="10795" marT="1079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A506DE1F-A61E-4E6F-B515-2387225B0E06}"/>
              </a:ext>
            </a:extLst>
          </p:cNvPr>
          <p:cNvSpPr/>
          <p:nvPr/>
        </p:nvSpPr>
        <p:spPr>
          <a:xfrm>
            <a:off x="0" y="99164"/>
            <a:ext cx="71928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l Table S2: List of antibodies used</a:t>
            </a:r>
          </a:p>
        </p:txBody>
      </p:sp>
    </p:spTree>
    <p:extLst>
      <p:ext uri="{BB962C8B-B14F-4D97-AF65-F5344CB8AC3E}">
        <p14:creationId xmlns:p14="http://schemas.microsoft.com/office/powerpoint/2010/main" val="2291650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AD77E35F-376B-49D6-B688-7AF1F88D7288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2</a:t>
            </a: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41DC0345-0A32-0D1E-7768-988DE71D5096}"/>
              </a:ext>
            </a:extLst>
          </p:cNvPr>
          <p:cNvGrpSpPr/>
          <p:nvPr/>
        </p:nvGrpSpPr>
        <p:grpSpPr>
          <a:xfrm>
            <a:off x="147344" y="844647"/>
            <a:ext cx="1162047" cy="1215801"/>
            <a:chOff x="248944" y="341635"/>
            <a:chExt cx="1162047" cy="1215801"/>
          </a:xfrm>
        </p:grpSpPr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BAC98FF-5780-5651-B3F0-B2FC9FB5BE94}"/>
                </a:ext>
              </a:extLst>
            </p:cNvPr>
            <p:cNvSpPr txBox="1"/>
            <p:nvPr/>
          </p:nvSpPr>
          <p:spPr>
            <a:xfrm>
              <a:off x="248944" y="348694"/>
              <a:ext cx="369332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/>
                <a:t>SSC-A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9F5D5840-CE85-106B-D31A-76761031147A}"/>
                </a:ext>
              </a:extLst>
            </p:cNvPr>
            <p:cNvSpPr txBox="1"/>
            <p:nvPr/>
          </p:nvSpPr>
          <p:spPr>
            <a:xfrm>
              <a:off x="708509" y="1280437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FSC-A</a:t>
              </a:r>
            </a:p>
          </p:txBody>
        </p:sp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F5B226F1-E588-CFE9-35B6-352C268639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179" b="8681"/>
            <a:stretch/>
          </p:blipFill>
          <p:spPr>
            <a:xfrm>
              <a:off x="496591" y="341635"/>
              <a:ext cx="914400" cy="940111"/>
            </a:xfrm>
            <a:prstGeom prst="rect">
              <a:avLst/>
            </a:prstGeom>
          </p:spPr>
        </p:pic>
      </p:grp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547ECF27-1846-8B59-CA92-368C2F082287}"/>
              </a:ext>
            </a:extLst>
          </p:cNvPr>
          <p:cNvGrpSpPr/>
          <p:nvPr/>
        </p:nvGrpSpPr>
        <p:grpSpPr>
          <a:xfrm>
            <a:off x="1430883" y="844647"/>
            <a:ext cx="1164997" cy="1204932"/>
            <a:chOff x="1532483" y="323947"/>
            <a:chExt cx="1164997" cy="1204932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9BC88F8-1561-E818-EA20-9D5EEA04D066}"/>
                </a:ext>
              </a:extLst>
            </p:cNvPr>
            <p:cNvSpPr txBox="1"/>
            <p:nvPr/>
          </p:nvSpPr>
          <p:spPr>
            <a:xfrm>
              <a:off x="1532483" y="323948"/>
              <a:ext cx="369332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/>
                <a:t>FSC-H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05A0ED4E-5DC2-AE1E-8C4F-B29E2401E9D0}"/>
                </a:ext>
              </a:extLst>
            </p:cNvPr>
            <p:cNvSpPr txBox="1"/>
            <p:nvPr/>
          </p:nvSpPr>
          <p:spPr>
            <a:xfrm>
              <a:off x="1964016" y="125188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FSC-A</a:t>
              </a:r>
            </a:p>
          </p:txBody>
        </p:sp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34BAB8B7-AA94-9A1D-838C-27700D14B2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031" b="9415"/>
            <a:stretch/>
          </p:blipFill>
          <p:spPr>
            <a:xfrm>
              <a:off x="1783080" y="323947"/>
              <a:ext cx="914400" cy="930996"/>
            </a:xfrm>
            <a:prstGeom prst="rect">
              <a:avLst/>
            </a:prstGeom>
          </p:spPr>
        </p:pic>
      </p:grp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61804E37-5D43-B6DB-718D-432145AADCAD}"/>
              </a:ext>
            </a:extLst>
          </p:cNvPr>
          <p:cNvGrpSpPr/>
          <p:nvPr/>
        </p:nvGrpSpPr>
        <p:grpSpPr>
          <a:xfrm>
            <a:off x="2710477" y="844647"/>
            <a:ext cx="1163023" cy="1215799"/>
            <a:chOff x="2812077" y="341635"/>
            <a:chExt cx="1163023" cy="1215799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0CBCC004-74AC-EFB5-8C34-4CDC2F040C4E}"/>
                </a:ext>
              </a:extLst>
            </p:cNvPr>
            <p:cNvSpPr txBox="1"/>
            <p:nvPr/>
          </p:nvSpPr>
          <p:spPr>
            <a:xfrm>
              <a:off x="3267274" y="1280435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qua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857EDCE-5E91-29DC-DA67-9B4C65384F8B}"/>
                </a:ext>
              </a:extLst>
            </p:cNvPr>
            <p:cNvSpPr txBox="1"/>
            <p:nvPr/>
          </p:nvSpPr>
          <p:spPr>
            <a:xfrm>
              <a:off x="2812077" y="609143"/>
              <a:ext cx="369332" cy="42172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3</a:t>
              </a:r>
            </a:p>
          </p:txBody>
        </p:sp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634802FB-9B76-731C-3BA3-86F50A9E52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031" b="9017"/>
            <a:stretch/>
          </p:blipFill>
          <p:spPr>
            <a:xfrm>
              <a:off x="3060700" y="341635"/>
              <a:ext cx="914400" cy="935093"/>
            </a:xfrm>
            <a:prstGeom prst="rect">
              <a:avLst/>
            </a:prstGeom>
          </p:spPr>
        </p:pic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B81EC95A-61B2-F07F-FBD2-8F3AEC04105C}"/>
              </a:ext>
            </a:extLst>
          </p:cNvPr>
          <p:cNvGrpSpPr/>
          <p:nvPr/>
        </p:nvGrpSpPr>
        <p:grpSpPr>
          <a:xfrm>
            <a:off x="4029352" y="844647"/>
            <a:ext cx="1151953" cy="1205872"/>
            <a:chOff x="4130952" y="323947"/>
            <a:chExt cx="1151953" cy="1205872"/>
          </a:xfrm>
        </p:grpSpPr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E8FAEAC4-445C-1DAE-AC18-B3FF8C0888B8}"/>
                </a:ext>
              </a:extLst>
            </p:cNvPr>
            <p:cNvSpPr txBox="1"/>
            <p:nvPr/>
          </p:nvSpPr>
          <p:spPr>
            <a:xfrm>
              <a:off x="4130952" y="454389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E0F0C10-ED2C-3562-7DB5-CCB8B2AB9DDF}"/>
                </a:ext>
              </a:extLst>
            </p:cNvPr>
            <p:cNvSpPr txBox="1"/>
            <p:nvPr/>
          </p:nvSpPr>
          <p:spPr>
            <a:xfrm>
              <a:off x="4582275" y="125282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CD8</a:t>
              </a:r>
            </a:p>
          </p:txBody>
        </p:sp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AB7F95C4-6148-689C-794A-067A807088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031" b="9689"/>
            <a:stretch/>
          </p:blipFill>
          <p:spPr>
            <a:xfrm>
              <a:off x="4368505" y="323947"/>
              <a:ext cx="914400" cy="928194"/>
            </a:xfrm>
            <a:prstGeom prst="rect">
              <a:avLst/>
            </a:prstGeom>
          </p:spPr>
        </p:pic>
      </p:grpSp>
      <p:grpSp>
        <p:nvGrpSpPr>
          <p:cNvPr id="149" name="Group 148">
            <a:extLst>
              <a:ext uri="{FF2B5EF4-FFF2-40B4-BE49-F238E27FC236}">
                <a16:creationId xmlns:a16="http://schemas.microsoft.com/office/drawing/2014/main" id="{56C85AE7-ADDB-6796-D92B-8B0E747BC78C}"/>
              </a:ext>
            </a:extLst>
          </p:cNvPr>
          <p:cNvGrpSpPr/>
          <p:nvPr/>
        </p:nvGrpSpPr>
        <p:grpSpPr>
          <a:xfrm>
            <a:off x="115225" y="2151227"/>
            <a:ext cx="1159658" cy="1209402"/>
            <a:chOff x="216825" y="1497296"/>
            <a:chExt cx="1159658" cy="1209402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2712B487-7F1A-7BD7-29EF-DD85FAF7D091}"/>
                </a:ext>
              </a:extLst>
            </p:cNvPr>
            <p:cNvSpPr txBox="1"/>
            <p:nvPr/>
          </p:nvSpPr>
          <p:spPr>
            <a:xfrm>
              <a:off x="674001" y="2429699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IFN-</a:t>
              </a:r>
              <a:r>
                <a:rPr lang="el-GR" sz="1200" dirty="0"/>
                <a:t>γ</a:t>
              </a:r>
              <a:endParaRPr lang="en-US" sz="1200" dirty="0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8F30BE7-2CC0-2BF4-9D8C-7450D2FAC574}"/>
                </a:ext>
              </a:extLst>
            </p:cNvPr>
            <p:cNvSpPr txBox="1"/>
            <p:nvPr/>
          </p:nvSpPr>
          <p:spPr>
            <a:xfrm>
              <a:off x="216825" y="1629925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4B11F524-6011-5050-81F7-67EEE0BBCA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0919" b="8681"/>
            <a:stretch/>
          </p:blipFill>
          <p:spPr>
            <a:xfrm>
              <a:off x="462083" y="1497296"/>
              <a:ext cx="914400" cy="937364"/>
            </a:xfrm>
            <a:prstGeom prst="rect">
              <a:avLst/>
            </a:prstGeom>
          </p:spPr>
        </p:pic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22AE140B-1EBF-2A42-4FF8-7F78BF145107}"/>
              </a:ext>
            </a:extLst>
          </p:cNvPr>
          <p:cNvGrpSpPr/>
          <p:nvPr/>
        </p:nvGrpSpPr>
        <p:grpSpPr>
          <a:xfrm>
            <a:off x="5350700" y="844647"/>
            <a:ext cx="1174402" cy="1236335"/>
            <a:chOff x="5452300" y="405974"/>
            <a:chExt cx="1174402" cy="1236335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98CDB38-A8F2-1122-6100-C576977847D0}"/>
                </a:ext>
              </a:extLst>
            </p:cNvPr>
            <p:cNvSpPr txBox="1"/>
            <p:nvPr/>
          </p:nvSpPr>
          <p:spPr>
            <a:xfrm>
              <a:off x="5452300" y="541245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8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51A5EB8-3532-60A7-2999-781935340666}"/>
                </a:ext>
              </a:extLst>
            </p:cNvPr>
            <p:cNvSpPr txBox="1"/>
            <p:nvPr/>
          </p:nvSpPr>
          <p:spPr>
            <a:xfrm>
              <a:off x="5878381" y="136531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IFN-</a:t>
              </a:r>
              <a:r>
                <a:rPr lang="el-GR" sz="1200" dirty="0"/>
                <a:t>γ</a:t>
              </a:r>
              <a:endParaRPr lang="en-US" sz="1200" dirty="0"/>
            </a:p>
          </p:txBody>
        </p:sp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05CB3042-0898-30AB-0CB5-FC35AEFCF7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918" b="8770"/>
            <a:stretch/>
          </p:blipFill>
          <p:spPr>
            <a:xfrm>
              <a:off x="5712302" y="405974"/>
              <a:ext cx="914400" cy="936453"/>
            </a:xfrm>
            <a:prstGeom prst="rect">
              <a:avLst/>
            </a:prstGeom>
          </p:spPr>
        </p:pic>
      </p:grpSp>
      <p:sp>
        <p:nvSpPr>
          <p:cNvPr id="122" name="Arrow: Right 121">
            <a:extLst>
              <a:ext uri="{FF2B5EF4-FFF2-40B4-BE49-F238E27FC236}">
                <a16:creationId xmlns:a16="http://schemas.microsoft.com/office/drawing/2014/main" id="{39DA1A9F-6883-34B8-6561-8486BF5B722B}"/>
              </a:ext>
            </a:extLst>
          </p:cNvPr>
          <p:cNvSpPr/>
          <p:nvPr/>
        </p:nvSpPr>
        <p:spPr>
          <a:xfrm>
            <a:off x="1316557" y="1230232"/>
            <a:ext cx="202382" cy="13004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Arrow: Right 122">
            <a:extLst>
              <a:ext uri="{FF2B5EF4-FFF2-40B4-BE49-F238E27FC236}">
                <a16:creationId xmlns:a16="http://schemas.microsoft.com/office/drawing/2014/main" id="{494B10C5-829D-9D81-F85F-AB63CDA7C5C5}"/>
              </a:ext>
            </a:extLst>
          </p:cNvPr>
          <p:cNvSpPr/>
          <p:nvPr/>
        </p:nvSpPr>
        <p:spPr>
          <a:xfrm>
            <a:off x="2600866" y="1264860"/>
            <a:ext cx="202382" cy="13004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Arrow: Right 123">
            <a:extLst>
              <a:ext uri="{FF2B5EF4-FFF2-40B4-BE49-F238E27FC236}">
                <a16:creationId xmlns:a16="http://schemas.microsoft.com/office/drawing/2014/main" id="{EFA1019C-5689-CF98-112E-2744879D20D9}"/>
              </a:ext>
            </a:extLst>
          </p:cNvPr>
          <p:cNvSpPr/>
          <p:nvPr/>
        </p:nvSpPr>
        <p:spPr>
          <a:xfrm>
            <a:off x="3894657" y="1281032"/>
            <a:ext cx="202382" cy="13004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67683A5A-E2A8-DB9F-F0DD-E88F64B86B97}"/>
              </a:ext>
            </a:extLst>
          </p:cNvPr>
          <p:cNvGrpSpPr/>
          <p:nvPr/>
        </p:nvGrpSpPr>
        <p:grpSpPr>
          <a:xfrm>
            <a:off x="6471510" y="844647"/>
            <a:ext cx="1164997" cy="1236335"/>
            <a:chOff x="6573110" y="405974"/>
            <a:chExt cx="1164997" cy="1236335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7F11FC15-2719-934C-93DC-52FCB2419AEA}"/>
                </a:ext>
              </a:extLst>
            </p:cNvPr>
            <p:cNvSpPr txBox="1"/>
            <p:nvPr/>
          </p:nvSpPr>
          <p:spPr>
            <a:xfrm>
              <a:off x="6999576" y="136531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D-1</a:t>
              </a:r>
            </a:p>
          </p:txBody>
        </p:sp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274A94FA-6856-1DE5-462E-9512FE7F54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0918" b="8770"/>
            <a:stretch/>
          </p:blipFill>
          <p:spPr>
            <a:xfrm>
              <a:off x="6823707" y="405974"/>
              <a:ext cx="914400" cy="936453"/>
            </a:xfrm>
            <a:prstGeom prst="rect">
              <a:avLst/>
            </a:prstGeom>
          </p:spPr>
        </p:pic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B24D2B13-E8B9-9DB9-F9FF-29036B2D18E7}"/>
                </a:ext>
              </a:extLst>
            </p:cNvPr>
            <p:cNvSpPr txBox="1"/>
            <p:nvPr/>
          </p:nvSpPr>
          <p:spPr>
            <a:xfrm>
              <a:off x="6573110" y="674782"/>
              <a:ext cx="369332" cy="42172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8</a:t>
              </a:r>
            </a:p>
          </p:txBody>
        </p:sp>
      </p:grp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F3FCB5B6-0034-329C-308F-F4F15A02AB01}"/>
              </a:ext>
            </a:extLst>
          </p:cNvPr>
          <p:cNvGrpSpPr/>
          <p:nvPr/>
        </p:nvGrpSpPr>
        <p:grpSpPr>
          <a:xfrm>
            <a:off x="1276353" y="2150008"/>
            <a:ext cx="1173548" cy="1210621"/>
            <a:chOff x="1377953" y="1473587"/>
            <a:chExt cx="1173548" cy="1210621"/>
          </a:xfrm>
        </p:grpSpPr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7AD28D8B-E580-270F-A65F-977DDAAAA8CD}"/>
                </a:ext>
              </a:extLst>
            </p:cNvPr>
            <p:cNvSpPr txBox="1"/>
            <p:nvPr/>
          </p:nvSpPr>
          <p:spPr>
            <a:xfrm>
              <a:off x="1859760" y="2407209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IL-2</a:t>
              </a:r>
            </a:p>
          </p:txBody>
        </p:sp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F9E7548C-423F-313C-9545-6ECA8CD2BB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918" b="8681"/>
            <a:stretch/>
          </p:blipFill>
          <p:spPr>
            <a:xfrm>
              <a:off x="1637101" y="1473587"/>
              <a:ext cx="914400" cy="937364"/>
            </a:xfrm>
            <a:prstGeom prst="rect">
              <a:avLst/>
            </a:prstGeom>
          </p:spPr>
        </p:pic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1C467C9-EB8C-1419-71F2-71C380269336}"/>
                </a:ext>
              </a:extLst>
            </p:cNvPr>
            <p:cNvSpPr txBox="1"/>
            <p:nvPr/>
          </p:nvSpPr>
          <p:spPr>
            <a:xfrm>
              <a:off x="1377953" y="1607438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D73C21B8-CCB4-9DB2-2FCE-8835F60132C1}"/>
              </a:ext>
            </a:extLst>
          </p:cNvPr>
          <p:cNvGrpSpPr/>
          <p:nvPr/>
        </p:nvGrpSpPr>
        <p:grpSpPr>
          <a:xfrm>
            <a:off x="2640703" y="2150007"/>
            <a:ext cx="1163023" cy="1210622"/>
            <a:chOff x="2742303" y="1457810"/>
            <a:chExt cx="1163023" cy="1210622"/>
          </a:xfrm>
        </p:grpSpPr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021CB16A-80D9-6FC8-FB8C-092F06673ACB}"/>
                </a:ext>
              </a:extLst>
            </p:cNvPr>
            <p:cNvSpPr txBox="1"/>
            <p:nvPr/>
          </p:nvSpPr>
          <p:spPr>
            <a:xfrm>
              <a:off x="3174863" y="2391433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IL-4</a:t>
              </a:r>
            </a:p>
          </p:txBody>
        </p:sp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B86817FB-C8C6-FEB7-85DD-19C2D16378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1030" b="8073"/>
            <a:stretch/>
          </p:blipFill>
          <p:spPr>
            <a:xfrm>
              <a:off x="2990926" y="1457810"/>
              <a:ext cx="914400" cy="944808"/>
            </a:xfrm>
            <a:prstGeom prst="rect">
              <a:avLst/>
            </a:prstGeom>
          </p:spPr>
        </p:pic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AD1F5C2B-130E-CAD4-5144-18D159615D47}"/>
                </a:ext>
              </a:extLst>
            </p:cNvPr>
            <p:cNvSpPr txBox="1"/>
            <p:nvPr/>
          </p:nvSpPr>
          <p:spPr>
            <a:xfrm>
              <a:off x="2742303" y="1602270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C2CABF7F-4A52-9163-8B2C-48B2DA1490F9}"/>
              </a:ext>
            </a:extLst>
          </p:cNvPr>
          <p:cNvGrpSpPr/>
          <p:nvPr/>
        </p:nvGrpSpPr>
        <p:grpSpPr>
          <a:xfrm>
            <a:off x="3983583" y="2150007"/>
            <a:ext cx="1164944" cy="1210622"/>
            <a:chOff x="4085183" y="1457810"/>
            <a:chExt cx="1164944" cy="1210622"/>
          </a:xfrm>
        </p:grpSpPr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B658EA6-5412-53E7-8014-BAC88E4D8E4F}"/>
                </a:ext>
              </a:extLst>
            </p:cNvPr>
            <p:cNvSpPr txBox="1"/>
            <p:nvPr/>
          </p:nvSpPr>
          <p:spPr>
            <a:xfrm>
              <a:off x="4551591" y="2391433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IL-17</a:t>
              </a:r>
            </a:p>
          </p:txBody>
        </p:sp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6FCDDE0D-B210-BF4B-0465-31DDF98F8B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030" b="9018"/>
            <a:stretch/>
          </p:blipFill>
          <p:spPr>
            <a:xfrm>
              <a:off x="4335727" y="1457810"/>
              <a:ext cx="914400" cy="935093"/>
            </a:xfrm>
            <a:prstGeom prst="rect">
              <a:avLst/>
            </a:prstGeom>
          </p:spPr>
        </p:pic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0F871DD2-D2D2-1F55-4310-273885E750D6}"/>
                </a:ext>
              </a:extLst>
            </p:cNvPr>
            <p:cNvSpPr txBox="1"/>
            <p:nvPr/>
          </p:nvSpPr>
          <p:spPr>
            <a:xfrm>
              <a:off x="4085183" y="1611369"/>
              <a:ext cx="353943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718DE309-E015-3B0A-DEFF-0615AB1C411C}"/>
              </a:ext>
            </a:extLst>
          </p:cNvPr>
          <p:cNvGrpSpPr/>
          <p:nvPr/>
        </p:nvGrpSpPr>
        <p:grpSpPr>
          <a:xfrm>
            <a:off x="5092718" y="2096906"/>
            <a:ext cx="1162880" cy="1263723"/>
            <a:chOff x="5194318" y="1576206"/>
            <a:chExt cx="1162880" cy="1263723"/>
          </a:xfrm>
        </p:grpSpPr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21CBCD4-2E05-DC2E-A12F-2DA9AF5CFB5D}"/>
                </a:ext>
              </a:extLst>
            </p:cNvPr>
            <p:cNvSpPr txBox="1"/>
            <p:nvPr/>
          </p:nvSpPr>
          <p:spPr>
            <a:xfrm>
              <a:off x="5194318" y="1719694"/>
              <a:ext cx="369332" cy="68879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25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7AE3DED-811B-0704-92B9-AC361323159C}"/>
                </a:ext>
              </a:extLst>
            </p:cNvPr>
            <p:cNvSpPr txBox="1"/>
            <p:nvPr/>
          </p:nvSpPr>
          <p:spPr>
            <a:xfrm>
              <a:off x="5657451" y="256293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Foxp3</a:t>
              </a:r>
            </a:p>
          </p:txBody>
        </p:sp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id="{3B76411E-06E2-80DB-F0EE-5005787939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0918" b="8770"/>
            <a:stretch/>
          </p:blipFill>
          <p:spPr>
            <a:xfrm>
              <a:off x="5442798" y="1576206"/>
              <a:ext cx="914400" cy="936455"/>
            </a:xfrm>
            <a:prstGeom prst="rect">
              <a:avLst/>
            </a:prstGeom>
          </p:spPr>
        </p:pic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3BA905B9-99D6-C85C-FDD7-0F83B21E032A}"/>
              </a:ext>
            </a:extLst>
          </p:cNvPr>
          <p:cNvGrpSpPr/>
          <p:nvPr/>
        </p:nvGrpSpPr>
        <p:grpSpPr>
          <a:xfrm>
            <a:off x="6438117" y="2094501"/>
            <a:ext cx="1177117" cy="1266128"/>
            <a:chOff x="6539717" y="1573801"/>
            <a:chExt cx="1177117" cy="1266128"/>
          </a:xfrm>
        </p:grpSpPr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DAD88F86-5BAA-046F-329F-656AE3C9B082}"/>
                </a:ext>
              </a:extLst>
            </p:cNvPr>
            <p:cNvSpPr txBox="1"/>
            <p:nvPr/>
          </p:nvSpPr>
          <p:spPr>
            <a:xfrm>
              <a:off x="6539717" y="1838686"/>
              <a:ext cx="369332" cy="42172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200" dirty="0"/>
                <a:t>CD4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1CD12FDB-1467-9D0E-6FB5-CF67B26BD279}"/>
                </a:ext>
              </a:extLst>
            </p:cNvPr>
            <p:cNvSpPr txBox="1"/>
            <p:nvPr/>
          </p:nvSpPr>
          <p:spPr>
            <a:xfrm>
              <a:off x="6983370" y="2562930"/>
              <a:ext cx="6625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D-1</a:t>
              </a:r>
            </a:p>
          </p:txBody>
        </p:sp>
        <p:pic>
          <p:nvPicPr>
            <p:cNvPr id="144" name="Picture 143">
              <a:extLst>
                <a:ext uri="{FF2B5EF4-FFF2-40B4-BE49-F238E27FC236}">
                  <a16:creationId xmlns:a16="http://schemas.microsoft.com/office/drawing/2014/main" id="{8D52AAE2-F035-572D-8CBD-DDADBCF6F8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0918" b="8770"/>
            <a:stretch/>
          </p:blipFill>
          <p:spPr>
            <a:xfrm>
              <a:off x="6802434" y="1573801"/>
              <a:ext cx="914400" cy="936455"/>
            </a:xfrm>
            <a:prstGeom prst="rect">
              <a:avLst/>
            </a:prstGeom>
          </p:spPr>
        </p:pic>
      </p:grpSp>
      <p:sp>
        <p:nvSpPr>
          <p:cNvPr id="153" name="Arrow: Right 152">
            <a:extLst>
              <a:ext uri="{FF2B5EF4-FFF2-40B4-BE49-F238E27FC236}">
                <a16:creationId xmlns:a16="http://schemas.microsoft.com/office/drawing/2014/main" id="{35EBBDE3-79B2-95C4-95C1-62850F94C649}"/>
              </a:ext>
            </a:extLst>
          </p:cNvPr>
          <p:cNvSpPr/>
          <p:nvPr/>
        </p:nvSpPr>
        <p:spPr>
          <a:xfrm>
            <a:off x="5062135" y="1382201"/>
            <a:ext cx="353944" cy="16811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Arrow: Right 157">
            <a:extLst>
              <a:ext uri="{FF2B5EF4-FFF2-40B4-BE49-F238E27FC236}">
                <a16:creationId xmlns:a16="http://schemas.microsoft.com/office/drawing/2014/main" id="{596DDD98-CB1F-451E-7DF3-FF307EC29009}"/>
              </a:ext>
            </a:extLst>
          </p:cNvPr>
          <p:cNvSpPr/>
          <p:nvPr/>
        </p:nvSpPr>
        <p:spPr>
          <a:xfrm rot="7339524">
            <a:off x="3986114" y="1585615"/>
            <a:ext cx="541637" cy="15344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F12224AA-5ABA-5125-AFB3-1AD1AEB3899D}"/>
              </a:ext>
            </a:extLst>
          </p:cNvPr>
          <p:cNvCxnSpPr/>
          <p:nvPr/>
        </p:nvCxnSpPr>
        <p:spPr>
          <a:xfrm flipV="1">
            <a:off x="330666" y="2060446"/>
            <a:ext cx="7229845" cy="205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F82A4B5E-B1B5-CB7F-4FA0-B9E4FA82B638}"/>
              </a:ext>
            </a:extLst>
          </p:cNvPr>
          <p:cNvSpPr txBox="1"/>
          <p:nvPr/>
        </p:nvSpPr>
        <p:spPr>
          <a:xfrm>
            <a:off x="206648" y="3482720"/>
            <a:ext cx="737601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kumimoji="0" lang="en-US" sz="13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300" b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US" sz="13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kumimoji="0" lang="en-US" sz="13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ting strategy for the in vivo study. </a:t>
            </a:r>
          </a:p>
        </p:txBody>
      </p:sp>
    </p:spTree>
    <p:extLst>
      <p:ext uri="{BB962C8B-B14F-4D97-AF65-F5344CB8AC3E}">
        <p14:creationId xmlns:p14="http://schemas.microsoft.com/office/powerpoint/2010/main" val="423450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A467C67-A4D1-4B99-B35A-3FF50EB4F89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739985" y="4804272"/>
          <a:ext cx="1847666" cy="19234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364651" imgH="2453009" progId="Prism9.Document">
                  <p:embed/>
                </p:oleObj>
              </mc:Choice>
              <mc:Fallback>
                <p:oleObj name="Prism 9" r:id="rId2" imgW="2364651" imgH="2453009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A467C67-A4D1-4B99-B35A-3FF50EB4F8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39985" y="4804272"/>
                        <a:ext cx="1847666" cy="19234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3574EE-5B3E-4424-8E92-1A01A6CA3D8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4475" y="4794250"/>
          <a:ext cx="1800308" cy="19334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291544" imgH="2465254" progId="Prism9.Document">
                  <p:embed/>
                </p:oleObj>
              </mc:Choice>
              <mc:Fallback>
                <p:oleObj name="Prism 9" r:id="rId4" imgW="2291544" imgH="2465254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3574EE-5B3E-4424-8E92-1A01A6CA3D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4475" y="4794250"/>
                        <a:ext cx="1800308" cy="19334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1BEC0F9-B935-4DE1-93C0-D856E573465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56344" y="4794250"/>
          <a:ext cx="1790159" cy="19234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291544" imgH="2465254" progId="Prism9.Document">
                  <p:embed/>
                </p:oleObj>
              </mc:Choice>
              <mc:Fallback>
                <p:oleObj name="Prism 9" r:id="rId6" imgW="2291544" imgH="246525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1BEC0F9-B935-4DE1-93C0-D856E57346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56344" y="4794250"/>
                        <a:ext cx="1790159" cy="19234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1841CF4-D4DB-43FE-86C3-43E889AA3AA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15013" y="4804271"/>
          <a:ext cx="1790159" cy="1931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291544" imgH="2465254" progId="Prism9.Document">
                  <p:embed/>
                </p:oleObj>
              </mc:Choice>
              <mc:Fallback>
                <p:oleObj name="Prism 9" r:id="rId8" imgW="2291544" imgH="2465254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1841CF4-D4DB-43FE-86C3-43E889AA3A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15013" y="4804271"/>
                        <a:ext cx="1790159" cy="1931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31A2ED2-FC50-4FC4-958F-19BF61EECDF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4824" y="479373"/>
          <a:ext cx="3374279" cy="2610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189459" imgH="3238505" progId="Prism9.Document">
                  <p:embed/>
                </p:oleObj>
              </mc:Choice>
              <mc:Fallback>
                <p:oleObj name="Prism 9" r:id="rId10" imgW="4189459" imgH="323850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D31A2ED2-FC50-4FC4-958F-19BF61EECD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4824" y="479373"/>
                        <a:ext cx="3374279" cy="26105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BCCC327-1EAC-4A8A-ADC6-338C4790B40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74422" y="796359"/>
          <a:ext cx="1642371" cy="1758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289743" imgH="2453009" progId="Prism9.Document">
                  <p:embed/>
                </p:oleObj>
              </mc:Choice>
              <mc:Fallback>
                <p:oleObj name="Prism 9" r:id="rId12" imgW="2289743" imgH="2453009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BCCC327-1EAC-4A8A-ADC6-338C4790B4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274422" y="796359"/>
                        <a:ext cx="1642371" cy="1758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0F28C889-04A5-423F-ABA4-78E21671EF3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31938" y="3039840"/>
          <a:ext cx="1771858" cy="18393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364651" imgH="2453009" progId="Prism9.Document">
                  <p:embed/>
                </p:oleObj>
              </mc:Choice>
              <mc:Fallback>
                <p:oleObj name="Prism 9" r:id="rId14" imgW="2364651" imgH="2453009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0F28C889-04A5-423F-ABA4-78E21671EF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31938" y="3039840"/>
                        <a:ext cx="1771858" cy="18393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7309CBF-312E-4719-8D5F-6863961262C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1419" y="3021806"/>
          <a:ext cx="1771859" cy="18359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364651" imgH="2453009" progId="Prism9.Document">
                  <p:embed/>
                </p:oleObj>
              </mc:Choice>
              <mc:Fallback>
                <p:oleObj name="Prism 9" r:id="rId16" imgW="2364651" imgH="2453009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7309CBF-312E-4719-8D5F-6863961262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51419" y="3021806"/>
                        <a:ext cx="1771859" cy="18359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B88F9F08-8311-477E-960A-030051FF147B}"/>
              </a:ext>
            </a:extLst>
          </p:cNvPr>
          <p:cNvSpPr txBox="1"/>
          <p:nvPr/>
        </p:nvSpPr>
        <p:spPr>
          <a:xfrm>
            <a:off x="29914" y="2900353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0FA955-06C3-4075-8145-6611DE3CFA49}"/>
              </a:ext>
            </a:extLst>
          </p:cNvPr>
          <p:cNvSpPr txBox="1"/>
          <p:nvPr/>
        </p:nvSpPr>
        <p:spPr>
          <a:xfrm>
            <a:off x="29914" y="30192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221F5DC-AC97-468B-943B-A9B549D947BF}"/>
              </a:ext>
            </a:extLst>
          </p:cNvPr>
          <p:cNvSpPr txBox="1"/>
          <p:nvPr/>
        </p:nvSpPr>
        <p:spPr>
          <a:xfrm>
            <a:off x="42737" y="473471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D77E35F-376B-49D6-B688-7AF1F88D7288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41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l Figure 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E5C148-BAFD-417D-8C2E-8FABBFBDDA01}"/>
              </a:ext>
            </a:extLst>
          </p:cNvPr>
          <p:cNvSpPr txBox="1"/>
          <p:nvPr/>
        </p:nvSpPr>
        <p:spPr>
          <a:xfrm>
            <a:off x="151419" y="6819494"/>
            <a:ext cx="7376017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3. </a:t>
            </a:r>
            <a:r>
              <a:rPr kumimoji="0" lang="en-US" sz="13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dulates TILs in Lewis cell carcinoma (LLC) model.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LC cells were transplanted into syngeneic recipient mice. Mice were treated with 60 mg/kg </a:t>
            </a:r>
            <a:r>
              <a:rPr kumimoji="0" lang="en-US" sz="13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vehicle control for 10 days (n=10 per group). Mice were sacrificed on day 21 after tumor inoculation; tumors were weighed and analyzed for TILs. </a:t>
            </a:r>
            <a:r>
              <a:rPr kumimoji="0" lang="en-US" sz="13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umor growth curve (left) and tumor weights at the end of the experiment (right) are shown; </a:t>
            </a:r>
            <a:r>
              <a:rPr kumimoji="0" lang="en-US" sz="13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filtrating CD4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8</a:t>
            </a:r>
            <a:r>
              <a:rPr kumimoji="0" lang="en-US" sz="13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ILs as well as </a:t>
            </a:r>
            <a:r>
              <a:rPr kumimoji="0" lang="en-US" sz="13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r>
              <a:rPr kumimoji="0" 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TLA-4 and PD-1 expression were quantified by flow cytometry. Data are mean ± SD. One-way ANOVA was performed for statistical analysis, *p&lt;0.05, **p&lt;0.01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30292857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92D3FE-5FC3-46E6-9148-B97684BEF13E}"/>
              </a:ext>
            </a:extLst>
          </p:cNvPr>
          <p:cNvSpPr txBox="1"/>
          <p:nvPr/>
        </p:nvSpPr>
        <p:spPr>
          <a:xfrm>
            <a:off x="57290" y="31757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8C93207-DCEC-4F78-BA14-AE3762FB43E4}"/>
              </a:ext>
            </a:extLst>
          </p:cNvPr>
          <p:cNvSpPr txBox="1"/>
          <p:nvPr/>
        </p:nvSpPr>
        <p:spPr>
          <a:xfrm>
            <a:off x="1606783" y="32074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7D2FD5-4CF7-4BF9-A909-8887CF8E2F0A}"/>
              </a:ext>
            </a:extLst>
          </p:cNvPr>
          <p:cNvSpPr txBox="1"/>
          <p:nvPr/>
        </p:nvSpPr>
        <p:spPr>
          <a:xfrm>
            <a:off x="57290" y="352037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C6A2577-9B36-4F0E-9F01-6C20FA85CAEE}"/>
              </a:ext>
            </a:extLst>
          </p:cNvPr>
          <p:cNvSpPr txBox="1"/>
          <p:nvPr/>
        </p:nvSpPr>
        <p:spPr>
          <a:xfrm>
            <a:off x="1526321" y="3503913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95DFC354-E59E-471F-9056-966A176F4D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0834060"/>
              </p:ext>
            </p:extLst>
          </p:nvPr>
        </p:nvGraphicFramePr>
        <p:xfrm>
          <a:off x="3613777" y="2097788"/>
          <a:ext cx="2256873" cy="16490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381674" imgH="2704757" progId="Prism9.Document">
                  <p:embed/>
                </p:oleObj>
              </mc:Choice>
              <mc:Fallback>
                <p:oleObj name="Prism 9" r:id="rId2" imgW="3381674" imgH="2704757" progId="Prism9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95DFC354-E59E-471F-9056-966A176F4D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13777" y="2097788"/>
                        <a:ext cx="2256873" cy="16490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2E18DD31-C4D0-448F-BEF5-B8EE212BFC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5841560"/>
              </p:ext>
            </p:extLst>
          </p:nvPr>
        </p:nvGraphicFramePr>
        <p:xfrm>
          <a:off x="1725278" y="2076074"/>
          <a:ext cx="2192403" cy="1695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172796" imgH="2704757" progId="Prism9.Document">
                  <p:embed/>
                </p:oleObj>
              </mc:Choice>
              <mc:Fallback>
                <p:oleObj name="Prism 9" r:id="rId4" imgW="3172796" imgH="2704757" progId="Prism9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2E18DD31-C4D0-448F-BEF5-B8EE212BFC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25278" y="2076074"/>
                        <a:ext cx="2192403" cy="1695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5B076780-BBB8-4927-9676-EE2C7CE190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5479822"/>
              </p:ext>
            </p:extLst>
          </p:nvPr>
        </p:nvGraphicFramePr>
        <p:xfrm>
          <a:off x="0" y="615739"/>
          <a:ext cx="1683576" cy="14328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198268" imgH="2447247" progId="Prism9.Document">
                  <p:embed/>
                </p:oleObj>
              </mc:Choice>
              <mc:Fallback>
                <p:oleObj name="Prism 9" r:id="rId6" imgW="2198268" imgH="2447247" progId="Prism9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5B076780-BBB8-4927-9676-EE2C7CE190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615739"/>
                        <a:ext cx="1683576" cy="14328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69DF10B7-83DC-4E9F-8834-5F68BE93B5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9826517"/>
              </p:ext>
            </p:extLst>
          </p:nvPr>
        </p:nvGraphicFramePr>
        <p:xfrm>
          <a:off x="1786744" y="305903"/>
          <a:ext cx="2069646" cy="18756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088884" imgH="3082919" progId="Prism9.Document">
                  <p:embed/>
                </p:oleObj>
              </mc:Choice>
              <mc:Fallback>
                <p:oleObj name="Prism 9" r:id="rId8" imgW="3088884" imgH="3082919" progId="Prism9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69DF10B7-83DC-4E9F-8834-5F68BE93B5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786744" y="305903"/>
                        <a:ext cx="2069646" cy="18756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B8E74813-0D47-49C1-AB40-F6FAF670D6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7594749"/>
              </p:ext>
            </p:extLst>
          </p:nvPr>
        </p:nvGraphicFramePr>
        <p:xfrm>
          <a:off x="3681239" y="434379"/>
          <a:ext cx="2055147" cy="17155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168114" imgH="2918328" progId="Prism9.Document">
                  <p:embed/>
                </p:oleObj>
              </mc:Choice>
              <mc:Fallback>
                <p:oleObj name="Prism 9" r:id="rId10" imgW="3168114" imgH="2918328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B8E74813-0D47-49C1-AB40-F6FAF670D6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81239" y="434379"/>
                        <a:ext cx="2055147" cy="17155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912E3001-D456-416F-948B-F986995698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2706567"/>
              </p:ext>
            </p:extLst>
          </p:nvPr>
        </p:nvGraphicFramePr>
        <p:xfrm>
          <a:off x="3228474" y="3761796"/>
          <a:ext cx="1871928" cy="18780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442440" imgH="2453009" progId="Prism9.Document">
                  <p:embed/>
                </p:oleObj>
              </mc:Choice>
              <mc:Fallback>
                <p:oleObj name="Prism 9" r:id="rId12" imgW="2442440" imgH="2453009" progId="Prism9.Document">
                  <p:embed/>
                  <p:pic>
                    <p:nvPicPr>
                      <p:cNvPr id="64" name="Object 63">
                        <a:extLst>
                          <a:ext uri="{FF2B5EF4-FFF2-40B4-BE49-F238E27FC236}">
                            <a16:creationId xmlns:a16="http://schemas.microsoft.com/office/drawing/2014/main" id="{912E3001-D456-416F-948B-F986995698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228474" y="3761796"/>
                        <a:ext cx="1871928" cy="18780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" name="Object 65">
            <a:extLst>
              <a:ext uri="{FF2B5EF4-FFF2-40B4-BE49-F238E27FC236}">
                <a16:creationId xmlns:a16="http://schemas.microsoft.com/office/drawing/2014/main" id="{2E65BE6B-D487-44A9-83B8-51440E3A85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849484"/>
              </p:ext>
            </p:extLst>
          </p:nvPr>
        </p:nvGraphicFramePr>
        <p:xfrm>
          <a:off x="1810606" y="5581331"/>
          <a:ext cx="1797358" cy="18026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447122" imgH="2453009" progId="Prism9.Document">
                  <p:embed/>
                </p:oleObj>
              </mc:Choice>
              <mc:Fallback>
                <p:oleObj name="Prism 9" r:id="rId14" imgW="2447122" imgH="2453009" progId="Prism9.Document">
                  <p:embed/>
                  <p:pic>
                    <p:nvPicPr>
                      <p:cNvPr id="66" name="Object 65">
                        <a:extLst>
                          <a:ext uri="{FF2B5EF4-FFF2-40B4-BE49-F238E27FC236}">
                            <a16:creationId xmlns:a16="http://schemas.microsoft.com/office/drawing/2014/main" id="{2E65BE6B-D487-44A9-83B8-51440E3A85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10606" y="5581331"/>
                        <a:ext cx="1797358" cy="18026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Object 66">
            <a:extLst>
              <a:ext uri="{FF2B5EF4-FFF2-40B4-BE49-F238E27FC236}">
                <a16:creationId xmlns:a16="http://schemas.microsoft.com/office/drawing/2014/main" id="{BB6B6946-5AAE-4FEA-BCCD-DD70F96384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5940844"/>
              </p:ext>
            </p:extLst>
          </p:nvPr>
        </p:nvGraphicFramePr>
        <p:xfrm>
          <a:off x="4703214" y="3813333"/>
          <a:ext cx="1779610" cy="17847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442440" imgH="2453009" progId="Prism9.Document">
                  <p:embed/>
                </p:oleObj>
              </mc:Choice>
              <mc:Fallback>
                <p:oleObj name="Prism 9" r:id="rId16" imgW="2442440" imgH="2453009" progId="Prism9.Document">
                  <p:embed/>
                  <p:pic>
                    <p:nvPicPr>
                      <p:cNvPr id="67" name="Object 66">
                        <a:extLst>
                          <a:ext uri="{FF2B5EF4-FFF2-40B4-BE49-F238E27FC236}">
                            <a16:creationId xmlns:a16="http://schemas.microsoft.com/office/drawing/2014/main" id="{BB6B6946-5AAE-4FEA-BCCD-DD70F96384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703214" y="3813333"/>
                        <a:ext cx="1779610" cy="17847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" name="Object 71">
            <a:extLst>
              <a:ext uri="{FF2B5EF4-FFF2-40B4-BE49-F238E27FC236}">
                <a16:creationId xmlns:a16="http://schemas.microsoft.com/office/drawing/2014/main" id="{FF24FD8F-264B-4D80-9678-92EBF9ECEB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8275260"/>
              </p:ext>
            </p:extLst>
          </p:nvPr>
        </p:nvGraphicFramePr>
        <p:xfrm>
          <a:off x="4585829" y="5581331"/>
          <a:ext cx="1897403" cy="17501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2655641" imgH="2453009" progId="Prism9.Document">
                  <p:embed/>
                </p:oleObj>
              </mc:Choice>
              <mc:Fallback>
                <p:oleObj name="Prism 9" r:id="rId18" imgW="2655641" imgH="2453009" progId="Prism9.Document">
                  <p:embed/>
                  <p:pic>
                    <p:nvPicPr>
                      <p:cNvPr id="72" name="Object 71">
                        <a:extLst>
                          <a:ext uri="{FF2B5EF4-FFF2-40B4-BE49-F238E27FC236}">
                            <a16:creationId xmlns:a16="http://schemas.microsoft.com/office/drawing/2014/main" id="{FF24FD8F-264B-4D80-9678-92EBF9ECEB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585829" y="5581331"/>
                        <a:ext cx="1897403" cy="17501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3" name="Object 72">
            <a:extLst>
              <a:ext uri="{FF2B5EF4-FFF2-40B4-BE49-F238E27FC236}">
                <a16:creationId xmlns:a16="http://schemas.microsoft.com/office/drawing/2014/main" id="{C82A1EC4-8D6E-472E-B4BE-C3EC9692D0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891231"/>
              </p:ext>
            </p:extLst>
          </p:nvPr>
        </p:nvGraphicFramePr>
        <p:xfrm>
          <a:off x="3289979" y="5581331"/>
          <a:ext cx="1779609" cy="17856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2447122" imgH="2453009" progId="Prism9.Document">
                  <p:embed/>
                </p:oleObj>
              </mc:Choice>
              <mc:Fallback>
                <p:oleObj name="Prism 9" r:id="rId20" imgW="2447122" imgH="2453009" progId="Prism9.Document">
                  <p:embed/>
                  <p:pic>
                    <p:nvPicPr>
                      <p:cNvPr id="73" name="Object 72">
                        <a:extLst>
                          <a:ext uri="{FF2B5EF4-FFF2-40B4-BE49-F238E27FC236}">
                            <a16:creationId xmlns:a16="http://schemas.microsoft.com/office/drawing/2014/main" id="{C82A1EC4-8D6E-472E-B4BE-C3EC9692D0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289979" y="5581331"/>
                        <a:ext cx="1779609" cy="17856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4" name="Object 73">
            <a:extLst>
              <a:ext uri="{FF2B5EF4-FFF2-40B4-BE49-F238E27FC236}">
                <a16:creationId xmlns:a16="http://schemas.microsoft.com/office/drawing/2014/main" id="{4193EDB6-61BE-4CA2-B111-D0045998C6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1494529"/>
              </p:ext>
            </p:extLst>
          </p:nvPr>
        </p:nvGraphicFramePr>
        <p:xfrm>
          <a:off x="21469" y="3802778"/>
          <a:ext cx="1825889" cy="18972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2364651" imgH="2453009" progId="Prism9.Document">
                  <p:embed/>
                </p:oleObj>
              </mc:Choice>
              <mc:Fallback>
                <p:oleObj name="Prism 9" r:id="rId22" imgW="2364651" imgH="2453009" progId="Prism9.Document">
                  <p:embed/>
                  <p:pic>
                    <p:nvPicPr>
                      <p:cNvPr id="74" name="Object 73">
                        <a:extLst>
                          <a:ext uri="{FF2B5EF4-FFF2-40B4-BE49-F238E27FC236}">
                            <a16:creationId xmlns:a16="http://schemas.microsoft.com/office/drawing/2014/main" id="{4193EDB6-61BE-4CA2-B111-D0045998C6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1469" y="3802778"/>
                        <a:ext cx="1825889" cy="18972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Object 74">
            <a:extLst>
              <a:ext uri="{FF2B5EF4-FFF2-40B4-BE49-F238E27FC236}">
                <a16:creationId xmlns:a16="http://schemas.microsoft.com/office/drawing/2014/main" id="{3513A233-C2C2-4634-BB1C-20ED7349F7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054352"/>
              </p:ext>
            </p:extLst>
          </p:nvPr>
        </p:nvGraphicFramePr>
        <p:xfrm>
          <a:off x="1785852" y="3763408"/>
          <a:ext cx="1871930" cy="1942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2363211" imgH="2453009" progId="Prism9.Document">
                  <p:embed/>
                </p:oleObj>
              </mc:Choice>
              <mc:Fallback>
                <p:oleObj name="Prism 9" r:id="rId24" imgW="2363211" imgH="2453009" progId="Prism9.Document">
                  <p:embed/>
                  <p:pic>
                    <p:nvPicPr>
                      <p:cNvPr id="75" name="Object 74">
                        <a:extLst>
                          <a:ext uri="{FF2B5EF4-FFF2-40B4-BE49-F238E27FC236}">
                            <a16:creationId xmlns:a16="http://schemas.microsoft.com/office/drawing/2014/main" id="{3513A233-C2C2-4634-BB1C-20ED7349F7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785852" y="3763408"/>
                        <a:ext cx="1871930" cy="19423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C00EE059-CA85-4B7E-94AF-28E7E472FC7B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A390ECD-73BB-415B-A26F-5D16F7646606}"/>
              </a:ext>
            </a:extLst>
          </p:cNvPr>
          <p:cNvSpPr txBox="1"/>
          <p:nvPr/>
        </p:nvSpPr>
        <p:spPr>
          <a:xfrm>
            <a:off x="168381" y="7407859"/>
            <a:ext cx="7376017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4. Immune profiles of CD8</a:t>
            </a:r>
            <a:r>
              <a:rPr lang="en-US" sz="13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4</a:t>
            </a:r>
            <a:r>
              <a:rPr lang="en-US" sz="13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ILs in A20 parental or B2M-KO lymphomas. </a:t>
            </a:r>
            <a:r>
              <a:rPr lang="en-US" sz="13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-B)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20 lymphoma cells were transplanted into syngeneic recipient mice. Mice were treated with 60 mg/kg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vehicle control for 10 days with or without an anti-CD8 antibody (250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g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.p.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n days 4, 6, 8, and 10 after tumor inoculation). Tumors were measured at the end of the experiment and used for TIL analysis. </a:t>
            </a:r>
            <a:r>
              <a:rPr lang="en-US" sz="13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-D)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20 </a:t>
            </a:r>
            <a:r>
              <a:rPr lang="en-US" sz="13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2M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mice were treated with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vehicle control. Immune profiles of tumor-infiltrating T cells are shown. Data are mean ± SD.</a:t>
            </a:r>
          </a:p>
        </p:txBody>
      </p:sp>
    </p:spTree>
    <p:extLst>
      <p:ext uri="{BB962C8B-B14F-4D97-AF65-F5344CB8AC3E}">
        <p14:creationId xmlns:p14="http://schemas.microsoft.com/office/powerpoint/2010/main" val="497691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11FF204B-78D0-4D9B-9514-AE29FE63F2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8746449"/>
              </p:ext>
            </p:extLst>
          </p:nvPr>
        </p:nvGraphicFramePr>
        <p:xfrm>
          <a:off x="3788571" y="577850"/>
          <a:ext cx="2070100" cy="1716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279396" imgH="2717002" progId="Prism9.Document">
                  <p:embed/>
                </p:oleObj>
              </mc:Choice>
              <mc:Fallback>
                <p:oleObj name="Prism 9" r:id="rId2" imgW="3279396" imgH="2717002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11FF204B-78D0-4D9B-9514-AE29FE63F2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88571" y="577850"/>
                        <a:ext cx="2070100" cy="1716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9F3BC26D-378B-4B27-889C-556C86F7BB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5785863"/>
              </p:ext>
            </p:extLst>
          </p:nvPr>
        </p:nvGraphicFramePr>
        <p:xfrm>
          <a:off x="2123282" y="563563"/>
          <a:ext cx="2025650" cy="171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206288" imgH="2710879" progId="Prism9.Document">
                  <p:embed/>
                </p:oleObj>
              </mc:Choice>
              <mc:Fallback>
                <p:oleObj name="Prism 9" r:id="rId4" imgW="3206288" imgH="2710879" progId="Prism9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9F3BC26D-378B-4B27-889C-556C86F7BB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23282" y="563563"/>
                        <a:ext cx="2025650" cy="171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09951063-4CF0-48A1-A1C0-4AE2EB67A4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8312233"/>
              </p:ext>
            </p:extLst>
          </p:nvPr>
        </p:nvGraphicFramePr>
        <p:xfrm>
          <a:off x="434975" y="579438"/>
          <a:ext cx="2022475" cy="1716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206288" imgH="2717002" progId="Prism9.Document">
                  <p:embed/>
                </p:oleObj>
              </mc:Choice>
              <mc:Fallback>
                <p:oleObj name="Prism 9" r:id="rId6" imgW="3206288" imgH="2717002" progId="Prism9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09951063-4CF0-48A1-A1C0-4AE2EB67A4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4975" y="579438"/>
                        <a:ext cx="2022475" cy="1716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>
            <a:extLst>
              <a:ext uri="{FF2B5EF4-FFF2-40B4-BE49-F238E27FC236}">
                <a16:creationId xmlns:a16="http://schemas.microsoft.com/office/drawing/2014/main" id="{E0C506BE-B521-4167-B19C-30DDB26DF376}"/>
              </a:ext>
            </a:extLst>
          </p:cNvPr>
          <p:cNvSpPr txBox="1"/>
          <p:nvPr/>
        </p:nvSpPr>
        <p:spPr>
          <a:xfrm>
            <a:off x="133778" y="415616"/>
            <a:ext cx="29046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A</a:t>
            </a:r>
          </a:p>
        </p:txBody>
      </p:sp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115658CD-D795-4627-8238-34449C0582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9518641"/>
              </p:ext>
            </p:extLst>
          </p:nvPr>
        </p:nvGraphicFramePr>
        <p:xfrm>
          <a:off x="3886200" y="4082653"/>
          <a:ext cx="2203450" cy="171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488275" imgH="2717002" progId="Prism9.Document">
                  <p:embed/>
                </p:oleObj>
              </mc:Choice>
              <mc:Fallback>
                <p:oleObj name="Prism 9" r:id="rId8" imgW="3488275" imgH="2717002" progId="Prism9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115658CD-D795-4627-8238-34449C0582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86200" y="4082653"/>
                        <a:ext cx="2203450" cy="171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1E05BC2F-2975-4B35-8D81-5E6EF84E1B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8043971"/>
              </p:ext>
            </p:extLst>
          </p:nvPr>
        </p:nvGraphicFramePr>
        <p:xfrm>
          <a:off x="2123282" y="4104880"/>
          <a:ext cx="2073275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279396" imgH="2717002" progId="Prism9.Document">
                  <p:embed/>
                </p:oleObj>
              </mc:Choice>
              <mc:Fallback>
                <p:oleObj name="Prism 9" r:id="rId10" imgW="3279396" imgH="2717002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1E05BC2F-2975-4B35-8D81-5E6EF84E1B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23282" y="4104880"/>
                        <a:ext cx="2073275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C25F6FC6-DAA6-4CF9-8047-9D0926BC68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5084952"/>
              </p:ext>
            </p:extLst>
          </p:nvPr>
        </p:nvGraphicFramePr>
        <p:xfrm>
          <a:off x="479425" y="4146550"/>
          <a:ext cx="2022475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206288" imgH="2717002" progId="Prism9.Document">
                  <p:embed/>
                </p:oleObj>
              </mc:Choice>
              <mc:Fallback>
                <p:oleObj name="Prism 9" r:id="rId12" imgW="3206288" imgH="2717002" progId="Prism9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C25F6FC6-DAA6-4CF9-8047-9D0926BC68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79425" y="4146550"/>
                        <a:ext cx="2022475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395755FF-C8E6-4CBD-A7A9-149966DCDE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4500582"/>
              </p:ext>
            </p:extLst>
          </p:nvPr>
        </p:nvGraphicFramePr>
        <p:xfrm>
          <a:off x="2083104" y="2377282"/>
          <a:ext cx="2022475" cy="1712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201606" imgH="2717002" progId="Prism9.Document">
                  <p:embed/>
                </p:oleObj>
              </mc:Choice>
              <mc:Fallback>
                <p:oleObj name="Prism 9" r:id="rId14" imgW="3201606" imgH="2717002" progId="Prism9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395755FF-C8E6-4CBD-A7A9-149966DCDE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083104" y="2377282"/>
                        <a:ext cx="2022475" cy="1712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89843183-4DFB-409F-9503-5479E2D2BE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3305288"/>
              </p:ext>
            </p:extLst>
          </p:nvPr>
        </p:nvGraphicFramePr>
        <p:xfrm>
          <a:off x="434975" y="2370138"/>
          <a:ext cx="2024063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206288" imgH="2717002" progId="Prism9.Document">
                  <p:embed/>
                </p:oleObj>
              </mc:Choice>
              <mc:Fallback>
                <p:oleObj name="Prism 9" r:id="rId16" imgW="3206288" imgH="2717002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89843183-4DFB-409F-9503-5479E2D2BE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34975" y="2370138"/>
                        <a:ext cx="2024063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1BC3BC51-E3F7-4146-AC45-59BCC95BFE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5180323"/>
              </p:ext>
            </p:extLst>
          </p:nvPr>
        </p:nvGraphicFramePr>
        <p:xfrm>
          <a:off x="3778858" y="2362596"/>
          <a:ext cx="1974850" cy="171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3128499" imgH="2717002" progId="Prism9.Document">
                  <p:embed/>
                </p:oleObj>
              </mc:Choice>
              <mc:Fallback>
                <p:oleObj name="Prism 9" r:id="rId18" imgW="3128499" imgH="2717002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1BC3BC51-E3F7-4146-AC45-59BCC95BFE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778858" y="2362596"/>
                        <a:ext cx="1974850" cy="171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92C9169B-7417-41CB-AE5A-25EADFC607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1422375"/>
              </p:ext>
            </p:extLst>
          </p:nvPr>
        </p:nvGraphicFramePr>
        <p:xfrm>
          <a:off x="5368925" y="2338587"/>
          <a:ext cx="1968500" cy="1712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3123817" imgH="2717002" progId="Prism9.Document">
                  <p:embed/>
                </p:oleObj>
              </mc:Choice>
              <mc:Fallback>
                <p:oleObj name="Prism 9" r:id="rId20" imgW="3123817" imgH="2717002" progId="Prism9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92C9169B-7417-41CB-AE5A-25EADFC607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368925" y="2338587"/>
                        <a:ext cx="1968500" cy="1712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TextBox 46">
            <a:extLst>
              <a:ext uri="{FF2B5EF4-FFF2-40B4-BE49-F238E27FC236}">
                <a16:creationId xmlns:a16="http://schemas.microsoft.com/office/drawing/2014/main" id="{C3AE67D7-1175-4132-82A0-EA4678036CE4}"/>
              </a:ext>
            </a:extLst>
          </p:cNvPr>
          <p:cNvSpPr txBox="1"/>
          <p:nvPr/>
        </p:nvSpPr>
        <p:spPr>
          <a:xfrm>
            <a:off x="133779" y="2466861"/>
            <a:ext cx="28245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25A253-389C-438C-AA74-186FDF2224E5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9CEF534-7E36-490B-A150-3A345DD375D0}"/>
              </a:ext>
            </a:extLst>
          </p:cNvPr>
          <p:cNvSpPr txBox="1"/>
          <p:nvPr/>
        </p:nvSpPr>
        <p:spPr>
          <a:xfrm>
            <a:off x="100562" y="5875736"/>
            <a:ext cx="7376017" cy="1092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5. Therapeutic effect of </a:t>
            </a:r>
            <a:r>
              <a:rPr lang="en-US" sz="13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 not through neddylation pathway of A20 cells. 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0 </a:t>
            </a:r>
            <a:r>
              <a:rPr lang="en-US" sz="13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E2M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knockdown lymphoma cells or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trl cells were transplanted into syngeneic recipient mice, and tumor-bearing mice were treated with vehicle control or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60 mg/kg for 10 days. Immune profiles of TILs are shown. Data are mean ± SD, *p&lt;0.05, **p&lt;0.01.</a:t>
            </a:r>
          </a:p>
        </p:txBody>
      </p:sp>
    </p:spTree>
    <p:extLst>
      <p:ext uri="{BB962C8B-B14F-4D97-AF65-F5344CB8AC3E}">
        <p14:creationId xmlns:p14="http://schemas.microsoft.com/office/powerpoint/2010/main" val="7018309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17BC063D-0BFD-4A7E-8F34-32A48B9BE35B}"/>
              </a:ext>
            </a:extLst>
          </p:cNvPr>
          <p:cNvGrpSpPr/>
          <p:nvPr/>
        </p:nvGrpSpPr>
        <p:grpSpPr>
          <a:xfrm>
            <a:off x="436545" y="878456"/>
            <a:ext cx="4194298" cy="2244683"/>
            <a:chOff x="833496" y="3585074"/>
            <a:chExt cx="3700851" cy="198060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FDF5183-EF19-4D7D-B012-7AFAFAB3D5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62008" y="4651277"/>
              <a:ext cx="928510" cy="9144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3597F8D-D4DD-463A-B027-F79554FA02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05836" y="4646836"/>
              <a:ext cx="928510" cy="9144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69B1D7FA-B98F-4FDC-944D-8E2C3A1E451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34319" y="4636111"/>
              <a:ext cx="928510" cy="9144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CCAB823D-38E7-465E-B5D8-DD9A9DCD9C1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20549" y="4618966"/>
              <a:ext cx="928510" cy="9144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5C63290-8F03-4D7C-8AD6-47E2B9C3AFF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00806" y="3631879"/>
              <a:ext cx="928510" cy="9144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E006C1C-FF58-4B07-A241-74D524D39F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05837" y="3585074"/>
              <a:ext cx="928510" cy="91440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185B5AAD-8D86-402F-8EBB-1AD94DAD2E9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33496" y="3646827"/>
              <a:ext cx="928510" cy="91440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A138009-B854-46E3-80D1-92C7CC655BF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77325" y="3636855"/>
              <a:ext cx="928510" cy="9144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31DC0BB-91A9-4001-862A-7E32E86F8844}"/>
                </a:ext>
              </a:extLst>
            </p:cNvPr>
            <p:cNvSpPr txBox="1"/>
            <p:nvPr/>
          </p:nvSpPr>
          <p:spPr>
            <a:xfrm>
              <a:off x="1948583" y="4404742"/>
              <a:ext cx="486842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IFN-</a:t>
              </a:r>
              <a:r>
                <a:rPr lang="el-GR" sz="1360" dirty="0"/>
                <a:t>γ</a:t>
              </a:r>
              <a:endParaRPr lang="en-US" sz="1360" dirty="0"/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890661FD-EED0-4034-801D-69F3A6EB1DBE}"/>
                </a:ext>
              </a:extLst>
            </p:cNvPr>
            <p:cNvCxnSpPr/>
            <p:nvPr/>
          </p:nvCxnSpPr>
          <p:spPr>
            <a:xfrm>
              <a:off x="1024185" y="4543239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88FD562A-ABBD-4929-B689-0E8B79A4ED7A}"/>
                </a:ext>
              </a:extLst>
            </p:cNvPr>
            <p:cNvCxnSpPr/>
            <p:nvPr/>
          </p:nvCxnSpPr>
          <p:spPr>
            <a:xfrm>
              <a:off x="1015877" y="5561236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7073175A-3191-4E70-A702-141E052D174A}"/>
              </a:ext>
            </a:extLst>
          </p:cNvPr>
          <p:cNvSpPr txBox="1"/>
          <p:nvPr/>
        </p:nvSpPr>
        <p:spPr>
          <a:xfrm>
            <a:off x="44528" y="360083"/>
            <a:ext cx="720518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 err="1"/>
              <a:t>Sh</a:t>
            </a:r>
            <a:r>
              <a:rPr lang="en-US" sz="1360" dirty="0"/>
              <a:t> </a:t>
            </a:r>
            <a:r>
              <a:rPr lang="en-US" sz="1360" i="1" dirty="0"/>
              <a:t>HIF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3C8930-7D20-46E1-9176-6A6DF9819E05}"/>
              </a:ext>
            </a:extLst>
          </p:cNvPr>
          <p:cNvSpPr txBox="1"/>
          <p:nvPr/>
        </p:nvSpPr>
        <p:spPr>
          <a:xfrm>
            <a:off x="184231" y="611187"/>
            <a:ext cx="52501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 err="1"/>
              <a:t>Pevo</a:t>
            </a:r>
            <a:endParaRPr lang="en-US" sz="136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D3A82E-21B9-411E-A99D-8DB2D27138A7}"/>
              </a:ext>
            </a:extLst>
          </p:cNvPr>
          <p:cNvSpPr txBox="1"/>
          <p:nvPr/>
        </p:nvSpPr>
        <p:spPr>
          <a:xfrm>
            <a:off x="594815" y="353070"/>
            <a:ext cx="4011127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dirty="0"/>
              <a:t>      -                          -                          +                          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6CF70B-2A59-4EE6-A0EB-71E145393A77}"/>
              </a:ext>
            </a:extLst>
          </p:cNvPr>
          <p:cNvSpPr txBox="1"/>
          <p:nvPr/>
        </p:nvSpPr>
        <p:spPr>
          <a:xfrm>
            <a:off x="597526" y="605100"/>
            <a:ext cx="4011127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dirty="0"/>
              <a:t>      -                          +                          -                          +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3811B36-F99E-4428-8C2C-FDA4CDA48DE5}"/>
              </a:ext>
            </a:extLst>
          </p:cNvPr>
          <p:cNvCxnSpPr>
            <a:cxnSpLocks/>
          </p:cNvCxnSpPr>
          <p:nvPr/>
        </p:nvCxnSpPr>
        <p:spPr>
          <a:xfrm flipV="1">
            <a:off x="370091" y="3297520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6F9438C-857E-4D14-A612-2FFAE24E42EA}"/>
              </a:ext>
            </a:extLst>
          </p:cNvPr>
          <p:cNvSpPr txBox="1"/>
          <p:nvPr/>
        </p:nvSpPr>
        <p:spPr>
          <a:xfrm rot="16200000">
            <a:off x="133491" y="2842109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4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9264A89-7982-403F-AAC3-A855868AFD65}"/>
              </a:ext>
            </a:extLst>
          </p:cNvPr>
          <p:cNvGrpSpPr/>
          <p:nvPr/>
        </p:nvGrpSpPr>
        <p:grpSpPr>
          <a:xfrm>
            <a:off x="436545" y="3280110"/>
            <a:ext cx="4219971" cy="2243648"/>
            <a:chOff x="819565" y="1717079"/>
            <a:chExt cx="3723504" cy="197968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22A16E7-5545-4BFC-BF34-FDA8CEBF9FA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19565" y="1717079"/>
              <a:ext cx="928510" cy="9144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D6FA522-84F0-436E-A7BC-2BBB515AED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686051" y="1735851"/>
              <a:ext cx="928510" cy="9144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308824F-C694-4B95-82B9-FD54509BD5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752806" y="1728139"/>
              <a:ext cx="928510" cy="9144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2E1A9C0-A9E9-4EFD-B8E4-D34F9D1AED9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614559" y="1743563"/>
              <a:ext cx="928510" cy="9144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439BC41-30CB-41CA-9A6B-AAA9D3A3B7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735880" y="2700262"/>
              <a:ext cx="928510" cy="9144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2A001CBE-7DC9-475C-8CE9-3CFF281038C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833496" y="2700262"/>
              <a:ext cx="928510" cy="9144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584E74E-0D06-42C3-8DF7-BD405E59FB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686469" y="2688982"/>
              <a:ext cx="928510" cy="9144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E149FCD-B584-4C84-8B5B-49E673EACDE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614559" y="2688982"/>
              <a:ext cx="928510" cy="91440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9DFF4F9-A1A3-4243-8575-A45362079E1F}"/>
                </a:ext>
              </a:extLst>
            </p:cNvPr>
            <p:cNvSpPr txBox="1"/>
            <p:nvPr/>
          </p:nvSpPr>
          <p:spPr>
            <a:xfrm>
              <a:off x="1955043" y="2475777"/>
              <a:ext cx="599316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CTLA-4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2580B921-F605-4495-A178-FF646BF2C7FD}"/>
                </a:ext>
              </a:extLst>
            </p:cNvPr>
            <p:cNvCxnSpPr/>
            <p:nvPr/>
          </p:nvCxnSpPr>
          <p:spPr>
            <a:xfrm>
              <a:off x="1015877" y="2581826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39920E8-5A91-4064-B085-5CF29003D8F6}"/>
                </a:ext>
              </a:extLst>
            </p:cNvPr>
            <p:cNvSpPr txBox="1"/>
            <p:nvPr/>
          </p:nvSpPr>
          <p:spPr>
            <a:xfrm>
              <a:off x="1946091" y="3430632"/>
              <a:ext cx="461382" cy="266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60" dirty="0"/>
                <a:t>PD-1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B9EF4C8-ADAD-4070-A932-1E4888F3ABF1}"/>
                </a:ext>
              </a:extLst>
            </p:cNvPr>
            <p:cNvCxnSpPr/>
            <p:nvPr/>
          </p:nvCxnSpPr>
          <p:spPr>
            <a:xfrm>
              <a:off x="1006924" y="3568582"/>
              <a:ext cx="93085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D37C4E89-9E6E-46EA-9A52-A5744F12850D}"/>
              </a:ext>
            </a:extLst>
          </p:cNvPr>
          <p:cNvSpPr txBox="1"/>
          <p:nvPr/>
        </p:nvSpPr>
        <p:spPr>
          <a:xfrm>
            <a:off x="1689806" y="2964023"/>
            <a:ext cx="614271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TNF-</a:t>
            </a:r>
            <a:r>
              <a:rPr lang="el-GR" sz="1360" dirty="0"/>
              <a:t>α</a:t>
            </a:r>
            <a:endParaRPr lang="en-US" sz="136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452BCC9-1C5A-4F1A-AC22-5363C09918CE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6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5C40FAE8-548F-43A7-9B80-6544AB0FA2D9}"/>
              </a:ext>
            </a:extLst>
          </p:cNvPr>
          <p:cNvCxnSpPr>
            <a:cxnSpLocks/>
          </p:cNvCxnSpPr>
          <p:nvPr/>
        </p:nvCxnSpPr>
        <p:spPr>
          <a:xfrm flipV="1">
            <a:off x="206995" y="7898176"/>
            <a:ext cx="0" cy="7686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A396B875-A62D-41FC-8C42-4D7F930BA48C}"/>
              </a:ext>
            </a:extLst>
          </p:cNvPr>
          <p:cNvSpPr txBox="1"/>
          <p:nvPr/>
        </p:nvSpPr>
        <p:spPr>
          <a:xfrm rot="16200000">
            <a:off x="-29607" y="7503016"/>
            <a:ext cx="47320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D8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FF7B6424-DC98-4646-8E75-B0F4E34DC71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99260" y="7747052"/>
            <a:ext cx="1052311" cy="103632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154C6D7F-FB1F-46E5-B573-7A1446DD7FD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417224" y="7751357"/>
            <a:ext cx="1052311" cy="103632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07AA1C5C-2767-46F9-93B1-D74918441CF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7836" y="7764846"/>
            <a:ext cx="1052311" cy="103632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4515F119-54AF-4805-815E-51C82AFF9D76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526218" y="7744531"/>
            <a:ext cx="1052311" cy="103632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E726A3F-9232-4532-917A-E4E1B846B5C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417224" y="8861788"/>
            <a:ext cx="1052311" cy="103632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597135DA-68CB-49A3-BE1F-939DACF2B3E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7836" y="8874347"/>
            <a:ext cx="1052311" cy="103632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F5C08B0E-52C1-47FA-BDE1-13D5F47C6C13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99260" y="8879732"/>
            <a:ext cx="1052311" cy="103632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73B9B56B-54D3-4398-9C53-39952661F645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526218" y="8879732"/>
            <a:ext cx="1052311" cy="103632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8E4963FB-6644-48B4-96EF-7D8227DEA3D7}"/>
              </a:ext>
            </a:extLst>
          </p:cNvPr>
          <p:cNvSpPr txBox="1"/>
          <p:nvPr/>
        </p:nvSpPr>
        <p:spPr>
          <a:xfrm>
            <a:off x="1749944" y="8634101"/>
            <a:ext cx="679225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CTLA-4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8A2FBFB8-7EA9-4A2A-9272-6349B5515B05}"/>
              </a:ext>
            </a:extLst>
          </p:cNvPr>
          <p:cNvCxnSpPr/>
          <p:nvPr/>
        </p:nvCxnSpPr>
        <p:spPr>
          <a:xfrm>
            <a:off x="685555" y="8814543"/>
            <a:ext cx="1054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EE1361B5-EB2E-46A4-8ABF-95D66D71CBD3}"/>
              </a:ext>
            </a:extLst>
          </p:cNvPr>
          <p:cNvSpPr txBox="1"/>
          <p:nvPr/>
        </p:nvSpPr>
        <p:spPr>
          <a:xfrm>
            <a:off x="1739797" y="9716262"/>
            <a:ext cx="52290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PD-1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2B7C64B5-2EAB-4E23-BC7A-96F4938B6479}"/>
              </a:ext>
            </a:extLst>
          </p:cNvPr>
          <p:cNvCxnSpPr/>
          <p:nvPr/>
        </p:nvCxnSpPr>
        <p:spPr>
          <a:xfrm>
            <a:off x="675610" y="9863114"/>
            <a:ext cx="1054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EC7265F0-DA60-443F-A56B-53E8BD106D14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57836" y="5628284"/>
            <a:ext cx="1052311" cy="103632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7FEB3AFC-1391-47FC-8DD1-20DEA6795463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526218" y="5596218"/>
            <a:ext cx="1052311" cy="103632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6EA909C3-02D5-4DC5-80EB-67D7CC23684C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417224" y="5578607"/>
            <a:ext cx="1052311" cy="103632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F78FA6DC-CD0A-4755-811F-38491CABACA1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599260" y="5589001"/>
            <a:ext cx="1052311" cy="103632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B9040AFC-F2B2-4B2C-8757-28820B21ABB4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417224" y="6656727"/>
            <a:ext cx="1052311" cy="1036320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B29FCC9F-E0CC-4321-93EC-2F72DB52078E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599260" y="6553862"/>
            <a:ext cx="1052311" cy="1036320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6D5A0B45-D032-45B9-B7C9-0822350C8F70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357836" y="6618579"/>
            <a:ext cx="1052311" cy="103632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0F4C1A59-0955-48D6-9081-C26292528B1B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526218" y="6583709"/>
            <a:ext cx="1052311" cy="1036320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2851464E-28AF-422B-B6FC-B01DF816F6E8}"/>
              </a:ext>
            </a:extLst>
          </p:cNvPr>
          <p:cNvSpPr txBox="1"/>
          <p:nvPr/>
        </p:nvSpPr>
        <p:spPr>
          <a:xfrm>
            <a:off x="1802613" y="6396897"/>
            <a:ext cx="55175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IFN-</a:t>
            </a:r>
            <a:r>
              <a:rPr lang="el-GR" sz="1360" dirty="0"/>
              <a:t>γ</a:t>
            </a:r>
            <a:endParaRPr lang="en-US" sz="1360" dirty="0"/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6F2ABF88-4579-4FFF-8595-C5D19C3D93C6}"/>
              </a:ext>
            </a:extLst>
          </p:cNvPr>
          <p:cNvCxnSpPr/>
          <p:nvPr/>
        </p:nvCxnSpPr>
        <p:spPr>
          <a:xfrm>
            <a:off x="754963" y="6553862"/>
            <a:ext cx="1054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BB34ECB1-E3DC-486C-AE90-5A36470CCAEB}"/>
              </a:ext>
            </a:extLst>
          </p:cNvPr>
          <p:cNvSpPr txBox="1"/>
          <p:nvPr/>
        </p:nvSpPr>
        <p:spPr>
          <a:xfrm>
            <a:off x="1814326" y="7523218"/>
            <a:ext cx="614271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dirty="0"/>
              <a:t>TNF-</a:t>
            </a:r>
            <a:r>
              <a:rPr lang="el-GR" sz="1360" dirty="0"/>
              <a:t>α</a:t>
            </a:r>
            <a:endParaRPr lang="en-US" sz="1360" dirty="0"/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F6458A74-EF8F-4927-9425-702022B680E9}"/>
              </a:ext>
            </a:extLst>
          </p:cNvPr>
          <p:cNvCxnSpPr/>
          <p:nvPr/>
        </p:nvCxnSpPr>
        <p:spPr>
          <a:xfrm>
            <a:off x="766677" y="7680181"/>
            <a:ext cx="1054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9A8CA970-F8B8-45E2-964A-4C4A4A3F2948}"/>
              </a:ext>
            </a:extLst>
          </p:cNvPr>
          <p:cNvSpPr txBox="1"/>
          <p:nvPr/>
        </p:nvSpPr>
        <p:spPr>
          <a:xfrm>
            <a:off x="4989923" y="5286520"/>
            <a:ext cx="2614883" cy="4093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6. Effect of </a:t>
            </a:r>
            <a:r>
              <a:rPr lang="en-US" sz="13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A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knockdown on </a:t>
            </a:r>
            <a:r>
              <a:rPr lang="en-US" sz="13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ffect in CD4</a:t>
            </a:r>
            <a:r>
              <a:rPr lang="en-US" sz="13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. 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gnetically enriched CD3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were activated with 0.5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g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mL αCD3/28 for 24 h. T cells were transduced by lentivirus bearing </a:t>
            </a:r>
            <a:r>
              <a:rPr lang="en-US" sz="13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A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RNA overnight. Thereafter, cell medium was changed, and stimulation continued in the presence of 0.25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vehicle control for an additional 72 h. CTLA-4, PD-1, IFN-γ and TNF-α expression was quantified in CD4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 by flow cytometry. Data are mean ± SD. One-way ANOVA was performed for statistical analysis, *p&lt;0.05.</a:t>
            </a:r>
          </a:p>
        </p:txBody>
      </p:sp>
    </p:spTree>
    <p:extLst>
      <p:ext uri="{BB962C8B-B14F-4D97-AF65-F5344CB8AC3E}">
        <p14:creationId xmlns:p14="http://schemas.microsoft.com/office/powerpoint/2010/main" val="34025009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37951F-8CAB-4218-BCDB-CEB937A9C3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8300280"/>
              </p:ext>
            </p:extLst>
          </p:nvPr>
        </p:nvGraphicFramePr>
        <p:xfrm>
          <a:off x="3684869" y="4652586"/>
          <a:ext cx="2205079" cy="20469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238340" imgH="3009807" progId="Prism9.Document">
                  <p:embed/>
                </p:oleObj>
              </mc:Choice>
              <mc:Fallback>
                <p:oleObj name="Prism 9" r:id="rId2" imgW="3238340" imgH="3009807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37951F-8CAB-4218-BCDB-CEB937A9C3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84869" y="4652586"/>
                        <a:ext cx="2205079" cy="20469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5E33A16-4266-49EA-8902-D9322A70C5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9308878"/>
              </p:ext>
            </p:extLst>
          </p:nvPr>
        </p:nvGraphicFramePr>
        <p:xfrm>
          <a:off x="1938744" y="2771966"/>
          <a:ext cx="2012460" cy="1992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087443" imgH="3055547" progId="Prism9.Document">
                  <p:embed/>
                </p:oleObj>
              </mc:Choice>
              <mc:Fallback>
                <p:oleObj name="Prism 9" r:id="rId4" imgW="3087443" imgH="3055547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5E33A16-4266-49EA-8902-D9322A70C5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38744" y="2771966"/>
                        <a:ext cx="2012460" cy="1992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92483EC-E68F-4FE9-B542-364EBFEA30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1043700"/>
              </p:ext>
            </p:extLst>
          </p:nvPr>
        </p:nvGraphicFramePr>
        <p:xfrm>
          <a:off x="1920316" y="6493397"/>
          <a:ext cx="1978505" cy="16903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169554" imgH="2707638" progId="Prism9.Document">
                  <p:embed/>
                </p:oleObj>
              </mc:Choice>
              <mc:Fallback>
                <p:oleObj name="Prism 9" r:id="rId6" imgW="3169554" imgH="2707638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92483EC-E68F-4FE9-B542-364EBFEA30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20316" y="6493397"/>
                        <a:ext cx="1978505" cy="16903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928EDAA-AD74-4AD4-A5BD-E8BCDCAAEE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4208232"/>
              </p:ext>
            </p:extLst>
          </p:nvPr>
        </p:nvGraphicFramePr>
        <p:xfrm>
          <a:off x="106041" y="6463039"/>
          <a:ext cx="2018421" cy="1751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164873" imgH="2744374" progId="Prism9.Document">
                  <p:embed/>
                </p:oleObj>
              </mc:Choice>
              <mc:Fallback>
                <p:oleObj name="Prism 9" r:id="rId8" imgW="3164873" imgH="2744374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928EDAA-AD74-4AD4-A5BD-E8BCDCAAEE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6041" y="6463039"/>
                        <a:ext cx="2018421" cy="1751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3AA0B63-68C0-489F-A916-E21661F2D4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270909"/>
              </p:ext>
            </p:extLst>
          </p:nvPr>
        </p:nvGraphicFramePr>
        <p:xfrm>
          <a:off x="91442" y="564639"/>
          <a:ext cx="2639570" cy="2229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189459" imgH="3537073" progId="Prism9.Document">
                  <p:embed/>
                </p:oleObj>
              </mc:Choice>
              <mc:Fallback>
                <p:oleObj name="Prism 9" r:id="rId10" imgW="4189459" imgH="3537073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3AA0B63-68C0-489F-A916-E21661F2D4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1442" y="564639"/>
                        <a:ext cx="2639570" cy="2229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13DB118-408C-4826-A025-D296D0B806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4758040"/>
              </p:ext>
            </p:extLst>
          </p:nvPr>
        </p:nvGraphicFramePr>
        <p:xfrm>
          <a:off x="2479730" y="604855"/>
          <a:ext cx="2066966" cy="1820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012535" imgH="2654335" progId="Prism9.Document">
                  <p:embed/>
                </p:oleObj>
              </mc:Choice>
              <mc:Fallback>
                <p:oleObj name="Prism 9" r:id="rId12" imgW="3012535" imgH="265433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13DB118-408C-4826-A025-D296D0B806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79730" y="604855"/>
                        <a:ext cx="2066966" cy="1820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CBA19FE9-CF10-443B-A4E8-7BED22707E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509986"/>
              </p:ext>
            </p:extLst>
          </p:nvPr>
        </p:nvGraphicFramePr>
        <p:xfrm>
          <a:off x="28657" y="4813006"/>
          <a:ext cx="2042686" cy="18416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242662" imgH="2924451" progId="Prism9.Document">
                  <p:embed/>
                </p:oleObj>
              </mc:Choice>
              <mc:Fallback>
                <p:oleObj name="Prism 9" r:id="rId14" imgW="3242662" imgH="2924451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CBA19FE9-CF10-443B-A4E8-7BED22707E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8657" y="4813006"/>
                        <a:ext cx="2042686" cy="18416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C57DBFD-2B8A-4B83-8A3A-E691CC8C03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8427541"/>
              </p:ext>
            </p:extLst>
          </p:nvPr>
        </p:nvGraphicFramePr>
        <p:xfrm>
          <a:off x="0" y="2806841"/>
          <a:ext cx="2155815" cy="19557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242662" imgH="2942459" progId="Prism9.Document">
                  <p:embed/>
                </p:oleObj>
              </mc:Choice>
              <mc:Fallback>
                <p:oleObj name="Prism 9" r:id="rId16" imgW="3242662" imgH="2942459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8C57DBFD-2B8A-4B83-8A3A-E691CC8C03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0" y="2806841"/>
                        <a:ext cx="2155815" cy="19557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F377FFA-2FD2-4510-9827-C446C8681B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8285326"/>
              </p:ext>
            </p:extLst>
          </p:nvPr>
        </p:nvGraphicFramePr>
        <p:xfrm>
          <a:off x="5264926" y="6570361"/>
          <a:ext cx="1904186" cy="16105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3378433" imgH="2860343" progId="Prism9.Document">
                  <p:embed/>
                </p:oleObj>
              </mc:Choice>
              <mc:Fallback>
                <p:oleObj name="Prism 9" r:id="rId18" imgW="3378433" imgH="2860343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1F377FFA-2FD2-4510-9827-C446C8681B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264926" y="6570361"/>
                        <a:ext cx="1904186" cy="16105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B6104E6-F2B6-4564-BED9-9BD347E07E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0994059"/>
              </p:ext>
            </p:extLst>
          </p:nvPr>
        </p:nvGraphicFramePr>
        <p:xfrm>
          <a:off x="3745843" y="6463039"/>
          <a:ext cx="1713385" cy="1717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3169554" imgH="3180520" progId="Prism9.Document">
                  <p:embed/>
                </p:oleObj>
              </mc:Choice>
              <mc:Fallback>
                <p:oleObj name="Prism 9" r:id="rId20" imgW="3169554" imgH="3180520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9B6104E6-F2B6-4564-BED9-9BD347E07E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745843" y="6463039"/>
                        <a:ext cx="1713385" cy="1717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2AB4CEAA-E6C5-4152-8D01-F51C266DA3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021355"/>
              </p:ext>
            </p:extLst>
          </p:nvPr>
        </p:nvGraphicFramePr>
        <p:xfrm>
          <a:off x="3822982" y="2672753"/>
          <a:ext cx="2066966" cy="2089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3087443" imgH="3125417" progId="Prism9.Document">
                  <p:embed/>
                </p:oleObj>
              </mc:Choice>
              <mc:Fallback>
                <p:oleObj name="Prism 9" r:id="rId22" imgW="3087443" imgH="3125417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2AB4CEAA-E6C5-4152-8D01-F51C266DA3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822982" y="2672753"/>
                        <a:ext cx="2066966" cy="2089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837D0CD-1287-4B94-9B5E-46ED810BA8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3712186"/>
              </p:ext>
            </p:extLst>
          </p:nvPr>
        </p:nvGraphicFramePr>
        <p:xfrm>
          <a:off x="1848183" y="4862958"/>
          <a:ext cx="2038017" cy="17894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3087443" imgH="2707638" progId="Prism9.Document">
                  <p:embed/>
                </p:oleObj>
              </mc:Choice>
              <mc:Fallback>
                <p:oleObj name="Prism 9" r:id="rId24" imgW="3087443" imgH="2707638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837D0CD-1287-4B94-9B5E-46ED810BA8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848183" y="4862958"/>
                        <a:ext cx="2038017" cy="17894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B57D8831-3641-492F-8EAD-4AEEE3299E5B}"/>
              </a:ext>
            </a:extLst>
          </p:cNvPr>
          <p:cNvSpPr txBox="1"/>
          <p:nvPr/>
        </p:nvSpPr>
        <p:spPr>
          <a:xfrm>
            <a:off x="-39191" y="35025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375D8E-724F-4400-A357-530321340A71}"/>
              </a:ext>
            </a:extLst>
          </p:cNvPr>
          <p:cNvSpPr txBox="1"/>
          <p:nvPr/>
        </p:nvSpPr>
        <p:spPr>
          <a:xfrm>
            <a:off x="-5455" y="2620528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E2D444D-314A-402C-99B7-76D0CB39A459}"/>
              </a:ext>
            </a:extLst>
          </p:cNvPr>
          <p:cNvSpPr txBox="1"/>
          <p:nvPr/>
        </p:nvSpPr>
        <p:spPr>
          <a:xfrm>
            <a:off x="-4218" y="4770475"/>
            <a:ext cx="5486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6674D3-CB86-4059-B524-FFEF4D212EC4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31205FA-66CF-415F-A3E6-E49B34A35EC4}"/>
              </a:ext>
            </a:extLst>
          </p:cNvPr>
          <p:cNvSpPr txBox="1"/>
          <p:nvPr/>
        </p:nvSpPr>
        <p:spPr>
          <a:xfrm>
            <a:off x="1496110" y="9555962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/>
              <a:t>β</a:t>
            </a:r>
            <a:r>
              <a:rPr lang="en-US" sz="1200" b="1" dirty="0"/>
              <a:t>-acti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129F08D-CD5C-4EF9-81DD-919FE726308A}"/>
              </a:ext>
            </a:extLst>
          </p:cNvPr>
          <p:cNvSpPr txBox="1"/>
          <p:nvPr/>
        </p:nvSpPr>
        <p:spPr>
          <a:xfrm>
            <a:off x="1512733" y="9327954"/>
            <a:ext cx="475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Y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BB91F0B-5C28-40A2-AB91-07A89FC01959}"/>
              </a:ext>
            </a:extLst>
          </p:cNvPr>
          <p:cNvSpPr txBox="1"/>
          <p:nvPr/>
        </p:nvSpPr>
        <p:spPr>
          <a:xfrm>
            <a:off x="1482667" y="9023932"/>
            <a:ext cx="1377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leaved caspase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8EEA770-1089-4746-B3D8-83FC7C6026C0}"/>
              </a:ext>
            </a:extLst>
          </p:cNvPr>
          <p:cNvSpPr txBox="1"/>
          <p:nvPr/>
        </p:nvSpPr>
        <p:spPr>
          <a:xfrm>
            <a:off x="151692" y="8590362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JeKo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EE60AB-29C5-4AD6-B9E2-F067A7373D3C}"/>
              </a:ext>
            </a:extLst>
          </p:cNvPr>
          <p:cNvSpPr txBox="1"/>
          <p:nvPr/>
        </p:nvSpPr>
        <p:spPr>
          <a:xfrm>
            <a:off x="983533" y="858489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2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D11BC07-FEB3-4B37-BD6A-CEE8C92664E1}"/>
              </a:ext>
            </a:extLst>
          </p:cNvPr>
          <p:cNvSpPr txBox="1"/>
          <p:nvPr/>
        </p:nvSpPr>
        <p:spPr>
          <a:xfrm>
            <a:off x="75090" y="8785223"/>
            <a:ext cx="752129" cy="2319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7" dirty="0"/>
              <a:t>0    0.25  1.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FA8963E-162C-40DD-8535-F83A6D7FF374}"/>
              </a:ext>
            </a:extLst>
          </p:cNvPr>
          <p:cNvCxnSpPr/>
          <p:nvPr/>
        </p:nvCxnSpPr>
        <p:spPr>
          <a:xfrm>
            <a:off x="149391" y="8813745"/>
            <a:ext cx="518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4C9306A-8898-46B3-9331-988F0DF30BF4}"/>
              </a:ext>
            </a:extLst>
          </p:cNvPr>
          <p:cNvSpPr txBox="1"/>
          <p:nvPr/>
        </p:nvSpPr>
        <p:spPr>
          <a:xfrm>
            <a:off x="0" y="809051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2DA57F4C-0B4F-40A1-AC83-BAEDFB20D6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0294683"/>
              </p:ext>
            </p:extLst>
          </p:nvPr>
        </p:nvGraphicFramePr>
        <p:xfrm>
          <a:off x="6037163" y="8075717"/>
          <a:ext cx="2049489" cy="19826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6" imgW="2413269" imgH="2860343" progId="Prism9.Document">
                  <p:embed/>
                </p:oleObj>
              </mc:Choice>
              <mc:Fallback>
                <p:oleObj name="Prism 9" r:id="rId26" imgW="2413269" imgH="2860343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2DA57F4C-0B4F-40A1-AC83-BAEDFB20D6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6037163" y="8075717"/>
                        <a:ext cx="2049489" cy="19826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861CB8DE-CD39-4F70-B138-008CD8BD09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9578780"/>
              </p:ext>
            </p:extLst>
          </p:nvPr>
        </p:nvGraphicFramePr>
        <p:xfrm>
          <a:off x="4505052" y="8176616"/>
          <a:ext cx="1894309" cy="18817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8" imgW="2413269" imgH="2713761" progId="Prism9.Document">
                  <p:embed/>
                </p:oleObj>
              </mc:Choice>
              <mc:Fallback>
                <p:oleObj name="Prism 9" r:id="rId28" imgW="2413269" imgH="2713761" progId="Prism9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861CB8DE-CD39-4F70-B138-008CD8BD09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4505052" y="8176616"/>
                        <a:ext cx="1894309" cy="18817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7A1240E4-CF53-4D38-AC57-7A8E9F1714C0}"/>
              </a:ext>
            </a:extLst>
          </p:cNvPr>
          <p:cNvSpPr txBox="1"/>
          <p:nvPr/>
        </p:nvSpPr>
        <p:spPr>
          <a:xfrm>
            <a:off x="4414927" y="820922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0647702C-BDDC-427D-96AD-AACD93C7BCE7}"/>
              </a:ext>
            </a:extLst>
          </p:cNvPr>
          <p:cNvCxnSpPr/>
          <p:nvPr/>
        </p:nvCxnSpPr>
        <p:spPr>
          <a:xfrm>
            <a:off x="902072" y="8805823"/>
            <a:ext cx="518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5961C56-546E-4664-9D71-7C9D84D14971}"/>
              </a:ext>
            </a:extLst>
          </p:cNvPr>
          <p:cNvSpPr txBox="1"/>
          <p:nvPr/>
        </p:nvSpPr>
        <p:spPr>
          <a:xfrm>
            <a:off x="745279" y="8794403"/>
            <a:ext cx="752129" cy="2319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7" dirty="0"/>
              <a:t>0    0.25  1.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4FD4964-90E1-4634-AD6D-F74E82196AD1}"/>
              </a:ext>
            </a:extLst>
          </p:cNvPr>
          <p:cNvSpPr txBox="1"/>
          <p:nvPr/>
        </p:nvSpPr>
        <p:spPr>
          <a:xfrm>
            <a:off x="1510157" y="8784977"/>
            <a:ext cx="633507" cy="2319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7" dirty="0" err="1"/>
              <a:t>Pevo</a:t>
            </a:r>
            <a:r>
              <a:rPr lang="en-US" sz="907" dirty="0"/>
              <a:t>, µM</a:t>
            </a:r>
          </a:p>
        </p:txBody>
      </p:sp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08A01486-19F3-4F66-9899-A99FC8A391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466388"/>
              </p:ext>
            </p:extLst>
          </p:nvPr>
        </p:nvGraphicFramePr>
        <p:xfrm>
          <a:off x="50897" y="9004252"/>
          <a:ext cx="1410483" cy="3205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0" imgW="1955520" imgH="444240" progId="Photoshop.Image.55">
                  <p:embed/>
                </p:oleObj>
              </mc:Choice>
              <mc:Fallback>
                <p:oleObj name="Image" r:id="rId30" imgW="1955520" imgH="444240" progId="Photoshop.Image.55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08A01486-19F3-4F66-9899-A99FC8A391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50897" y="9004252"/>
                        <a:ext cx="1410483" cy="3205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E274A859-4C1E-4A86-9281-B9DFE5C611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4261818"/>
              </p:ext>
            </p:extLst>
          </p:nvPr>
        </p:nvGraphicFramePr>
        <p:xfrm>
          <a:off x="58888" y="9372297"/>
          <a:ext cx="1438520" cy="2095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2" imgW="1917360" imgH="279360" progId="Photoshop.Image.55">
                  <p:embed/>
                </p:oleObj>
              </mc:Choice>
              <mc:Fallback>
                <p:oleObj name="Image" r:id="rId32" imgW="1917360" imgH="279360" progId="Photoshop.Image.55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E274A859-4C1E-4A86-9281-B9DFE5C611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58888" y="9372297"/>
                        <a:ext cx="1438520" cy="2095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AA474382-CA3E-47CC-AF22-E5C03D54D5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297275"/>
              </p:ext>
            </p:extLst>
          </p:nvPr>
        </p:nvGraphicFramePr>
        <p:xfrm>
          <a:off x="45445" y="9576951"/>
          <a:ext cx="1451963" cy="253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4" imgW="1891800" imgH="330120" progId="Photoshop.Image.55">
                  <p:embed/>
                </p:oleObj>
              </mc:Choice>
              <mc:Fallback>
                <p:oleObj name="Image" r:id="rId34" imgW="1891800" imgH="330120" progId="Photoshop.Image.55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AA474382-CA3E-47CC-AF22-E5C03D54D5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45445" y="9576951"/>
                        <a:ext cx="1451963" cy="253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Rectangle 36">
            <a:extLst>
              <a:ext uri="{FF2B5EF4-FFF2-40B4-BE49-F238E27FC236}">
                <a16:creationId xmlns:a16="http://schemas.microsoft.com/office/drawing/2014/main" id="{0D2A9F4E-1ECB-4913-AD20-0EC7AEF776F4}"/>
              </a:ext>
            </a:extLst>
          </p:cNvPr>
          <p:cNvSpPr/>
          <p:nvPr/>
        </p:nvSpPr>
        <p:spPr>
          <a:xfrm>
            <a:off x="62341" y="8991709"/>
            <a:ext cx="1410483" cy="328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347003C-1C72-4382-B03B-CA5709D6D4FD}"/>
              </a:ext>
            </a:extLst>
          </p:cNvPr>
          <p:cNvSpPr/>
          <p:nvPr/>
        </p:nvSpPr>
        <p:spPr>
          <a:xfrm>
            <a:off x="58888" y="9374006"/>
            <a:ext cx="1438520" cy="2077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B94F0304-E728-4CC7-A85A-7CA7CBB81F2D}"/>
              </a:ext>
            </a:extLst>
          </p:cNvPr>
          <p:cNvSpPr/>
          <p:nvPr/>
        </p:nvSpPr>
        <p:spPr>
          <a:xfrm>
            <a:off x="58888" y="9629459"/>
            <a:ext cx="1423779" cy="20085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CE0FC9D-6C9D-473B-AF62-B83A94479923}"/>
              </a:ext>
            </a:extLst>
          </p:cNvPr>
          <p:cNvSpPr txBox="1"/>
          <p:nvPr/>
        </p:nvSpPr>
        <p:spPr>
          <a:xfrm>
            <a:off x="5697329" y="-38941"/>
            <a:ext cx="2035646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7. A20 cells with </a:t>
            </a:r>
            <a:r>
              <a:rPr lang="en-US" sz="12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2M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letion mutation are not sensitive to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anti-PD-1 treatment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-C)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0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2M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lymphoma cells were transplanted into syngeneic recipient mice, and tumor-bearing mice were randomized into 4 groups (n=6) and treated with vehicle control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ti-PD-1 or both. Tumors were measured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immune profiles of CD8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ILs are shown in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-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20 or JeKo-1 cells were treated with 0.25 or 1 µ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24 hours. Whole cell protein lysates were subjected to immunoblotting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0 cells were treated with 1 µ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24 hours and analyzed by flow cytometry. (F) PD-L1 expression in A20 cells treated with 1 µ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24 hours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vitro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left graph) or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vivo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 above (right graph). Data are mean ± SD. **p&lt;0.01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7B18FE-FFC8-4E6C-41F6-9E799B949476}"/>
              </a:ext>
            </a:extLst>
          </p:cNvPr>
          <p:cNvSpPr txBox="1"/>
          <p:nvPr/>
        </p:nvSpPr>
        <p:spPr>
          <a:xfrm>
            <a:off x="2806755" y="819082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1FCA271-1917-E94D-03F5-91BED9E14116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2926177" y="8982828"/>
            <a:ext cx="731520" cy="73152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58D2F8DE-B38A-1F4C-5921-5200D093C729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3767523" y="9000723"/>
            <a:ext cx="731520" cy="73152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75F9005-0349-0D21-6B8F-DD0F27B97273}"/>
              </a:ext>
            </a:extLst>
          </p:cNvPr>
          <p:cNvSpPr txBox="1"/>
          <p:nvPr/>
        </p:nvSpPr>
        <p:spPr>
          <a:xfrm rot="16200000">
            <a:off x="2581834" y="9262395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SC-A</a:t>
            </a:r>
            <a:endParaRPr lang="en-US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36FF904-783A-44FE-7C8D-2E701E780674}"/>
              </a:ext>
            </a:extLst>
          </p:cNvPr>
          <p:cNvSpPr txBox="1"/>
          <p:nvPr/>
        </p:nvSpPr>
        <p:spPr>
          <a:xfrm>
            <a:off x="3880542" y="9709806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FN-</a:t>
            </a:r>
            <a:r>
              <a:rPr lang="el-GR" sz="1000" dirty="0"/>
              <a:t>γ</a:t>
            </a:r>
            <a:endParaRPr lang="en-US" sz="1000" dirty="0"/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50E5DC4A-70CD-3935-8B28-F1D9703729B0}"/>
              </a:ext>
            </a:extLst>
          </p:cNvPr>
          <p:cNvCxnSpPr>
            <a:cxnSpLocks/>
          </p:cNvCxnSpPr>
          <p:nvPr/>
        </p:nvCxnSpPr>
        <p:spPr>
          <a:xfrm>
            <a:off x="2965730" y="9832916"/>
            <a:ext cx="9116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8927862D-2108-5B5E-44AB-A4474CA5E939}"/>
              </a:ext>
            </a:extLst>
          </p:cNvPr>
          <p:cNvSpPr txBox="1"/>
          <p:nvPr/>
        </p:nvSpPr>
        <p:spPr>
          <a:xfrm>
            <a:off x="2907069" y="8784903"/>
            <a:ext cx="805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20 DMSO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A45F67F-FB74-5BBF-4280-77A189C294C4}"/>
              </a:ext>
            </a:extLst>
          </p:cNvPr>
          <p:cNvSpPr txBox="1"/>
          <p:nvPr/>
        </p:nvSpPr>
        <p:spPr>
          <a:xfrm>
            <a:off x="3749593" y="8765731"/>
            <a:ext cx="805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20 </a:t>
            </a:r>
            <a:r>
              <a:rPr lang="en-US" sz="1000" dirty="0" err="1"/>
              <a:t>Pevo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8430660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DD01AC1-9BD0-464F-AEF0-B170BC4740A7}"/>
              </a:ext>
            </a:extLst>
          </p:cNvPr>
          <p:cNvSpPr txBox="1"/>
          <p:nvPr/>
        </p:nvSpPr>
        <p:spPr>
          <a:xfrm>
            <a:off x="-14504" y="-64758"/>
            <a:ext cx="2614883" cy="406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41" b="1" dirty="0"/>
              <a:t>Supplemental Figure 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CA91816-96F7-4AA3-9ECB-DE6193C4049C}"/>
              </a:ext>
            </a:extLst>
          </p:cNvPr>
          <p:cNvSpPr txBox="1"/>
          <p:nvPr/>
        </p:nvSpPr>
        <p:spPr>
          <a:xfrm>
            <a:off x="118302" y="7067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63C09C-8933-4493-8295-BD140CFE078C}"/>
              </a:ext>
            </a:extLst>
          </p:cNvPr>
          <p:cNvSpPr txBox="1"/>
          <p:nvPr/>
        </p:nvSpPr>
        <p:spPr>
          <a:xfrm>
            <a:off x="135936" y="223849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326C1EA-B4B3-04F4-8781-E7B3C5F158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727" y="706788"/>
            <a:ext cx="4103304" cy="313176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30087EE-E17A-CC77-FBC7-4638D7C658B2}"/>
              </a:ext>
            </a:extLst>
          </p:cNvPr>
          <p:cNvSpPr txBox="1"/>
          <p:nvPr/>
        </p:nvSpPr>
        <p:spPr>
          <a:xfrm>
            <a:off x="648794" y="2130630"/>
            <a:ext cx="1527982" cy="208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ES 0.38  P value 0.0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485F8A-B767-F445-CFD1-60573E84759D}"/>
              </a:ext>
            </a:extLst>
          </p:cNvPr>
          <p:cNvSpPr txBox="1"/>
          <p:nvPr/>
        </p:nvSpPr>
        <p:spPr>
          <a:xfrm>
            <a:off x="2756610" y="2116068"/>
            <a:ext cx="1457450" cy="208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ES 0.47  P value 0.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9672D3-BEF0-B0DE-11DD-BF3718F0462B}"/>
              </a:ext>
            </a:extLst>
          </p:cNvPr>
          <p:cNvSpPr txBox="1"/>
          <p:nvPr/>
        </p:nvSpPr>
        <p:spPr>
          <a:xfrm>
            <a:off x="736096" y="3818239"/>
            <a:ext cx="1457450" cy="208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ES 0.41  P value 0.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17D53E8-FFB9-F47E-B4D9-3108C5CF0F15}"/>
              </a:ext>
            </a:extLst>
          </p:cNvPr>
          <p:cNvSpPr txBox="1"/>
          <p:nvPr/>
        </p:nvSpPr>
        <p:spPr>
          <a:xfrm>
            <a:off x="2782010" y="3821938"/>
            <a:ext cx="1598515" cy="208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ES 0.33  P value 0.00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CDF81C-5DE3-4D86-977B-136EF00A2952}"/>
              </a:ext>
            </a:extLst>
          </p:cNvPr>
          <p:cNvSpPr txBox="1"/>
          <p:nvPr/>
        </p:nvSpPr>
        <p:spPr>
          <a:xfrm>
            <a:off x="135936" y="7559442"/>
            <a:ext cx="7376017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8. </a:t>
            </a:r>
            <a:r>
              <a:rPr lang="en-US" sz="13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RNA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Seq profiling of immune cells from patients treated with </a:t>
            </a:r>
            <a:r>
              <a:rPr lang="en-US" sz="13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GSEA plots of the hallmark IFN-α response pathway in the indicated cell types following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 (3 hours post-infusion versus baseline). (B) GSEA plots of the hallmark DNA repair pathway in the CD4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following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 (3 and 24 hours versus baseline). (C) GSEA plots of the hallmark DNA repair pathway in the CD4</a:t>
            </a:r>
            <a:r>
              <a:rPr lang="en-US" sz="13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following </a:t>
            </a:r>
            <a:r>
              <a:rPr lang="en-US" sz="1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vonedistat</a:t>
            </a:r>
            <a:r>
              <a:rPr lang="en-US" sz="1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 (24 hours versus baseline). GSEA: gene set enrichment analysis; NES: normalized enrichment score.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5FFCA68-5F3A-3F12-11D7-C143821E52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174030"/>
              </p:ext>
            </p:extLst>
          </p:nvPr>
        </p:nvGraphicFramePr>
        <p:xfrm>
          <a:off x="636943" y="4494443"/>
          <a:ext cx="1951585" cy="11958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" imgW="2984040" imgH="1828440" progId="Photoshop.Image.55">
                  <p:embed/>
                </p:oleObj>
              </mc:Choice>
              <mc:Fallback>
                <p:oleObj name="Image" r:id="rId3" imgW="2984040" imgH="1828440" progId="Photoshop.Image.55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6943" y="4494443"/>
                        <a:ext cx="1951585" cy="11958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2A22B64-E5C2-546F-DC2A-A224896C82BD}"/>
              </a:ext>
            </a:extLst>
          </p:cNvPr>
          <p:cNvSpPr txBox="1"/>
          <p:nvPr/>
        </p:nvSpPr>
        <p:spPr>
          <a:xfrm>
            <a:off x="672209" y="5721479"/>
            <a:ext cx="1598515" cy="208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ES 0.34  P value 0.00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8E0E7F2-D4AD-201C-5915-07C9CFDEBBD1}"/>
              </a:ext>
            </a:extLst>
          </p:cNvPr>
          <p:cNvSpPr txBox="1"/>
          <p:nvPr/>
        </p:nvSpPr>
        <p:spPr>
          <a:xfrm>
            <a:off x="768859" y="4187960"/>
            <a:ext cx="10835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 24h vs 0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423CB8-448B-9956-05B2-4D5882A4C520}"/>
              </a:ext>
            </a:extLst>
          </p:cNvPr>
          <p:cNvSpPr txBox="1"/>
          <p:nvPr/>
        </p:nvSpPr>
        <p:spPr>
          <a:xfrm>
            <a:off x="135936" y="408435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988656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2">
            <a:extLst>
              <a:ext uri="{FF2B5EF4-FFF2-40B4-BE49-F238E27FC236}">
                <a16:creationId xmlns:a16="http://schemas.microsoft.com/office/drawing/2014/main" id="{12A17C9B-E96D-47F3-8B6E-FFC28F8C775F}"/>
              </a:ext>
            </a:extLst>
          </p:cNvPr>
          <p:cNvSpPr/>
          <p:nvPr/>
        </p:nvSpPr>
        <p:spPr>
          <a:xfrm>
            <a:off x="0" y="99164"/>
            <a:ext cx="719288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l Table S1: Patient diagnosis and dose of </a:t>
            </a:r>
            <a:r>
              <a:rPr lang="en-US" sz="1600" b="1" dirty="0" err="1">
                <a:solidFill>
                  <a:srgbClr val="000000"/>
                </a:solidFill>
                <a:latin typeface="Arial" panose="020B0604020202020204" pitchFamily="34" charset="0"/>
              </a:rPr>
              <a:t>pevonedistat</a:t>
            </a:r>
            <a:endParaRPr lang="en-US" sz="1600" b="1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fontAlgn="b"/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evonedista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50 mg/m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etermined as the recommended Phase 2 dose)</a:t>
            </a:r>
            <a:endParaRPr lang="en-US" sz="16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1B642DA-B223-41F1-BACF-30ABA45E2781}"/>
              </a:ext>
            </a:extLst>
          </p:cNvPr>
          <p:cNvGraphicFramePr>
            <a:graphicFrameLocks noGrp="1"/>
          </p:cNvGraphicFramePr>
          <p:nvPr/>
        </p:nvGraphicFramePr>
        <p:xfrm>
          <a:off x="384175" y="1195388"/>
          <a:ext cx="6473825" cy="3074708"/>
        </p:xfrm>
        <a:graphic>
          <a:graphicData uri="http://schemas.openxmlformats.org/drawingml/2006/table">
            <a:tbl>
              <a:tblPr firstRow="1" firstCol="1" bandRow="1">
                <a:tableStyleId>{5202B0CA-FC54-4496-8BCA-5EF66A818D29}</a:tableStyleId>
              </a:tblPr>
              <a:tblGrid>
                <a:gridCol w="1546225">
                  <a:extLst>
                    <a:ext uri="{9D8B030D-6E8A-4147-A177-3AD203B41FA5}">
                      <a16:colId xmlns:a16="http://schemas.microsoft.com/office/drawing/2014/main" val="1245681691"/>
                    </a:ext>
                  </a:extLst>
                </a:gridCol>
                <a:gridCol w="2682983">
                  <a:extLst>
                    <a:ext uri="{9D8B030D-6E8A-4147-A177-3AD203B41FA5}">
                      <a16:colId xmlns:a16="http://schemas.microsoft.com/office/drawing/2014/main" val="796068499"/>
                    </a:ext>
                  </a:extLst>
                </a:gridCol>
                <a:gridCol w="2244617">
                  <a:extLst>
                    <a:ext uri="{9D8B030D-6E8A-4147-A177-3AD203B41FA5}">
                      <a16:colId xmlns:a16="http://schemas.microsoft.com/office/drawing/2014/main" val="3958445277"/>
                    </a:ext>
                  </a:extLst>
                </a:gridCol>
              </a:tblGrid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se of </a:t>
                      </a:r>
                      <a:r>
                        <a:rPr lang="en-US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vonedistat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6776234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4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tle cell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04863041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use large B-cell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2024299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1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76482851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1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tle cell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07267139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2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nic lymphocytic leukemi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7317523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2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nic lymphocytic leukemi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4427885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2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tle cell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7233835"/>
                  </a:ext>
                </a:extLst>
              </a:tr>
              <a:tr h="3173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2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tle cell lymphom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mg/m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69654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4236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80</TotalTime>
  <Words>1363</Words>
  <Application>Microsoft Office PowerPoint</Application>
  <PresentationFormat>Custom</PresentationFormat>
  <Paragraphs>271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rism 9</vt:lpstr>
      <vt:lpstr>Image</vt:lpstr>
      <vt:lpstr>Adobe Photoshop 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 Wang</dc:creator>
  <cp:lastModifiedBy>Alexey Danilov MD PhD</cp:lastModifiedBy>
  <cp:revision>263</cp:revision>
  <dcterms:created xsi:type="dcterms:W3CDTF">2021-09-20T23:52:23Z</dcterms:created>
  <dcterms:modified xsi:type="dcterms:W3CDTF">2023-03-02T22:52:32Z</dcterms:modified>
</cp:coreProperties>
</file>